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6" r:id="rId2"/>
  </p:sldIdLst>
  <p:sldSz cx="71993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7A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65"/>
    <p:restoredTop sz="93415"/>
  </p:normalViewPr>
  <p:slideViewPr>
    <p:cSldViewPr snapToGrid="0">
      <p:cViewPr varScale="1">
        <p:scale>
          <a:sx n="76" d="100"/>
          <a:sy n="76" d="100"/>
        </p:scale>
        <p:origin x="378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C8C0F8-B0EB-A743-B635-EDE72A7CD44D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1143000"/>
            <a:ext cx="2057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7AC08A-5A6D-AF42-9C7B-3961A27E1E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11355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1pPr>
    <a:lvl2pPr marL="253975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2pPr>
    <a:lvl3pPr marL="507949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3pPr>
    <a:lvl4pPr marL="761924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4pPr>
    <a:lvl5pPr marL="1015898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5pPr>
    <a:lvl6pPr marL="1269873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6pPr>
    <a:lvl7pPr marL="1523848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7pPr>
    <a:lvl8pPr marL="1777822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8pPr>
    <a:lvl9pPr marL="2031797" algn="l" defTabSz="507949" rtl="0" eaLnBrk="1" latinLnBrk="0" hangingPunct="1">
      <a:defRPr kumimoji="1" sz="66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400300" y="1143000"/>
            <a:ext cx="2057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17AC08A-5A6D-AF42-9C7B-3961A27E1E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7398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767462"/>
            <a:ext cx="6119416" cy="3759917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5672376"/>
            <a:ext cx="5399485" cy="2607442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4980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1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574987"/>
            <a:ext cx="1552352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574987"/>
            <a:ext cx="4567064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145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0243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2692444"/>
            <a:ext cx="6209407" cy="4492401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7227345"/>
            <a:ext cx="6209407" cy="236244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015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2874937"/>
            <a:ext cx="3059708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35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574990"/>
            <a:ext cx="6209407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647443"/>
            <a:ext cx="3045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3944914"/>
            <a:ext cx="3045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647443"/>
            <a:ext cx="3060646" cy="129747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3944914"/>
            <a:ext cx="306064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581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311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100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554968"/>
            <a:ext cx="3644652" cy="767483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165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719984"/>
            <a:ext cx="2321966" cy="2519945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554968"/>
            <a:ext cx="3644652" cy="767483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239929"/>
            <a:ext cx="2321966" cy="6002369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0814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574990"/>
            <a:ext cx="6209407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2874937"/>
            <a:ext cx="6209407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5B075-8192-2743-A145-09555656E358}" type="datetimeFigureOut">
              <a:rPr kumimoji="1" lang="ja-JP" altLang="en-US" smtClean="0"/>
              <a:t>2022/9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0009783"/>
            <a:ext cx="242976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0009783"/>
            <a:ext cx="1619845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19436-B3AC-D04C-9C5A-C0BFD230B9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6126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97251F8-1804-E4CA-1011-0F87EA25A448}"/>
              </a:ext>
            </a:extLst>
          </p:cNvPr>
          <p:cNvSpPr txBox="1"/>
          <p:nvPr/>
        </p:nvSpPr>
        <p:spPr>
          <a:xfrm>
            <a:off x="1140966" y="1059091"/>
            <a:ext cx="2801600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err="1"/>
              <a:t>pCMV-Mm.cargo</a:t>
            </a:r>
            <a:r>
              <a:rPr lang="en-US" altLang="ja-JP" sz="1600" dirty="0"/>
              <a:t> (</a:t>
            </a:r>
            <a:r>
              <a:rPr lang="en-US" altLang="ja-JP" sz="1600" dirty="0" err="1"/>
              <a:t>Akaluc</a:t>
            </a:r>
            <a:r>
              <a:rPr lang="en-US" altLang="ja-JP" sz="1600" dirty="0"/>
              <a:t>)</a:t>
            </a:r>
            <a:r>
              <a:rPr lang="ja-JP" altLang="ja-JP" sz="1600"/>
              <a:t> </a:t>
            </a:r>
            <a:endParaRPr kumimoji="1" lang="ja-JP" altLang="en-US" sz="1600" b="1"/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A9606D11-3DB0-A190-A225-1A3DF9B7B20B}"/>
              </a:ext>
            </a:extLst>
          </p:cNvPr>
          <p:cNvGrpSpPr>
            <a:grpSpLocks noChangeAspect="1"/>
          </p:cNvGrpSpPr>
          <p:nvPr/>
        </p:nvGrpSpPr>
        <p:grpSpPr>
          <a:xfrm>
            <a:off x="1199246" y="1483270"/>
            <a:ext cx="5150591" cy="742845"/>
            <a:chOff x="907112" y="5944359"/>
            <a:chExt cx="5622928" cy="624720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4BFF1EC-52EC-E25C-89DC-C42DEB76CB35}"/>
                </a:ext>
              </a:extLst>
            </p:cNvPr>
            <p:cNvSpPr txBox="1"/>
            <p:nvPr/>
          </p:nvSpPr>
          <p:spPr>
            <a:xfrm>
              <a:off x="1266624" y="6261126"/>
              <a:ext cx="1626037" cy="30795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Peg10 5’UTR</a:t>
              </a:r>
              <a:endParaRPr kumimoji="1" lang="ja-JP" altLang="en-US" sz="140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45127511-4A44-C0BB-BB25-47331DC23D4F}"/>
                </a:ext>
              </a:extLst>
            </p:cNvPr>
            <p:cNvSpPr txBox="1"/>
            <p:nvPr/>
          </p:nvSpPr>
          <p:spPr>
            <a:xfrm>
              <a:off x="4789004" y="6261126"/>
              <a:ext cx="1626037" cy="307953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mPeg10 3’UTR</a:t>
              </a:r>
              <a:endParaRPr kumimoji="1" lang="ja-JP" altLang="en-US" sz="1400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EC585924-3A98-71A5-7326-756066B292EE}"/>
                </a:ext>
              </a:extLst>
            </p:cNvPr>
            <p:cNvSpPr/>
            <p:nvPr/>
          </p:nvSpPr>
          <p:spPr>
            <a:xfrm>
              <a:off x="907112" y="5994804"/>
              <a:ext cx="1012041" cy="235775"/>
            </a:xfrm>
            <a:prstGeom prst="rect">
              <a:avLst/>
            </a:prstGeom>
            <a:solidFill>
              <a:srgbClr val="00206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DC7178FB-DE35-AF95-ADCB-BC44577BFCF2}"/>
                </a:ext>
              </a:extLst>
            </p:cNvPr>
            <p:cNvSpPr/>
            <p:nvPr/>
          </p:nvSpPr>
          <p:spPr>
            <a:xfrm>
              <a:off x="1917071" y="5994804"/>
              <a:ext cx="202446" cy="23577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19403033-E4A8-228B-6964-73C553371210}"/>
                </a:ext>
              </a:extLst>
            </p:cNvPr>
            <p:cNvSpPr/>
            <p:nvPr/>
          </p:nvSpPr>
          <p:spPr>
            <a:xfrm>
              <a:off x="2117435" y="5994804"/>
              <a:ext cx="2958352" cy="235775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5A81C1F4-6E19-A838-18B0-AB14CCA67C2E}"/>
                </a:ext>
              </a:extLst>
            </p:cNvPr>
            <p:cNvSpPr/>
            <p:nvPr/>
          </p:nvSpPr>
          <p:spPr>
            <a:xfrm>
              <a:off x="5072883" y="5994804"/>
              <a:ext cx="966394" cy="23577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2E0AFAA0-6E22-DD71-88E8-3C9705E76331}"/>
                </a:ext>
              </a:extLst>
            </p:cNvPr>
            <p:cNvSpPr/>
            <p:nvPr/>
          </p:nvSpPr>
          <p:spPr>
            <a:xfrm>
              <a:off x="6038140" y="5994804"/>
              <a:ext cx="414562" cy="235775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2D9A223A-84C2-480F-02F7-3A83FF823739}"/>
                </a:ext>
              </a:extLst>
            </p:cNvPr>
            <p:cNvSpPr txBox="1"/>
            <p:nvPr/>
          </p:nvSpPr>
          <p:spPr>
            <a:xfrm>
              <a:off x="1034356" y="5961302"/>
              <a:ext cx="760383" cy="33874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dirty="0">
                  <a:solidFill>
                    <a:schemeClr val="bg1"/>
                  </a:solidFill>
                </a:rPr>
                <a:t>CMV</a:t>
              </a:r>
              <a:endParaRPr kumimoji="1" lang="ja-JP" altLang="en-US" sz="1600">
                <a:solidFill>
                  <a:schemeClr val="bg1"/>
                </a:solidFill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BF95EF0E-712C-6979-6DE6-DC510861ADF9}"/>
                </a:ext>
              </a:extLst>
            </p:cNvPr>
            <p:cNvSpPr txBox="1"/>
            <p:nvPr/>
          </p:nvSpPr>
          <p:spPr>
            <a:xfrm>
              <a:off x="3138561" y="5944363"/>
              <a:ext cx="949437" cy="338748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dirty="0" err="1">
                  <a:solidFill>
                    <a:schemeClr val="bg1"/>
                  </a:solidFill>
                </a:rPr>
                <a:t>Akaluc</a:t>
              </a:r>
              <a:endParaRPr kumimoji="1" lang="ja-JP" altLang="en-US" sz="1600">
                <a:solidFill>
                  <a:schemeClr val="bg1"/>
                </a:solidFill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2D896A1-11D0-CC5B-3160-0C79D0D925A2}"/>
                </a:ext>
              </a:extLst>
            </p:cNvPr>
            <p:cNvSpPr txBox="1"/>
            <p:nvPr/>
          </p:nvSpPr>
          <p:spPr>
            <a:xfrm>
              <a:off x="5996605" y="5944359"/>
              <a:ext cx="533435" cy="3387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dirty="0" err="1">
                  <a:solidFill>
                    <a:schemeClr val="bg1"/>
                  </a:solidFill>
                </a:rPr>
                <a:t>pA</a:t>
              </a:r>
              <a:endParaRPr kumimoji="1" lang="ja-JP" altLang="en-US" sz="1600">
                <a:solidFill>
                  <a:schemeClr val="bg1"/>
                </a:solidFill>
              </a:endParaRPr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1D46513-5C74-78EB-0E7E-084701C6EC50}"/>
              </a:ext>
            </a:extLst>
          </p:cNvPr>
          <p:cNvSpPr txBox="1"/>
          <p:nvPr/>
        </p:nvSpPr>
        <p:spPr>
          <a:xfrm>
            <a:off x="650117" y="899881"/>
            <a:ext cx="406615" cy="2929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A)</a:t>
            </a:r>
            <a:endParaRPr kumimoji="1" lang="ja-JP" altLang="en-US" b="1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31338965-DE8C-D90F-E67A-8DE07F3B62D9}"/>
              </a:ext>
            </a:extLst>
          </p:cNvPr>
          <p:cNvSpPr txBox="1"/>
          <p:nvPr/>
        </p:nvSpPr>
        <p:spPr>
          <a:xfrm>
            <a:off x="659654" y="2419802"/>
            <a:ext cx="400894" cy="2929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B)</a:t>
            </a:r>
            <a:endParaRPr kumimoji="1" lang="ja-JP" altLang="en-US" b="1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F23E758-5C91-0D9A-DE86-D99C0DD4A308}"/>
              </a:ext>
            </a:extLst>
          </p:cNvPr>
          <p:cNvSpPr txBox="1"/>
          <p:nvPr/>
        </p:nvSpPr>
        <p:spPr>
          <a:xfrm>
            <a:off x="5142342" y="2643536"/>
            <a:ext cx="1320164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i="1" dirty="0"/>
              <a:t>IVIS analysis</a:t>
            </a:r>
            <a:endParaRPr kumimoji="1" lang="ja-JP" altLang="en-US" sz="1400" b="1" i="1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A6F8C279-49E0-91EC-2A23-F2358FCB019E}"/>
              </a:ext>
            </a:extLst>
          </p:cNvPr>
          <p:cNvCxnSpPr>
            <a:cxnSpLocks/>
          </p:cNvCxnSpPr>
          <p:nvPr/>
        </p:nvCxnSpPr>
        <p:spPr>
          <a:xfrm>
            <a:off x="1704347" y="4736973"/>
            <a:ext cx="44590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E555C559-B3C3-E9E7-21A5-40A850A3867E}"/>
              </a:ext>
            </a:extLst>
          </p:cNvPr>
          <p:cNvCxnSpPr>
            <a:cxnSpLocks/>
          </p:cNvCxnSpPr>
          <p:nvPr/>
        </p:nvCxnSpPr>
        <p:spPr>
          <a:xfrm rot="16200000">
            <a:off x="1575848" y="4736973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F6B38CC-A0ED-EC86-F9A9-06D13BF37CB4}"/>
              </a:ext>
            </a:extLst>
          </p:cNvPr>
          <p:cNvCxnSpPr>
            <a:cxnSpLocks/>
          </p:cNvCxnSpPr>
          <p:nvPr/>
        </p:nvCxnSpPr>
        <p:spPr>
          <a:xfrm>
            <a:off x="4201624" y="5395416"/>
            <a:ext cx="124211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図形グループ 2">
            <a:extLst>
              <a:ext uri="{FF2B5EF4-FFF2-40B4-BE49-F238E27FC236}">
                <a16:creationId xmlns:a16="http://schemas.microsoft.com/office/drawing/2014/main" id="{C9F06FFF-DA5C-B306-95A4-CBBA6AF5AF74}"/>
              </a:ext>
            </a:extLst>
          </p:cNvPr>
          <p:cNvGrpSpPr/>
          <p:nvPr/>
        </p:nvGrpSpPr>
        <p:grpSpPr>
          <a:xfrm>
            <a:off x="2288645" y="3484071"/>
            <a:ext cx="686800" cy="320186"/>
            <a:chOff x="2335213" y="1373188"/>
            <a:chExt cx="1597025" cy="744537"/>
          </a:xfrm>
        </p:grpSpPr>
        <p:sp>
          <p:nvSpPr>
            <p:cNvPr id="24" name="Line 13">
              <a:extLst>
                <a:ext uri="{FF2B5EF4-FFF2-40B4-BE49-F238E27FC236}">
                  <a16:creationId xmlns:a16="http://schemas.microsoft.com/office/drawing/2014/main" id="{A780665D-D1C6-5CA7-654E-5006A82F8A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5213" y="1870075"/>
              <a:ext cx="655637" cy="24765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5" name="Freeform 14">
              <a:extLst>
                <a:ext uri="{FF2B5EF4-FFF2-40B4-BE49-F238E27FC236}">
                  <a16:creationId xmlns:a16="http://schemas.microsoft.com/office/drawing/2014/main" id="{7B2955D4-4851-ACED-C73A-7000FA2FCE7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8263" y="1573213"/>
              <a:ext cx="920750" cy="514350"/>
            </a:xfrm>
            <a:custGeom>
              <a:avLst/>
              <a:gdLst>
                <a:gd name="T0" fmla="*/ 2147483647 w 736"/>
                <a:gd name="T1" fmla="*/ 0 h 392"/>
                <a:gd name="T2" fmla="*/ 2147483647 w 736"/>
                <a:gd name="T3" fmla="*/ 2147483647 h 392"/>
                <a:gd name="T4" fmla="*/ 2147483647 w 736"/>
                <a:gd name="T5" fmla="*/ 2147483647 h 392"/>
                <a:gd name="T6" fmla="*/ 0 w 736"/>
                <a:gd name="T7" fmla="*/ 2147483647 h 392"/>
                <a:gd name="T8" fmla="*/ 2147483647 w 736"/>
                <a:gd name="T9" fmla="*/ 0 h 39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36" h="392">
                  <a:moveTo>
                    <a:pt x="680" y="0"/>
                  </a:moveTo>
                  <a:lnTo>
                    <a:pt x="736" y="144"/>
                  </a:lnTo>
                  <a:lnTo>
                    <a:pt x="56" y="392"/>
                  </a:lnTo>
                  <a:lnTo>
                    <a:pt x="0" y="248"/>
                  </a:lnTo>
                  <a:lnTo>
                    <a:pt x="680" y="0"/>
                  </a:lnTo>
                  <a:close/>
                </a:path>
              </a:pathLst>
            </a:custGeom>
            <a:blipFill dpi="0" rotWithShape="0"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tile tx="0" ty="0" sx="100000" sy="100000" flip="none" algn="tl"/>
            </a:blip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6" name="Freeform 14">
              <a:extLst>
                <a:ext uri="{FF2B5EF4-FFF2-40B4-BE49-F238E27FC236}">
                  <a16:creationId xmlns:a16="http://schemas.microsoft.com/office/drawing/2014/main" id="{07F2E56F-B616-01A3-F470-EC9289E27D4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3388" y="1433513"/>
              <a:ext cx="922337" cy="514350"/>
            </a:xfrm>
            <a:custGeom>
              <a:avLst/>
              <a:gdLst>
                <a:gd name="T0" fmla="*/ 2147483647 w 736"/>
                <a:gd name="T1" fmla="*/ 0 h 392"/>
                <a:gd name="T2" fmla="*/ 2147483647 w 736"/>
                <a:gd name="T3" fmla="*/ 2147483647 h 392"/>
                <a:gd name="T4" fmla="*/ 2147483647 w 736"/>
                <a:gd name="T5" fmla="*/ 2147483647 h 392"/>
                <a:gd name="T6" fmla="*/ 0 w 736"/>
                <a:gd name="T7" fmla="*/ 2147483647 h 392"/>
                <a:gd name="T8" fmla="*/ 2147483647 w 736"/>
                <a:gd name="T9" fmla="*/ 0 h 39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36" h="392">
                  <a:moveTo>
                    <a:pt x="680" y="0"/>
                  </a:moveTo>
                  <a:lnTo>
                    <a:pt x="736" y="144"/>
                  </a:lnTo>
                  <a:lnTo>
                    <a:pt x="56" y="392"/>
                  </a:lnTo>
                  <a:lnTo>
                    <a:pt x="0" y="248"/>
                  </a:lnTo>
                  <a:lnTo>
                    <a:pt x="680" y="0"/>
                  </a:lnTo>
                  <a:close/>
                </a:path>
              </a:pathLst>
            </a:custGeom>
            <a:solidFill>
              <a:schemeClr val="bg1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7" name="Freeform 16">
              <a:extLst>
                <a:ext uri="{FF2B5EF4-FFF2-40B4-BE49-F238E27FC236}">
                  <a16:creationId xmlns:a16="http://schemas.microsoft.com/office/drawing/2014/main" id="{D99C6D73-1992-8C5B-2EFB-DC2337A2F05A}"/>
                </a:ext>
              </a:extLst>
            </p:cNvPr>
            <p:cNvSpPr>
              <a:spLocks/>
            </p:cNvSpPr>
            <p:nvPr/>
          </p:nvSpPr>
          <p:spPr bwMode="auto">
            <a:xfrm>
              <a:off x="3405188" y="1412875"/>
              <a:ext cx="201612" cy="465138"/>
            </a:xfrm>
            <a:custGeom>
              <a:avLst/>
              <a:gdLst>
                <a:gd name="T0" fmla="*/ 2147483647 w 128"/>
                <a:gd name="T1" fmla="*/ 0 h 304"/>
                <a:gd name="T2" fmla="*/ 2147483647 w 128"/>
                <a:gd name="T3" fmla="*/ 2147483647 h 304"/>
                <a:gd name="T4" fmla="*/ 2147483647 w 128"/>
                <a:gd name="T5" fmla="*/ 2147483647 h 304"/>
                <a:gd name="T6" fmla="*/ 0 w 128"/>
                <a:gd name="T7" fmla="*/ 2147483647 h 304"/>
                <a:gd name="T8" fmla="*/ 2147483647 w 128"/>
                <a:gd name="T9" fmla="*/ 0 h 3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8" h="304">
                  <a:moveTo>
                    <a:pt x="24" y="0"/>
                  </a:moveTo>
                  <a:lnTo>
                    <a:pt x="128" y="296"/>
                  </a:lnTo>
                  <a:lnTo>
                    <a:pt x="104" y="304"/>
                  </a:lnTo>
                  <a:lnTo>
                    <a:pt x="0" y="16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28" name="Freeform 17">
              <a:extLst>
                <a:ext uri="{FF2B5EF4-FFF2-40B4-BE49-F238E27FC236}">
                  <a16:creationId xmlns:a16="http://schemas.microsoft.com/office/drawing/2014/main" id="{258C1BE9-E6E3-EABF-9B69-32322027C1A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7775" y="1373188"/>
              <a:ext cx="144463" cy="323850"/>
            </a:xfrm>
            <a:custGeom>
              <a:avLst/>
              <a:gdLst>
                <a:gd name="T0" fmla="*/ 2147483647 w 120"/>
                <a:gd name="T1" fmla="*/ 0 h 272"/>
                <a:gd name="T2" fmla="*/ 2147483647 w 120"/>
                <a:gd name="T3" fmla="*/ 2147483647 h 272"/>
                <a:gd name="T4" fmla="*/ 2147483647 w 120"/>
                <a:gd name="T5" fmla="*/ 2147483647 h 272"/>
                <a:gd name="T6" fmla="*/ 0 w 120"/>
                <a:gd name="T7" fmla="*/ 2147483647 h 272"/>
                <a:gd name="T8" fmla="*/ 2147483647 w 120"/>
                <a:gd name="T9" fmla="*/ 0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0" h="272">
                  <a:moveTo>
                    <a:pt x="24" y="0"/>
                  </a:moveTo>
                  <a:lnTo>
                    <a:pt x="120" y="264"/>
                  </a:lnTo>
                  <a:lnTo>
                    <a:pt x="96" y="272"/>
                  </a:lnTo>
                  <a:lnTo>
                    <a:pt x="0" y="8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1D88B8F-C1C5-9B7D-D990-1F359491D0C7}"/>
              </a:ext>
            </a:extLst>
          </p:cNvPr>
          <p:cNvSpPr txBox="1"/>
          <p:nvPr/>
        </p:nvSpPr>
        <p:spPr>
          <a:xfrm>
            <a:off x="1137804" y="2643536"/>
            <a:ext cx="1593656" cy="622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i="1" dirty="0"/>
              <a:t>Hydrodynamics</a:t>
            </a:r>
          </a:p>
          <a:p>
            <a:pPr algn="ctr"/>
            <a:r>
              <a:rPr kumimoji="1" lang="en-US" altLang="ja-JP" sz="1400" b="1" i="1" dirty="0"/>
              <a:t>injection</a:t>
            </a:r>
            <a:endParaRPr kumimoji="1" lang="ja-JP" altLang="en-US" sz="1400" b="1" i="1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248330F-4C02-4857-6ABC-18C1160F897E}"/>
              </a:ext>
            </a:extLst>
          </p:cNvPr>
          <p:cNvSpPr txBox="1"/>
          <p:nvPr/>
        </p:nvSpPr>
        <p:spPr>
          <a:xfrm>
            <a:off x="3405906" y="2643536"/>
            <a:ext cx="1578934" cy="622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i="1" dirty="0" err="1"/>
              <a:t>Akalumine</a:t>
            </a:r>
            <a:endParaRPr lang="en-US" altLang="ja-JP" sz="1400" b="1" i="1" dirty="0"/>
          </a:p>
          <a:p>
            <a:pPr algn="ctr"/>
            <a:r>
              <a:rPr lang="en-US" altLang="ja-JP" sz="1400" b="1" i="1" dirty="0"/>
              <a:t>administration</a:t>
            </a:r>
            <a:r>
              <a:rPr lang="ja-JP" altLang="ja-JP" sz="1400" b="1" i="1"/>
              <a:t> </a:t>
            </a:r>
            <a:endParaRPr kumimoji="1" lang="ja-JP" altLang="en-US" sz="1400" b="1" i="1"/>
          </a:p>
        </p:txBody>
      </p: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89F55061-EDF0-6505-D626-765F850D1778}"/>
              </a:ext>
            </a:extLst>
          </p:cNvPr>
          <p:cNvCxnSpPr>
            <a:cxnSpLocks/>
          </p:cNvCxnSpPr>
          <p:nvPr/>
        </p:nvCxnSpPr>
        <p:spPr>
          <a:xfrm rot="16200000">
            <a:off x="4073201" y="5389948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871DD569-BCB8-8CF8-D08C-D659DE2E31AD}"/>
              </a:ext>
            </a:extLst>
          </p:cNvPr>
          <p:cNvCxnSpPr>
            <a:cxnSpLocks/>
          </p:cNvCxnSpPr>
          <p:nvPr/>
        </p:nvCxnSpPr>
        <p:spPr>
          <a:xfrm rot="16200000">
            <a:off x="4238945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DCD730D7-3163-1819-B2E7-EE840DC0A22F}"/>
              </a:ext>
            </a:extLst>
          </p:cNvPr>
          <p:cNvCxnSpPr>
            <a:cxnSpLocks/>
          </p:cNvCxnSpPr>
          <p:nvPr/>
        </p:nvCxnSpPr>
        <p:spPr>
          <a:xfrm rot="16200000">
            <a:off x="4699224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7948C12-F8B2-A097-8708-312625476AE7}"/>
              </a:ext>
            </a:extLst>
          </p:cNvPr>
          <p:cNvSpPr txBox="1"/>
          <p:nvPr/>
        </p:nvSpPr>
        <p:spPr>
          <a:xfrm>
            <a:off x="1364003" y="4275601"/>
            <a:ext cx="684913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day 0</a:t>
            </a:r>
            <a:endParaRPr kumimoji="1" lang="ja-JP" altLang="en-US" sz="1400"/>
          </a:p>
        </p:txBody>
      </p:sp>
      <p:cxnSp>
        <p:nvCxnSpPr>
          <p:cNvPr id="144" name="直線コネクタ 143">
            <a:extLst>
              <a:ext uri="{FF2B5EF4-FFF2-40B4-BE49-F238E27FC236}">
                <a16:creationId xmlns:a16="http://schemas.microsoft.com/office/drawing/2014/main" id="{41ED748F-0EFF-C3F1-261A-3EE78A30A034}"/>
              </a:ext>
            </a:extLst>
          </p:cNvPr>
          <p:cNvCxnSpPr>
            <a:cxnSpLocks/>
          </p:cNvCxnSpPr>
          <p:nvPr/>
        </p:nvCxnSpPr>
        <p:spPr>
          <a:xfrm rot="16200000">
            <a:off x="4071592" y="4736972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93D91182-CE9A-4B76-C52E-DBA3968078B6}"/>
              </a:ext>
            </a:extLst>
          </p:cNvPr>
          <p:cNvSpPr txBox="1"/>
          <p:nvPr/>
        </p:nvSpPr>
        <p:spPr>
          <a:xfrm>
            <a:off x="4041238" y="4275601"/>
            <a:ext cx="328421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2</a:t>
            </a:r>
            <a:endParaRPr kumimoji="1" lang="ja-JP" altLang="en-US" sz="1400"/>
          </a:p>
        </p:txBody>
      </p: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0B6BA67E-C157-91C1-FF19-88BD2E8809DE}"/>
              </a:ext>
            </a:extLst>
          </p:cNvPr>
          <p:cNvCxnSpPr>
            <a:cxnSpLocks/>
          </p:cNvCxnSpPr>
          <p:nvPr/>
        </p:nvCxnSpPr>
        <p:spPr>
          <a:xfrm rot="16200000">
            <a:off x="6039826" y="4736973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728237D0-7927-3EC8-16CB-B09405464954}"/>
              </a:ext>
            </a:extLst>
          </p:cNvPr>
          <p:cNvCxnSpPr>
            <a:cxnSpLocks/>
          </p:cNvCxnSpPr>
          <p:nvPr/>
        </p:nvCxnSpPr>
        <p:spPr>
          <a:xfrm rot="16200000">
            <a:off x="6043571" y="5389949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左大かっこ 148">
            <a:extLst>
              <a:ext uri="{FF2B5EF4-FFF2-40B4-BE49-F238E27FC236}">
                <a16:creationId xmlns:a16="http://schemas.microsoft.com/office/drawing/2014/main" id="{683357F0-B6FD-10A1-24B3-135DD628A4DC}"/>
              </a:ext>
            </a:extLst>
          </p:cNvPr>
          <p:cNvSpPr/>
          <p:nvPr/>
        </p:nvSpPr>
        <p:spPr>
          <a:xfrm rot="16200000" flipH="1">
            <a:off x="5245002" y="3583787"/>
            <a:ext cx="85663" cy="175609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50" name="図 149">
            <a:extLst>
              <a:ext uri="{FF2B5EF4-FFF2-40B4-BE49-F238E27FC236}">
                <a16:creationId xmlns:a16="http://schemas.microsoft.com/office/drawing/2014/main" id="{FC4A22BB-C3A2-C6D1-FB97-40356057D9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88806" y="3097423"/>
            <a:ext cx="827233" cy="1259030"/>
          </a:xfrm>
          <a:prstGeom prst="rect">
            <a:avLst/>
          </a:prstGeom>
        </p:spPr>
      </p:pic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05CE3B5D-4884-B1FA-B042-A3B1FB2C565B}"/>
              </a:ext>
            </a:extLst>
          </p:cNvPr>
          <p:cNvSpPr txBox="1"/>
          <p:nvPr/>
        </p:nvSpPr>
        <p:spPr>
          <a:xfrm>
            <a:off x="3656937" y="4962078"/>
            <a:ext cx="707954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min 0</a:t>
            </a:r>
            <a:endParaRPr kumimoji="1" lang="ja-JP" altLang="en-US" sz="140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BFE733CA-9C01-8D3B-E0FB-DCFE41758EAD}"/>
              </a:ext>
            </a:extLst>
          </p:cNvPr>
          <p:cNvSpPr txBox="1"/>
          <p:nvPr/>
        </p:nvSpPr>
        <p:spPr>
          <a:xfrm>
            <a:off x="4693703" y="4962078"/>
            <a:ext cx="328421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4</a:t>
            </a:r>
            <a:endParaRPr kumimoji="1" lang="ja-JP" altLang="en-US" sz="140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89AEDAAA-43FF-C8D5-314E-9C2E1C70675D}"/>
              </a:ext>
            </a:extLst>
          </p:cNvPr>
          <p:cNvSpPr txBox="1"/>
          <p:nvPr/>
        </p:nvSpPr>
        <p:spPr>
          <a:xfrm>
            <a:off x="5955671" y="4962078"/>
            <a:ext cx="437130" cy="3661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/>
              <a:t>17</a:t>
            </a:r>
            <a:endParaRPr kumimoji="1" lang="ja-JP" altLang="en-US" sz="1400"/>
          </a:p>
        </p:txBody>
      </p:sp>
      <p:cxnSp>
        <p:nvCxnSpPr>
          <p:cNvPr id="164" name="直線矢印コネクタ 163">
            <a:extLst>
              <a:ext uri="{FF2B5EF4-FFF2-40B4-BE49-F238E27FC236}">
                <a16:creationId xmlns:a16="http://schemas.microsoft.com/office/drawing/2014/main" id="{D5E0D01E-26DA-561E-1A60-C47D1A20A4F2}"/>
              </a:ext>
            </a:extLst>
          </p:cNvPr>
          <p:cNvCxnSpPr>
            <a:cxnSpLocks/>
          </p:cNvCxnSpPr>
          <p:nvPr/>
        </p:nvCxnSpPr>
        <p:spPr>
          <a:xfrm flipV="1">
            <a:off x="4862434" y="5615115"/>
            <a:ext cx="0" cy="214158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矢印コネクタ 165">
            <a:extLst>
              <a:ext uri="{FF2B5EF4-FFF2-40B4-BE49-F238E27FC236}">
                <a16:creationId xmlns:a16="http://schemas.microsoft.com/office/drawing/2014/main" id="{808EB7F4-1DF3-6797-0259-6FF0B3470D8B}"/>
              </a:ext>
            </a:extLst>
          </p:cNvPr>
          <p:cNvCxnSpPr>
            <a:cxnSpLocks/>
          </p:cNvCxnSpPr>
          <p:nvPr/>
        </p:nvCxnSpPr>
        <p:spPr>
          <a:xfrm flipV="1">
            <a:off x="6180787" y="5615115"/>
            <a:ext cx="0" cy="214158"/>
          </a:xfrm>
          <a:prstGeom prst="straightConnector1">
            <a:avLst/>
          </a:prstGeom>
          <a:ln w="31750"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D34B3E72-2CEC-9F38-3560-78DD338E8229}"/>
              </a:ext>
            </a:extLst>
          </p:cNvPr>
          <p:cNvSpPr txBox="1"/>
          <p:nvPr/>
        </p:nvSpPr>
        <p:spPr>
          <a:xfrm>
            <a:off x="4527530" y="5819143"/>
            <a:ext cx="669809" cy="5126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Whole</a:t>
            </a:r>
          </a:p>
          <a:p>
            <a:pPr algn="ctr"/>
            <a:r>
              <a:rPr kumimoji="1" lang="en-US" altLang="ja-JP" sz="1100" i="1" dirty="0"/>
              <a:t>mouse</a:t>
            </a:r>
            <a:endParaRPr kumimoji="1" lang="ja-JP" altLang="en-US" sz="1100" i="1"/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3BDD4EF8-3040-A0CE-8262-1CF2389D7FE8}"/>
              </a:ext>
            </a:extLst>
          </p:cNvPr>
          <p:cNvSpPr txBox="1"/>
          <p:nvPr/>
        </p:nvSpPr>
        <p:spPr>
          <a:xfrm>
            <a:off x="5799284" y="5819143"/>
            <a:ext cx="749911" cy="5126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i="1" dirty="0"/>
              <a:t>Internal</a:t>
            </a:r>
          </a:p>
          <a:p>
            <a:pPr algn="ctr"/>
            <a:r>
              <a:rPr kumimoji="1" lang="en-US" altLang="ja-JP" sz="1100" i="1" dirty="0"/>
              <a:t>organs</a:t>
            </a:r>
            <a:endParaRPr kumimoji="1" lang="ja-JP" altLang="en-US" sz="1100" i="1"/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C42DF554-58A6-965B-8892-F36E3EB36043}"/>
              </a:ext>
            </a:extLst>
          </p:cNvPr>
          <p:cNvSpPr txBox="1"/>
          <p:nvPr/>
        </p:nvSpPr>
        <p:spPr>
          <a:xfrm>
            <a:off x="819132" y="6734293"/>
            <a:ext cx="725956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err="1"/>
              <a:t>VSVg</a:t>
            </a:r>
            <a:endParaRPr kumimoji="1" lang="ja-JP" altLang="en-US" sz="1600" b="1"/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3333E744-778C-0A6D-14FD-65A189EC1CDE}"/>
              </a:ext>
            </a:extLst>
          </p:cNvPr>
          <p:cNvSpPr txBox="1"/>
          <p:nvPr/>
        </p:nvSpPr>
        <p:spPr>
          <a:xfrm>
            <a:off x="661560" y="6215433"/>
            <a:ext cx="395172" cy="29294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(C)</a:t>
            </a:r>
            <a:endParaRPr kumimoji="1" lang="ja-JP" altLang="en-US" b="1"/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4BEFDC13-041D-BF2C-5168-7C01841A708D}"/>
              </a:ext>
            </a:extLst>
          </p:cNvPr>
          <p:cNvSpPr txBox="1"/>
          <p:nvPr/>
        </p:nvSpPr>
        <p:spPr>
          <a:xfrm>
            <a:off x="1732456" y="6734293"/>
            <a:ext cx="463831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600" b="1"/>
              <a:t>＋</a:t>
            </a: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5C6D4BB8-F49A-A2EA-0A7B-63405EF715B5}"/>
              </a:ext>
            </a:extLst>
          </p:cNvPr>
          <p:cNvSpPr txBox="1"/>
          <p:nvPr/>
        </p:nvSpPr>
        <p:spPr>
          <a:xfrm>
            <a:off x="2660900" y="6734293"/>
            <a:ext cx="463831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600" b="1"/>
              <a:t>ー</a:t>
            </a: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DEFC7089-A2F1-2AD6-04AB-FE097FDFDCB4}"/>
              </a:ext>
            </a:extLst>
          </p:cNvPr>
          <p:cNvSpPr txBox="1"/>
          <p:nvPr/>
        </p:nvSpPr>
        <p:spPr>
          <a:xfrm>
            <a:off x="4119249" y="6734293"/>
            <a:ext cx="463831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600" b="1"/>
              <a:t>＋</a:t>
            </a: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D54F9C6A-D37B-AAD1-E10A-8A4D78904081}"/>
              </a:ext>
            </a:extLst>
          </p:cNvPr>
          <p:cNvSpPr txBox="1"/>
          <p:nvPr/>
        </p:nvSpPr>
        <p:spPr>
          <a:xfrm>
            <a:off x="5327497" y="6734293"/>
            <a:ext cx="463831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600" b="1"/>
              <a:t>ー</a:t>
            </a: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4FE21962-33C8-96F5-F7E2-14BD00592525}"/>
              </a:ext>
            </a:extLst>
          </p:cNvPr>
          <p:cNvSpPr txBox="1"/>
          <p:nvPr/>
        </p:nvSpPr>
        <p:spPr>
          <a:xfrm>
            <a:off x="1659648" y="6418246"/>
            <a:ext cx="1602430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i="1" dirty="0"/>
              <a:t>Whole mouse</a:t>
            </a:r>
            <a:endParaRPr kumimoji="1" lang="ja-JP" altLang="en-US" sz="1600" b="1" i="1"/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37E7633A-3E0A-7291-2004-BDD2D1AC6E03}"/>
              </a:ext>
            </a:extLst>
          </p:cNvPr>
          <p:cNvSpPr txBox="1"/>
          <p:nvPr/>
        </p:nvSpPr>
        <p:spPr>
          <a:xfrm>
            <a:off x="4151419" y="6418246"/>
            <a:ext cx="1766449" cy="402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b="1" i="1" dirty="0"/>
              <a:t>Internal organs</a:t>
            </a:r>
            <a:endParaRPr kumimoji="1" lang="ja-JP" altLang="en-US" sz="1600" b="1" i="1"/>
          </a:p>
        </p:txBody>
      </p:sp>
      <p:cxnSp>
        <p:nvCxnSpPr>
          <p:cNvPr id="201" name="直線コネクタ 200">
            <a:extLst>
              <a:ext uri="{FF2B5EF4-FFF2-40B4-BE49-F238E27FC236}">
                <a16:creationId xmlns:a16="http://schemas.microsoft.com/office/drawing/2014/main" id="{36ABC977-3B44-543A-2D48-FF9B8126CF18}"/>
              </a:ext>
            </a:extLst>
          </p:cNvPr>
          <p:cNvCxnSpPr>
            <a:cxnSpLocks/>
          </p:cNvCxnSpPr>
          <p:nvPr/>
        </p:nvCxnSpPr>
        <p:spPr>
          <a:xfrm rot="16200000">
            <a:off x="4392371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直線コネクタ 202">
            <a:extLst>
              <a:ext uri="{FF2B5EF4-FFF2-40B4-BE49-F238E27FC236}">
                <a16:creationId xmlns:a16="http://schemas.microsoft.com/office/drawing/2014/main" id="{4B8C4A80-996F-EDCE-CB5F-8ED84B17A406}"/>
              </a:ext>
            </a:extLst>
          </p:cNvPr>
          <p:cNvCxnSpPr>
            <a:cxnSpLocks/>
          </p:cNvCxnSpPr>
          <p:nvPr/>
        </p:nvCxnSpPr>
        <p:spPr>
          <a:xfrm rot="16200000">
            <a:off x="4545798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直線コネクタ 203">
            <a:extLst>
              <a:ext uri="{FF2B5EF4-FFF2-40B4-BE49-F238E27FC236}">
                <a16:creationId xmlns:a16="http://schemas.microsoft.com/office/drawing/2014/main" id="{1E0261DA-8AC5-100B-1028-1B45DB21122C}"/>
              </a:ext>
            </a:extLst>
          </p:cNvPr>
          <p:cNvCxnSpPr>
            <a:cxnSpLocks/>
          </p:cNvCxnSpPr>
          <p:nvPr/>
        </p:nvCxnSpPr>
        <p:spPr>
          <a:xfrm flipV="1">
            <a:off x="5532749" y="5395416"/>
            <a:ext cx="6479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直線コネクタ 207">
            <a:extLst>
              <a:ext uri="{FF2B5EF4-FFF2-40B4-BE49-F238E27FC236}">
                <a16:creationId xmlns:a16="http://schemas.microsoft.com/office/drawing/2014/main" id="{538582C0-1719-1AA4-8727-3BE807DBF04A}"/>
              </a:ext>
            </a:extLst>
          </p:cNvPr>
          <p:cNvCxnSpPr>
            <a:cxnSpLocks/>
          </p:cNvCxnSpPr>
          <p:nvPr/>
        </p:nvCxnSpPr>
        <p:spPr>
          <a:xfrm rot="16200000">
            <a:off x="5883323" y="5389949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E11BC538-8E54-60DF-C83C-1B4086C9EDB5}"/>
              </a:ext>
            </a:extLst>
          </p:cNvPr>
          <p:cNvCxnSpPr>
            <a:cxnSpLocks/>
          </p:cNvCxnSpPr>
          <p:nvPr/>
        </p:nvCxnSpPr>
        <p:spPr>
          <a:xfrm rot="16200000">
            <a:off x="4852651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43FE800F-1003-6AAF-2AA7-9D179C67DF43}"/>
              </a:ext>
            </a:extLst>
          </p:cNvPr>
          <p:cNvCxnSpPr>
            <a:cxnSpLocks/>
          </p:cNvCxnSpPr>
          <p:nvPr/>
        </p:nvCxnSpPr>
        <p:spPr>
          <a:xfrm rot="16200000">
            <a:off x="5006077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A67C92A8-897F-19AF-F0A9-9A9A7F5D2156}"/>
              </a:ext>
            </a:extLst>
          </p:cNvPr>
          <p:cNvCxnSpPr>
            <a:cxnSpLocks/>
          </p:cNvCxnSpPr>
          <p:nvPr/>
        </p:nvCxnSpPr>
        <p:spPr>
          <a:xfrm rot="16200000">
            <a:off x="5159506" y="5388415"/>
            <a:ext cx="25699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617A01AE-0B5F-3DFC-CA33-7C85EBF933C4}"/>
              </a:ext>
            </a:extLst>
          </p:cNvPr>
          <p:cNvGrpSpPr/>
          <p:nvPr/>
        </p:nvGrpSpPr>
        <p:grpSpPr>
          <a:xfrm>
            <a:off x="5707191" y="5266921"/>
            <a:ext cx="460282" cy="256990"/>
            <a:chOff x="9490625" y="7512968"/>
            <a:chExt cx="386867" cy="216000"/>
          </a:xfrm>
        </p:grpSpPr>
        <p:cxnSp>
          <p:nvCxnSpPr>
            <p:cNvPr id="214" name="直線コネクタ 213">
              <a:extLst>
                <a:ext uri="{FF2B5EF4-FFF2-40B4-BE49-F238E27FC236}">
                  <a16:creationId xmlns:a16="http://schemas.microsoft.com/office/drawing/2014/main" id="{DF427EF8-F5F6-7619-F844-DE9B9A7F4D8B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382625" y="7620968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直線コネクタ 216">
              <a:extLst>
                <a:ext uri="{FF2B5EF4-FFF2-40B4-BE49-F238E27FC236}">
                  <a16:creationId xmlns:a16="http://schemas.microsoft.com/office/drawing/2014/main" id="{EFB69B6B-872A-5E6A-F6A3-59F76C53CE3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511580" y="7620968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直線コネクタ 217">
              <a:extLst>
                <a:ext uri="{FF2B5EF4-FFF2-40B4-BE49-F238E27FC236}">
                  <a16:creationId xmlns:a16="http://schemas.microsoft.com/office/drawing/2014/main" id="{B7A42DEC-4946-18D9-A183-1DEF2CA3C261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640535" y="7620968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直線コネクタ 218">
              <a:extLst>
                <a:ext uri="{FF2B5EF4-FFF2-40B4-BE49-F238E27FC236}">
                  <a16:creationId xmlns:a16="http://schemas.microsoft.com/office/drawing/2014/main" id="{82D7D28E-09E6-18DD-C0FB-C4E41619BFBA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9769492" y="7620968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0DFF13F7-2123-28EE-127F-45DA1AB11BFE}"/>
              </a:ext>
            </a:extLst>
          </p:cNvPr>
          <p:cNvGrpSpPr/>
          <p:nvPr/>
        </p:nvGrpSpPr>
        <p:grpSpPr>
          <a:xfrm>
            <a:off x="5411536" y="5278721"/>
            <a:ext cx="131207" cy="240800"/>
            <a:chOff x="6801984" y="1873766"/>
            <a:chExt cx="110280" cy="202393"/>
          </a:xfrm>
        </p:grpSpPr>
        <p:cxnSp>
          <p:nvCxnSpPr>
            <p:cNvPr id="20" name="直線コネクタ 210">
              <a:extLst>
                <a:ext uri="{FF2B5EF4-FFF2-40B4-BE49-F238E27FC236}">
                  <a16:creationId xmlns:a16="http://schemas.microsoft.com/office/drawing/2014/main" id="{B071D204-F3BB-1A8B-3314-D8EF69B55F7B}"/>
                </a:ext>
              </a:extLst>
            </p:cNvPr>
            <p:cNvCxnSpPr>
              <a:cxnSpLocks/>
            </p:cNvCxnSpPr>
            <p:nvPr/>
          </p:nvCxnSpPr>
          <p:spPr>
            <a:xfrm>
              <a:off x="6801984" y="1876625"/>
              <a:ext cx="43454" cy="199534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210">
              <a:extLst>
                <a:ext uri="{FF2B5EF4-FFF2-40B4-BE49-F238E27FC236}">
                  <a16:creationId xmlns:a16="http://schemas.microsoft.com/office/drawing/2014/main" id="{81421D31-E65C-F2DD-98F4-7484BA3E249D}"/>
                </a:ext>
              </a:extLst>
            </p:cNvPr>
            <p:cNvCxnSpPr>
              <a:cxnSpLocks/>
            </p:cNvCxnSpPr>
            <p:nvPr/>
          </p:nvCxnSpPr>
          <p:spPr>
            <a:xfrm>
              <a:off x="6868810" y="1873766"/>
              <a:ext cx="43454" cy="199534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953D6AE1-FA6D-B66F-D8AD-4A97D6F3E8E3}"/>
              </a:ext>
            </a:extLst>
          </p:cNvPr>
          <p:cNvGrpSpPr>
            <a:grpSpLocks noChangeAspect="1"/>
          </p:cNvGrpSpPr>
          <p:nvPr/>
        </p:nvGrpSpPr>
        <p:grpSpPr>
          <a:xfrm>
            <a:off x="1380263" y="3260586"/>
            <a:ext cx="926142" cy="1027959"/>
            <a:chOff x="985804" y="429085"/>
            <a:chExt cx="4026800" cy="4866859"/>
          </a:xfrm>
        </p:grpSpPr>
        <p:sp>
          <p:nvSpPr>
            <p:cNvPr id="370" name="フリーフォーム 369">
              <a:extLst>
                <a:ext uri="{FF2B5EF4-FFF2-40B4-BE49-F238E27FC236}">
                  <a16:creationId xmlns:a16="http://schemas.microsoft.com/office/drawing/2014/main" id="{93B3E6A8-E2B1-B9E1-A7F4-301F46BE6B5A}"/>
                </a:ext>
              </a:extLst>
            </p:cNvPr>
            <p:cNvSpPr/>
            <p:nvPr/>
          </p:nvSpPr>
          <p:spPr>
            <a:xfrm>
              <a:off x="1593484" y="429085"/>
              <a:ext cx="672999" cy="728191"/>
            </a:xfrm>
            <a:custGeom>
              <a:avLst/>
              <a:gdLst>
                <a:gd name="connsiteX0" fmla="*/ 659210 w 672999"/>
                <a:gd name="connsiteY0" fmla="*/ 576149 h 728191"/>
                <a:gd name="connsiteX1" fmla="*/ 659210 w 672999"/>
                <a:gd name="connsiteY1" fmla="*/ 394481 h 728191"/>
                <a:gd name="connsiteX2" fmla="*/ 525986 w 672999"/>
                <a:gd name="connsiteY2" fmla="*/ 115922 h 728191"/>
                <a:gd name="connsiteX3" fmla="*/ 277705 w 672999"/>
                <a:gd name="connsiteY3" fmla="*/ 865 h 728191"/>
                <a:gd name="connsiteX4" fmla="*/ 168704 w 672999"/>
                <a:gd name="connsiteY4" fmla="*/ 67477 h 728191"/>
                <a:gd name="connsiteX5" fmla="*/ 114203 w 672999"/>
                <a:gd name="connsiteY5" fmla="*/ 146200 h 728191"/>
                <a:gd name="connsiteX6" fmla="*/ 102092 w 672999"/>
                <a:gd name="connsiteY6" fmla="*/ 200700 h 728191"/>
                <a:gd name="connsiteX7" fmla="*/ 132370 w 672999"/>
                <a:gd name="connsiteY7" fmla="*/ 333924 h 728191"/>
                <a:gd name="connsiteX8" fmla="*/ 138426 w 672999"/>
                <a:gd name="connsiteY8" fmla="*/ 479259 h 728191"/>
                <a:gd name="connsiteX9" fmla="*/ 96037 w 672999"/>
                <a:gd name="connsiteY9" fmla="*/ 594316 h 728191"/>
                <a:gd name="connsiteX10" fmla="*/ 29425 w 672999"/>
                <a:gd name="connsiteY10" fmla="*/ 685151 h 728191"/>
                <a:gd name="connsiteX11" fmla="*/ 5202 w 672999"/>
                <a:gd name="connsiteY11" fmla="*/ 727540 h 728191"/>
                <a:gd name="connsiteX12" fmla="*/ 126315 w 672999"/>
                <a:gd name="connsiteY12" fmla="*/ 654873 h 728191"/>
                <a:gd name="connsiteX13" fmla="*/ 307984 w 672999"/>
                <a:gd name="connsiteY13" fmla="*/ 606428 h 728191"/>
                <a:gd name="connsiteX14" fmla="*/ 489652 w 672999"/>
                <a:gd name="connsiteY14" fmla="*/ 600372 h 728191"/>
                <a:gd name="connsiteX15" fmla="*/ 574431 w 672999"/>
                <a:gd name="connsiteY15" fmla="*/ 606428 h 728191"/>
                <a:gd name="connsiteX16" fmla="*/ 659210 w 672999"/>
                <a:gd name="connsiteY16" fmla="*/ 576149 h 728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672999" h="728191">
                  <a:moveTo>
                    <a:pt x="659210" y="576149"/>
                  </a:moveTo>
                  <a:cubicBezTo>
                    <a:pt x="673340" y="540824"/>
                    <a:pt x="681414" y="471185"/>
                    <a:pt x="659210" y="394481"/>
                  </a:cubicBezTo>
                  <a:cubicBezTo>
                    <a:pt x="637006" y="317777"/>
                    <a:pt x="589570" y="181525"/>
                    <a:pt x="525986" y="115922"/>
                  </a:cubicBezTo>
                  <a:cubicBezTo>
                    <a:pt x="462402" y="50319"/>
                    <a:pt x="337252" y="8939"/>
                    <a:pt x="277705" y="865"/>
                  </a:cubicBezTo>
                  <a:cubicBezTo>
                    <a:pt x="218158" y="-7209"/>
                    <a:pt x="195954" y="43255"/>
                    <a:pt x="168704" y="67477"/>
                  </a:cubicBezTo>
                  <a:cubicBezTo>
                    <a:pt x="141454" y="91699"/>
                    <a:pt x="125305" y="123996"/>
                    <a:pt x="114203" y="146200"/>
                  </a:cubicBezTo>
                  <a:cubicBezTo>
                    <a:pt x="103101" y="168404"/>
                    <a:pt x="99064" y="169413"/>
                    <a:pt x="102092" y="200700"/>
                  </a:cubicBezTo>
                  <a:cubicBezTo>
                    <a:pt x="105120" y="231987"/>
                    <a:pt x="126314" y="287498"/>
                    <a:pt x="132370" y="333924"/>
                  </a:cubicBezTo>
                  <a:cubicBezTo>
                    <a:pt x="138426" y="380350"/>
                    <a:pt x="144481" y="435860"/>
                    <a:pt x="138426" y="479259"/>
                  </a:cubicBezTo>
                  <a:cubicBezTo>
                    <a:pt x="132371" y="522658"/>
                    <a:pt x="114204" y="560001"/>
                    <a:pt x="96037" y="594316"/>
                  </a:cubicBezTo>
                  <a:cubicBezTo>
                    <a:pt x="77870" y="628631"/>
                    <a:pt x="44564" y="662947"/>
                    <a:pt x="29425" y="685151"/>
                  </a:cubicBezTo>
                  <a:cubicBezTo>
                    <a:pt x="14286" y="707355"/>
                    <a:pt x="-10946" y="732586"/>
                    <a:pt x="5202" y="727540"/>
                  </a:cubicBezTo>
                  <a:cubicBezTo>
                    <a:pt x="21350" y="722494"/>
                    <a:pt x="75851" y="675058"/>
                    <a:pt x="126315" y="654873"/>
                  </a:cubicBezTo>
                  <a:cubicBezTo>
                    <a:pt x="176779" y="634688"/>
                    <a:pt x="247428" y="615511"/>
                    <a:pt x="307984" y="606428"/>
                  </a:cubicBezTo>
                  <a:cubicBezTo>
                    <a:pt x="368540" y="597345"/>
                    <a:pt x="445244" y="600372"/>
                    <a:pt x="489652" y="600372"/>
                  </a:cubicBezTo>
                  <a:cubicBezTo>
                    <a:pt x="534060" y="600372"/>
                    <a:pt x="549199" y="603400"/>
                    <a:pt x="574431" y="606428"/>
                  </a:cubicBezTo>
                  <a:cubicBezTo>
                    <a:pt x="599663" y="609456"/>
                    <a:pt x="645080" y="611474"/>
                    <a:pt x="659210" y="576149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1" name="フリーフォーム 370">
              <a:extLst>
                <a:ext uri="{FF2B5EF4-FFF2-40B4-BE49-F238E27FC236}">
                  <a16:creationId xmlns:a16="http://schemas.microsoft.com/office/drawing/2014/main" id="{5AC8A009-4513-90FF-F7A4-327D2871B3F6}"/>
                </a:ext>
              </a:extLst>
            </p:cNvPr>
            <p:cNvSpPr/>
            <p:nvPr/>
          </p:nvSpPr>
          <p:spPr>
            <a:xfrm rot="21341374">
              <a:off x="4454019" y="2433209"/>
              <a:ext cx="558585" cy="1888476"/>
            </a:xfrm>
            <a:custGeom>
              <a:avLst/>
              <a:gdLst>
                <a:gd name="connsiteX0" fmla="*/ 0 w 558586"/>
                <a:gd name="connsiteY0" fmla="*/ 1328057 h 1643802"/>
                <a:gd name="connsiteX1" fmla="*/ 283028 w 558586"/>
                <a:gd name="connsiteY1" fmla="*/ 1643742 h 1643802"/>
                <a:gd name="connsiteX2" fmla="*/ 522514 w 558586"/>
                <a:gd name="connsiteY2" fmla="*/ 1306285 h 1643802"/>
                <a:gd name="connsiteX3" fmla="*/ 544286 w 558586"/>
                <a:gd name="connsiteY3" fmla="*/ 642257 h 1643802"/>
                <a:gd name="connsiteX4" fmla="*/ 391886 w 558586"/>
                <a:gd name="connsiteY4" fmla="*/ 119742 h 1643802"/>
                <a:gd name="connsiteX5" fmla="*/ 337457 w 558586"/>
                <a:gd name="connsiteY5" fmla="*/ 0 h 16438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8586" h="1643802">
                  <a:moveTo>
                    <a:pt x="0" y="1328057"/>
                  </a:moveTo>
                  <a:cubicBezTo>
                    <a:pt x="97971" y="1487714"/>
                    <a:pt x="195942" y="1647371"/>
                    <a:pt x="283028" y="1643742"/>
                  </a:cubicBezTo>
                  <a:cubicBezTo>
                    <a:pt x="370114" y="1640113"/>
                    <a:pt x="478971" y="1473199"/>
                    <a:pt x="522514" y="1306285"/>
                  </a:cubicBezTo>
                  <a:cubicBezTo>
                    <a:pt x="566057" y="1139371"/>
                    <a:pt x="566057" y="840014"/>
                    <a:pt x="544286" y="642257"/>
                  </a:cubicBezTo>
                  <a:cubicBezTo>
                    <a:pt x="522515" y="444500"/>
                    <a:pt x="426357" y="226785"/>
                    <a:pt x="391886" y="119742"/>
                  </a:cubicBezTo>
                  <a:cubicBezTo>
                    <a:pt x="357415" y="12699"/>
                    <a:pt x="347436" y="6349"/>
                    <a:pt x="337457" y="0"/>
                  </a:cubicBezTo>
                </a:path>
              </a:pathLst>
            </a:custGeom>
            <a:noFill/>
            <a:ln w="53975"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2" name="フリーフォーム 371">
              <a:extLst>
                <a:ext uri="{FF2B5EF4-FFF2-40B4-BE49-F238E27FC236}">
                  <a16:creationId xmlns:a16="http://schemas.microsoft.com/office/drawing/2014/main" id="{2D085F08-7CFB-1968-55A6-DAD11B62F0C2}"/>
                </a:ext>
              </a:extLst>
            </p:cNvPr>
            <p:cNvSpPr/>
            <p:nvPr/>
          </p:nvSpPr>
          <p:spPr>
            <a:xfrm>
              <a:off x="2438799" y="467412"/>
              <a:ext cx="1080194" cy="1246921"/>
            </a:xfrm>
            <a:custGeom>
              <a:avLst/>
              <a:gdLst>
                <a:gd name="connsiteX0" fmla="*/ 1620 w 1080194"/>
                <a:gd name="connsiteY0" fmla="*/ 501489 h 1246921"/>
                <a:gd name="connsiteX1" fmla="*/ 213567 w 1080194"/>
                <a:gd name="connsiteY1" fmla="*/ 216874 h 1246921"/>
                <a:gd name="connsiteX2" fmla="*/ 328624 w 1080194"/>
                <a:gd name="connsiteY2" fmla="*/ 95762 h 1246921"/>
                <a:gd name="connsiteX3" fmla="*/ 401291 w 1080194"/>
                <a:gd name="connsiteY3" fmla="*/ 47316 h 1246921"/>
                <a:gd name="connsiteX4" fmla="*/ 510292 w 1080194"/>
                <a:gd name="connsiteY4" fmla="*/ 4927 h 1246921"/>
                <a:gd name="connsiteX5" fmla="*/ 601127 w 1080194"/>
                <a:gd name="connsiteY5" fmla="*/ 4927 h 1246921"/>
                <a:gd name="connsiteX6" fmla="*/ 710128 w 1080194"/>
                <a:gd name="connsiteY6" fmla="*/ 41261 h 1246921"/>
                <a:gd name="connsiteX7" fmla="*/ 867575 w 1080194"/>
                <a:gd name="connsiteY7" fmla="*/ 132095 h 1246921"/>
                <a:gd name="connsiteX8" fmla="*/ 994743 w 1080194"/>
                <a:gd name="connsiteY8" fmla="*/ 313764 h 1246921"/>
                <a:gd name="connsiteX9" fmla="*/ 1079522 w 1080194"/>
                <a:gd name="connsiteY9" fmla="*/ 628657 h 1246921"/>
                <a:gd name="connsiteX10" fmla="*/ 1031076 w 1080194"/>
                <a:gd name="connsiteY10" fmla="*/ 876938 h 1246921"/>
                <a:gd name="connsiteX11" fmla="*/ 970520 w 1080194"/>
                <a:gd name="connsiteY11" fmla="*/ 973828 h 1246921"/>
                <a:gd name="connsiteX12" fmla="*/ 867575 w 1080194"/>
                <a:gd name="connsiteY12" fmla="*/ 1088885 h 1246921"/>
                <a:gd name="connsiteX13" fmla="*/ 595071 w 1080194"/>
                <a:gd name="connsiteY13" fmla="*/ 1246331 h 1246921"/>
                <a:gd name="connsiteX14" fmla="*/ 516348 w 1080194"/>
                <a:gd name="connsiteY14" fmla="*/ 1028328 h 1246921"/>
                <a:gd name="connsiteX15" fmla="*/ 407347 w 1080194"/>
                <a:gd name="connsiteY15" fmla="*/ 864826 h 1246921"/>
                <a:gd name="connsiteX16" fmla="*/ 249900 w 1080194"/>
                <a:gd name="connsiteY16" fmla="*/ 707380 h 1246921"/>
                <a:gd name="connsiteX17" fmla="*/ 122732 w 1080194"/>
                <a:gd name="connsiteY17" fmla="*/ 592323 h 1246921"/>
                <a:gd name="connsiteX18" fmla="*/ 1620 w 1080194"/>
                <a:gd name="connsiteY18" fmla="*/ 501489 h 12469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080194" h="1246921">
                  <a:moveTo>
                    <a:pt x="1620" y="501489"/>
                  </a:moveTo>
                  <a:cubicBezTo>
                    <a:pt x="16759" y="438914"/>
                    <a:pt x="159066" y="284495"/>
                    <a:pt x="213567" y="216874"/>
                  </a:cubicBezTo>
                  <a:cubicBezTo>
                    <a:pt x="268068" y="149253"/>
                    <a:pt x="297337" y="124022"/>
                    <a:pt x="328624" y="95762"/>
                  </a:cubicBezTo>
                  <a:cubicBezTo>
                    <a:pt x="359911" y="67502"/>
                    <a:pt x="371013" y="62455"/>
                    <a:pt x="401291" y="47316"/>
                  </a:cubicBezTo>
                  <a:cubicBezTo>
                    <a:pt x="431569" y="32177"/>
                    <a:pt x="476986" y="11992"/>
                    <a:pt x="510292" y="4927"/>
                  </a:cubicBezTo>
                  <a:cubicBezTo>
                    <a:pt x="543598" y="-2138"/>
                    <a:pt x="567821" y="-1129"/>
                    <a:pt x="601127" y="4927"/>
                  </a:cubicBezTo>
                  <a:cubicBezTo>
                    <a:pt x="634433" y="10983"/>
                    <a:pt x="665720" y="20066"/>
                    <a:pt x="710128" y="41261"/>
                  </a:cubicBezTo>
                  <a:cubicBezTo>
                    <a:pt x="754536" y="62456"/>
                    <a:pt x="820139" y="86678"/>
                    <a:pt x="867575" y="132095"/>
                  </a:cubicBezTo>
                  <a:cubicBezTo>
                    <a:pt x="915011" y="177512"/>
                    <a:pt x="959419" y="231004"/>
                    <a:pt x="994743" y="313764"/>
                  </a:cubicBezTo>
                  <a:cubicBezTo>
                    <a:pt x="1030068" y="396524"/>
                    <a:pt x="1073467" y="534795"/>
                    <a:pt x="1079522" y="628657"/>
                  </a:cubicBezTo>
                  <a:cubicBezTo>
                    <a:pt x="1085577" y="722519"/>
                    <a:pt x="1049243" y="819410"/>
                    <a:pt x="1031076" y="876938"/>
                  </a:cubicBezTo>
                  <a:cubicBezTo>
                    <a:pt x="1012909" y="934466"/>
                    <a:pt x="997770" y="938504"/>
                    <a:pt x="970520" y="973828"/>
                  </a:cubicBezTo>
                  <a:cubicBezTo>
                    <a:pt x="943270" y="1009153"/>
                    <a:pt x="930150" y="1043468"/>
                    <a:pt x="867575" y="1088885"/>
                  </a:cubicBezTo>
                  <a:cubicBezTo>
                    <a:pt x="805000" y="1134302"/>
                    <a:pt x="653609" y="1256424"/>
                    <a:pt x="595071" y="1246331"/>
                  </a:cubicBezTo>
                  <a:cubicBezTo>
                    <a:pt x="536533" y="1236238"/>
                    <a:pt x="547635" y="1091912"/>
                    <a:pt x="516348" y="1028328"/>
                  </a:cubicBezTo>
                  <a:cubicBezTo>
                    <a:pt x="485061" y="964744"/>
                    <a:pt x="451755" y="918317"/>
                    <a:pt x="407347" y="864826"/>
                  </a:cubicBezTo>
                  <a:cubicBezTo>
                    <a:pt x="362939" y="811335"/>
                    <a:pt x="297336" y="752797"/>
                    <a:pt x="249900" y="707380"/>
                  </a:cubicBezTo>
                  <a:cubicBezTo>
                    <a:pt x="202464" y="661963"/>
                    <a:pt x="164112" y="624620"/>
                    <a:pt x="122732" y="592323"/>
                  </a:cubicBezTo>
                  <a:cubicBezTo>
                    <a:pt x="81352" y="560026"/>
                    <a:pt x="-13519" y="564064"/>
                    <a:pt x="1620" y="501489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3" name="フリーフォーム 372">
              <a:extLst>
                <a:ext uri="{FF2B5EF4-FFF2-40B4-BE49-F238E27FC236}">
                  <a16:creationId xmlns:a16="http://schemas.microsoft.com/office/drawing/2014/main" id="{C86C086C-7ED6-35C6-3987-074CAF23B5C2}"/>
                </a:ext>
              </a:extLst>
            </p:cNvPr>
            <p:cNvSpPr/>
            <p:nvPr/>
          </p:nvSpPr>
          <p:spPr>
            <a:xfrm>
              <a:off x="985804" y="903627"/>
              <a:ext cx="2078963" cy="1730581"/>
            </a:xfrm>
            <a:custGeom>
              <a:avLst/>
              <a:gdLst>
                <a:gd name="connsiteX0" fmla="*/ 576548 w 2078962"/>
                <a:gd name="connsiteY0" fmla="*/ 252998 h 1730581"/>
                <a:gd name="connsiteX1" fmla="*/ 322212 w 2078962"/>
                <a:gd name="connsiteY1" fmla="*/ 549724 h 1730581"/>
                <a:gd name="connsiteX2" fmla="*/ 213211 w 2078962"/>
                <a:gd name="connsiteY2" fmla="*/ 725337 h 1730581"/>
                <a:gd name="connsiteX3" fmla="*/ 164766 w 2078962"/>
                <a:gd name="connsiteY3" fmla="*/ 828283 h 1730581"/>
                <a:gd name="connsiteX4" fmla="*/ 146599 w 2078962"/>
                <a:gd name="connsiteY4" fmla="*/ 858561 h 1730581"/>
                <a:gd name="connsiteX5" fmla="*/ 92098 w 2078962"/>
                <a:gd name="connsiteY5" fmla="*/ 931229 h 1730581"/>
                <a:gd name="connsiteX6" fmla="*/ 37597 w 2078962"/>
                <a:gd name="connsiteY6" fmla="*/ 1022063 h 1730581"/>
                <a:gd name="connsiteX7" fmla="*/ 1264 w 2078962"/>
                <a:gd name="connsiteY7" fmla="*/ 1131064 h 1730581"/>
                <a:gd name="connsiteX8" fmla="*/ 13375 w 2078962"/>
                <a:gd name="connsiteY8" fmla="*/ 1246121 h 1730581"/>
                <a:gd name="connsiteX9" fmla="*/ 61820 w 2078962"/>
                <a:gd name="connsiteY9" fmla="*/ 1343011 h 1730581"/>
                <a:gd name="connsiteX10" fmla="*/ 146599 w 2078962"/>
                <a:gd name="connsiteY10" fmla="*/ 1349067 h 1730581"/>
                <a:gd name="connsiteX11" fmla="*/ 176877 w 2078962"/>
                <a:gd name="connsiteY11" fmla="*/ 1403568 h 1730581"/>
                <a:gd name="connsiteX12" fmla="*/ 176877 w 2078962"/>
                <a:gd name="connsiteY12" fmla="*/ 1452013 h 1730581"/>
                <a:gd name="connsiteX13" fmla="*/ 237433 w 2078962"/>
                <a:gd name="connsiteY13" fmla="*/ 1518625 h 1730581"/>
                <a:gd name="connsiteX14" fmla="*/ 388824 w 2078962"/>
                <a:gd name="connsiteY14" fmla="*/ 1585237 h 1730581"/>
                <a:gd name="connsiteX15" fmla="*/ 552326 w 2078962"/>
                <a:gd name="connsiteY15" fmla="*/ 1609459 h 1730581"/>
                <a:gd name="connsiteX16" fmla="*/ 691605 w 2078962"/>
                <a:gd name="connsiteY16" fmla="*/ 1567070 h 1730581"/>
                <a:gd name="connsiteX17" fmla="*/ 715828 w 2078962"/>
                <a:gd name="connsiteY17" fmla="*/ 1615515 h 1730581"/>
                <a:gd name="connsiteX18" fmla="*/ 836940 w 2078962"/>
                <a:gd name="connsiteY18" fmla="*/ 1712405 h 1730581"/>
                <a:gd name="connsiteX19" fmla="*/ 964109 w 2078962"/>
                <a:gd name="connsiteY19" fmla="*/ 1730572 h 1730581"/>
                <a:gd name="connsiteX20" fmla="*/ 1188167 w 2078962"/>
                <a:gd name="connsiteY20" fmla="*/ 1712405 h 1730581"/>
                <a:gd name="connsiteX21" fmla="*/ 1351669 w 2078962"/>
                <a:gd name="connsiteY21" fmla="*/ 1639737 h 1730581"/>
                <a:gd name="connsiteX22" fmla="*/ 1587838 w 2078962"/>
                <a:gd name="connsiteY22" fmla="*/ 1482291 h 1730581"/>
                <a:gd name="connsiteX23" fmla="*/ 1799785 w 2078962"/>
                <a:gd name="connsiteY23" fmla="*/ 1300622 h 1730581"/>
                <a:gd name="connsiteX24" fmla="*/ 1975399 w 2078962"/>
                <a:gd name="connsiteY24" fmla="*/ 1100786 h 1730581"/>
                <a:gd name="connsiteX25" fmla="*/ 2078344 w 2078962"/>
                <a:gd name="connsiteY25" fmla="*/ 828283 h 1730581"/>
                <a:gd name="connsiteX26" fmla="*/ 2017788 w 2078962"/>
                <a:gd name="connsiteY26" fmla="*/ 798005 h 1730581"/>
                <a:gd name="connsiteX27" fmla="*/ 2005677 w 2078962"/>
                <a:gd name="connsiteY27" fmla="*/ 634503 h 1730581"/>
                <a:gd name="connsiteX28" fmla="*/ 1624172 w 2078962"/>
                <a:gd name="connsiteY28" fmla="*/ 174275 h 1730581"/>
                <a:gd name="connsiteX29" fmla="*/ 1442503 w 2078962"/>
                <a:gd name="connsiteY29" fmla="*/ 34996 h 1730581"/>
                <a:gd name="connsiteX30" fmla="*/ 1279001 w 2078962"/>
                <a:gd name="connsiteY30" fmla="*/ 16829 h 1730581"/>
                <a:gd name="connsiteX31" fmla="*/ 576548 w 2078962"/>
                <a:gd name="connsiteY31" fmla="*/ 252998 h 17305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2078962" h="1730581">
                  <a:moveTo>
                    <a:pt x="576548" y="252998"/>
                  </a:moveTo>
                  <a:cubicBezTo>
                    <a:pt x="417083" y="341814"/>
                    <a:pt x="382768" y="471001"/>
                    <a:pt x="322212" y="549724"/>
                  </a:cubicBezTo>
                  <a:cubicBezTo>
                    <a:pt x="261656" y="628447"/>
                    <a:pt x="239452" y="678911"/>
                    <a:pt x="213211" y="725337"/>
                  </a:cubicBezTo>
                  <a:cubicBezTo>
                    <a:pt x="186970" y="771763"/>
                    <a:pt x="175868" y="806079"/>
                    <a:pt x="164766" y="828283"/>
                  </a:cubicBezTo>
                  <a:cubicBezTo>
                    <a:pt x="153664" y="850487"/>
                    <a:pt x="158710" y="841403"/>
                    <a:pt x="146599" y="858561"/>
                  </a:cubicBezTo>
                  <a:cubicBezTo>
                    <a:pt x="134488" y="875719"/>
                    <a:pt x="110265" y="903979"/>
                    <a:pt x="92098" y="931229"/>
                  </a:cubicBezTo>
                  <a:cubicBezTo>
                    <a:pt x="73931" y="958479"/>
                    <a:pt x="52736" y="988757"/>
                    <a:pt x="37597" y="1022063"/>
                  </a:cubicBezTo>
                  <a:cubicBezTo>
                    <a:pt x="22458" y="1055369"/>
                    <a:pt x="5301" y="1093721"/>
                    <a:pt x="1264" y="1131064"/>
                  </a:cubicBezTo>
                  <a:cubicBezTo>
                    <a:pt x="-2773" y="1168407"/>
                    <a:pt x="3282" y="1210797"/>
                    <a:pt x="13375" y="1246121"/>
                  </a:cubicBezTo>
                  <a:cubicBezTo>
                    <a:pt x="23468" y="1281445"/>
                    <a:pt x="39616" y="1325853"/>
                    <a:pt x="61820" y="1343011"/>
                  </a:cubicBezTo>
                  <a:cubicBezTo>
                    <a:pt x="84024" y="1360169"/>
                    <a:pt x="127423" y="1338974"/>
                    <a:pt x="146599" y="1349067"/>
                  </a:cubicBezTo>
                  <a:cubicBezTo>
                    <a:pt x="165775" y="1359160"/>
                    <a:pt x="171831" y="1386410"/>
                    <a:pt x="176877" y="1403568"/>
                  </a:cubicBezTo>
                  <a:cubicBezTo>
                    <a:pt x="181923" y="1420726"/>
                    <a:pt x="166784" y="1432837"/>
                    <a:pt x="176877" y="1452013"/>
                  </a:cubicBezTo>
                  <a:cubicBezTo>
                    <a:pt x="186970" y="1471189"/>
                    <a:pt x="202109" y="1496421"/>
                    <a:pt x="237433" y="1518625"/>
                  </a:cubicBezTo>
                  <a:cubicBezTo>
                    <a:pt x="272757" y="1540829"/>
                    <a:pt x="336342" y="1570098"/>
                    <a:pt x="388824" y="1585237"/>
                  </a:cubicBezTo>
                  <a:cubicBezTo>
                    <a:pt x="441306" y="1600376"/>
                    <a:pt x="501863" y="1612487"/>
                    <a:pt x="552326" y="1609459"/>
                  </a:cubicBezTo>
                  <a:cubicBezTo>
                    <a:pt x="602789" y="1606431"/>
                    <a:pt x="664355" y="1566061"/>
                    <a:pt x="691605" y="1567070"/>
                  </a:cubicBezTo>
                  <a:cubicBezTo>
                    <a:pt x="718855" y="1568079"/>
                    <a:pt x="691606" y="1591293"/>
                    <a:pt x="715828" y="1615515"/>
                  </a:cubicBezTo>
                  <a:cubicBezTo>
                    <a:pt x="740050" y="1639737"/>
                    <a:pt x="795560" y="1693229"/>
                    <a:pt x="836940" y="1712405"/>
                  </a:cubicBezTo>
                  <a:cubicBezTo>
                    <a:pt x="878320" y="1731581"/>
                    <a:pt x="905571" y="1730572"/>
                    <a:pt x="964109" y="1730572"/>
                  </a:cubicBezTo>
                  <a:cubicBezTo>
                    <a:pt x="1022647" y="1730572"/>
                    <a:pt x="1123574" y="1727544"/>
                    <a:pt x="1188167" y="1712405"/>
                  </a:cubicBezTo>
                  <a:cubicBezTo>
                    <a:pt x="1252760" y="1697266"/>
                    <a:pt x="1285057" y="1678089"/>
                    <a:pt x="1351669" y="1639737"/>
                  </a:cubicBezTo>
                  <a:cubicBezTo>
                    <a:pt x="1418281" y="1601385"/>
                    <a:pt x="1513152" y="1538810"/>
                    <a:pt x="1587838" y="1482291"/>
                  </a:cubicBezTo>
                  <a:cubicBezTo>
                    <a:pt x="1662524" y="1425772"/>
                    <a:pt x="1735191" y="1364206"/>
                    <a:pt x="1799785" y="1300622"/>
                  </a:cubicBezTo>
                  <a:cubicBezTo>
                    <a:pt x="1864379" y="1237038"/>
                    <a:pt x="1928973" y="1179509"/>
                    <a:pt x="1975399" y="1100786"/>
                  </a:cubicBezTo>
                  <a:cubicBezTo>
                    <a:pt x="2021825" y="1022063"/>
                    <a:pt x="2071279" y="878746"/>
                    <a:pt x="2078344" y="828283"/>
                  </a:cubicBezTo>
                  <a:cubicBezTo>
                    <a:pt x="2085409" y="777820"/>
                    <a:pt x="2029899" y="830302"/>
                    <a:pt x="2017788" y="798005"/>
                  </a:cubicBezTo>
                  <a:cubicBezTo>
                    <a:pt x="2005677" y="765708"/>
                    <a:pt x="2071280" y="738458"/>
                    <a:pt x="2005677" y="634503"/>
                  </a:cubicBezTo>
                  <a:cubicBezTo>
                    <a:pt x="1940074" y="530548"/>
                    <a:pt x="1718034" y="274193"/>
                    <a:pt x="1624172" y="174275"/>
                  </a:cubicBezTo>
                  <a:cubicBezTo>
                    <a:pt x="1530310" y="74357"/>
                    <a:pt x="1500031" y="61237"/>
                    <a:pt x="1442503" y="34996"/>
                  </a:cubicBezTo>
                  <a:cubicBezTo>
                    <a:pt x="1384975" y="8755"/>
                    <a:pt x="1426355" y="-18496"/>
                    <a:pt x="1279001" y="16829"/>
                  </a:cubicBezTo>
                  <a:cubicBezTo>
                    <a:pt x="1131647" y="52154"/>
                    <a:pt x="736013" y="164182"/>
                    <a:pt x="576548" y="252998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4" name="フリーフォーム 373">
              <a:extLst>
                <a:ext uri="{FF2B5EF4-FFF2-40B4-BE49-F238E27FC236}">
                  <a16:creationId xmlns:a16="http://schemas.microsoft.com/office/drawing/2014/main" id="{6F85068A-8A5F-9352-A070-A239FEF97F33}"/>
                </a:ext>
              </a:extLst>
            </p:cNvPr>
            <p:cNvSpPr/>
            <p:nvPr/>
          </p:nvSpPr>
          <p:spPr>
            <a:xfrm>
              <a:off x="2475215" y="607868"/>
              <a:ext cx="926511" cy="1041568"/>
            </a:xfrm>
            <a:custGeom>
              <a:avLst/>
              <a:gdLst>
                <a:gd name="connsiteX0" fmla="*/ 1620 w 1080194"/>
                <a:gd name="connsiteY0" fmla="*/ 501489 h 1246921"/>
                <a:gd name="connsiteX1" fmla="*/ 213567 w 1080194"/>
                <a:gd name="connsiteY1" fmla="*/ 216874 h 1246921"/>
                <a:gd name="connsiteX2" fmla="*/ 328624 w 1080194"/>
                <a:gd name="connsiteY2" fmla="*/ 95762 h 1246921"/>
                <a:gd name="connsiteX3" fmla="*/ 401291 w 1080194"/>
                <a:gd name="connsiteY3" fmla="*/ 47316 h 1246921"/>
                <a:gd name="connsiteX4" fmla="*/ 510292 w 1080194"/>
                <a:gd name="connsiteY4" fmla="*/ 4927 h 1246921"/>
                <a:gd name="connsiteX5" fmla="*/ 601127 w 1080194"/>
                <a:gd name="connsiteY5" fmla="*/ 4927 h 1246921"/>
                <a:gd name="connsiteX6" fmla="*/ 710128 w 1080194"/>
                <a:gd name="connsiteY6" fmla="*/ 41261 h 1246921"/>
                <a:gd name="connsiteX7" fmla="*/ 867575 w 1080194"/>
                <a:gd name="connsiteY7" fmla="*/ 132095 h 1246921"/>
                <a:gd name="connsiteX8" fmla="*/ 994743 w 1080194"/>
                <a:gd name="connsiteY8" fmla="*/ 313764 h 1246921"/>
                <a:gd name="connsiteX9" fmla="*/ 1079522 w 1080194"/>
                <a:gd name="connsiteY9" fmla="*/ 628657 h 1246921"/>
                <a:gd name="connsiteX10" fmla="*/ 1031076 w 1080194"/>
                <a:gd name="connsiteY10" fmla="*/ 876938 h 1246921"/>
                <a:gd name="connsiteX11" fmla="*/ 970520 w 1080194"/>
                <a:gd name="connsiteY11" fmla="*/ 973828 h 1246921"/>
                <a:gd name="connsiteX12" fmla="*/ 867575 w 1080194"/>
                <a:gd name="connsiteY12" fmla="*/ 1088885 h 1246921"/>
                <a:gd name="connsiteX13" fmla="*/ 595071 w 1080194"/>
                <a:gd name="connsiteY13" fmla="*/ 1246331 h 1246921"/>
                <a:gd name="connsiteX14" fmla="*/ 516348 w 1080194"/>
                <a:gd name="connsiteY14" fmla="*/ 1028328 h 1246921"/>
                <a:gd name="connsiteX15" fmla="*/ 407347 w 1080194"/>
                <a:gd name="connsiteY15" fmla="*/ 864826 h 1246921"/>
                <a:gd name="connsiteX16" fmla="*/ 249900 w 1080194"/>
                <a:gd name="connsiteY16" fmla="*/ 707380 h 1246921"/>
                <a:gd name="connsiteX17" fmla="*/ 122732 w 1080194"/>
                <a:gd name="connsiteY17" fmla="*/ 592323 h 1246921"/>
                <a:gd name="connsiteX18" fmla="*/ 1620 w 1080194"/>
                <a:gd name="connsiteY18" fmla="*/ 501489 h 12469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080194" h="1246921">
                  <a:moveTo>
                    <a:pt x="1620" y="501489"/>
                  </a:moveTo>
                  <a:cubicBezTo>
                    <a:pt x="16759" y="438914"/>
                    <a:pt x="159066" y="284495"/>
                    <a:pt x="213567" y="216874"/>
                  </a:cubicBezTo>
                  <a:cubicBezTo>
                    <a:pt x="268068" y="149253"/>
                    <a:pt x="297337" y="124022"/>
                    <a:pt x="328624" y="95762"/>
                  </a:cubicBezTo>
                  <a:cubicBezTo>
                    <a:pt x="359911" y="67502"/>
                    <a:pt x="371013" y="62455"/>
                    <a:pt x="401291" y="47316"/>
                  </a:cubicBezTo>
                  <a:cubicBezTo>
                    <a:pt x="431569" y="32177"/>
                    <a:pt x="476986" y="11992"/>
                    <a:pt x="510292" y="4927"/>
                  </a:cubicBezTo>
                  <a:cubicBezTo>
                    <a:pt x="543598" y="-2138"/>
                    <a:pt x="567821" y="-1129"/>
                    <a:pt x="601127" y="4927"/>
                  </a:cubicBezTo>
                  <a:cubicBezTo>
                    <a:pt x="634433" y="10983"/>
                    <a:pt x="665720" y="20066"/>
                    <a:pt x="710128" y="41261"/>
                  </a:cubicBezTo>
                  <a:cubicBezTo>
                    <a:pt x="754536" y="62456"/>
                    <a:pt x="820139" y="86678"/>
                    <a:pt x="867575" y="132095"/>
                  </a:cubicBezTo>
                  <a:cubicBezTo>
                    <a:pt x="915011" y="177512"/>
                    <a:pt x="959419" y="231004"/>
                    <a:pt x="994743" y="313764"/>
                  </a:cubicBezTo>
                  <a:cubicBezTo>
                    <a:pt x="1030068" y="396524"/>
                    <a:pt x="1073467" y="534795"/>
                    <a:pt x="1079522" y="628657"/>
                  </a:cubicBezTo>
                  <a:cubicBezTo>
                    <a:pt x="1085577" y="722519"/>
                    <a:pt x="1049243" y="819410"/>
                    <a:pt x="1031076" y="876938"/>
                  </a:cubicBezTo>
                  <a:cubicBezTo>
                    <a:pt x="1012909" y="934466"/>
                    <a:pt x="997770" y="938504"/>
                    <a:pt x="970520" y="973828"/>
                  </a:cubicBezTo>
                  <a:cubicBezTo>
                    <a:pt x="943270" y="1009153"/>
                    <a:pt x="930150" y="1043468"/>
                    <a:pt x="867575" y="1088885"/>
                  </a:cubicBezTo>
                  <a:cubicBezTo>
                    <a:pt x="805000" y="1134302"/>
                    <a:pt x="653609" y="1256424"/>
                    <a:pt x="595071" y="1246331"/>
                  </a:cubicBezTo>
                  <a:cubicBezTo>
                    <a:pt x="536533" y="1236238"/>
                    <a:pt x="547635" y="1091912"/>
                    <a:pt x="516348" y="1028328"/>
                  </a:cubicBezTo>
                  <a:cubicBezTo>
                    <a:pt x="485061" y="964744"/>
                    <a:pt x="451755" y="918317"/>
                    <a:pt x="407347" y="864826"/>
                  </a:cubicBezTo>
                  <a:cubicBezTo>
                    <a:pt x="362939" y="811335"/>
                    <a:pt x="297336" y="752797"/>
                    <a:pt x="249900" y="707380"/>
                  </a:cubicBezTo>
                  <a:cubicBezTo>
                    <a:pt x="202464" y="661963"/>
                    <a:pt x="164112" y="624620"/>
                    <a:pt x="122732" y="592323"/>
                  </a:cubicBezTo>
                  <a:cubicBezTo>
                    <a:pt x="81352" y="560026"/>
                    <a:pt x="-13519" y="564064"/>
                    <a:pt x="1620" y="501489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5" name="フリーフォーム 374">
              <a:extLst>
                <a:ext uri="{FF2B5EF4-FFF2-40B4-BE49-F238E27FC236}">
                  <a16:creationId xmlns:a16="http://schemas.microsoft.com/office/drawing/2014/main" id="{4A78B02F-5B68-B0E8-2AD2-E3474718C305}"/>
                </a:ext>
              </a:extLst>
            </p:cNvPr>
            <p:cNvSpPr/>
            <p:nvPr/>
          </p:nvSpPr>
          <p:spPr>
            <a:xfrm>
              <a:off x="1156625" y="2027846"/>
              <a:ext cx="690342" cy="255236"/>
            </a:xfrm>
            <a:custGeom>
              <a:avLst/>
              <a:gdLst>
                <a:gd name="connsiteX0" fmla="*/ 0 w 690342"/>
                <a:gd name="connsiteY0" fmla="*/ 236959 h 255236"/>
                <a:gd name="connsiteX1" fmla="*/ 102946 w 690342"/>
                <a:gd name="connsiteY1" fmla="*/ 127958 h 255236"/>
                <a:gd name="connsiteX2" fmla="*/ 127168 w 690342"/>
                <a:gd name="connsiteY2" fmla="*/ 91624 h 255236"/>
                <a:gd name="connsiteX3" fmla="*/ 145335 w 690342"/>
                <a:gd name="connsiteY3" fmla="*/ 31068 h 255236"/>
                <a:gd name="connsiteX4" fmla="*/ 145335 w 690342"/>
                <a:gd name="connsiteY4" fmla="*/ 790 h 255236"/>
                <a:gd name="connsiteX5" fmla="*/ 181669 w 690342"/>
                <a:gd name="connsiteY5" fmla="*/ 61346 h 255236"/>
                <a:gd name="connsiteX6" fmla="*/ 218003 w 690342"/>
                <a:gd name="connsiteY6" fmla="*/ 127958 h 255236"/>
                <a:gd name="connsiteX7" fmla="*/ 327004 w 690342"/>
                <a:gd name="connsiteY7" fmla="*/ 212737 h 255236"/>
                <a:gd name="connsiteX8" fmla="*/ 423894 w 690342"/>
                <a:gd name="connsiteY8" fmla="*/ 243015 h 255236"/>
                <a:gd name="connsiteX9" fmla="*/ 502617 w 690342"/>
                <a:gd name="connsiteY9" fmla="*/ 255126 h 255236"/>
                <a:gd name="connsiteX10" fmla="*/ 611619 w 690342"/>
                <a:gd name="connsiteY10" fmla="*/ 236959 h 255236"/>
                <a:gd name="connsiteX11" fmla="*/ 690342 w 690342"/>
                <a:gd name="connsiteY11" fmla="*/ 206681 h 255236"/>
                <a:gd name="connsiteX12" fmla="*/ 690342 w 690342"/>
                <a:gd name="connsiteY12" fmla="*/ 206681 h 2552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690342" h="255236">
                  <a:moveTo>
                    <a:pt x="0" y="236959"/>
                  </a:moveTo>
                  <a:cubicBezTo>
                    <a:pt x="40875" y="194569"/>
                    <a:pt x="81751" y="152180"/>
                    <a:pt x="102946" y="127958"/>
                  </a:cubicBezTo>
                  <a:cubicBezTo>
                    <a:pt x="124141" y="103735"/>
                    <a:pt x="120103" y="107772"/>
                    <a:pt x="127168" y="91624"/>
                  </a:cubicBezTo>
                  <a:cubicBezTo>
                    <a:pt x="134233" y="75476"/>
                    <a:pt x="142307" y="46207"/>
                    <a:pt x="145335" y="31068"/>
                  </a:cubicBezTo>
                  <a:cubicBezTo>
                    <a:pt x="148363" y="15929"/>
                    <a:pt x="139279" y="-4256"/>
                    <a:pt x="145335" y="790"/>
                  </a:cubicBezTo>
                  <a:cubicBezTo>
                    <a:pt x="151391" y="5836"/>
                    <a:pt x="169558" y="40151"/>
                    <a:pt x="181669" y="61346"/>
                  </a:cubicBezTo>
                  <a:cubicBezTo>
                    <a:pt x="193780" y="82541"/>
                    <a:pt x="193781" y="102726"/>
                    <a:pt x="218003" y="127958"/>
                  </a:cubicBezTo>
                  <a:cubicBezTo>
                    <a:pt x="242225" y="153190"/>
                    <a:pt x="292689" y="193561"/>
                    <a:pt x="327004" y="212737"/>
                  </a:cubicBezTo>
                  <a:cubicBezTo>
                    <a:pt x="361319" y="231913"/>
                    <a:pt x="394625" y="235950"/>
                    <a:pt x="423894" y="243015"/>
                  </a:cubicBezTo>
                  <a:cubicBezTo>
                    <a:pt x="453163" y="250080"/>
                    <a:pt x="471330" y="256135"/>
                    <a:pt x="502617" y="255126"/>
                  </a:cubicBezTo>
                  <a:cubicBezTo>
                    <a:pt x="533904" y="254117"/>
                    <a:pt x="580332" y="245033"/>
                    <a:pt x="611619" y="236959"/>
                  </a:cubicBezTo>
                  <a:cubicBezTo>
                    <a:pt x="642906" y="228885"/>
                    <a:pt x="690342" y="206681"/>
                    <a:pt x="690342" y="206681"/>
                  </a:cubicBezTo>
                  <a:lnTo>
                    <a:pt x="690342" y="206681"/>
                  </a:lnTo>
                </a:path>
              </a:pathLst>
            </a:custGeom>
            <a:noFill/>
            <a:ln w="127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6" name="フリーフォーム 375">
              <a:extLst>
                <a:ext uri="{FF2B5EF4-FFF2-40B4-BE49-F238E27FC236}">
                  <a16:creationId xmlns:a16="http://schemas.microsoft.com/office/drawing/2014/main" id="{14510371-59E0-AC2D-0021-51E591679769}"/>
                </a:ext>
              </a:extLst>
            </p:cNvPr>
            <p:cNvSpPr/>
            <p:nvPr/>
          </p:nvSpPr>
          <p:spPr>
            <a:xfrm>
              <a:off x="1671354" y="2313106"/>
              <a:ext cx="496561" cy="163646"/>
            </a:xfrm>
            <a:custGeom>
              <a:avLst/>
              <a:gdLst>
                <a:gd name="connsiteX0" fmla="*/ 0 w 496561"/>
                <a:gd name="connsiteY0" fmla="*/ 157591 h 163646"/>
                <a:gd name="connsiteX1" fmla="*/ 139279 w 496561"/>
                <a:gd name="connsiteY1" fmla="*/ 109146 h 163646"/>
                <a:gd name="connsiteX2" fmla="*/ 205891 w 496561"/>
                <a:gd name="connsiteY2" fmla="*/ 60701 h 163646"/>
                <a:gd name="connsiteX3" fmla="*/ 242225 w 496561"/>
                <a:gd name="connsiteY3" fmla="*/ 144 h 163646"/>
                <a:gd name="connsiteX4" fmla="*/ 272503 w 496561"/>
                <a:gd name="connsiteY4" fmla="*/ 78868 h 163646"/>
                <a:gd name="connsiteX5" fmla="*/ 399671 w 496561"/>
                <a:gd name="connsiteY5" fmla="*/ 139424 h 163646"/>
                <a:gd name="connsiteX6" fmla="*/ 496561 w 496561"/>
                <a:gd name="connsiteY6" fmla="*/ 163646 h 163646"/>
                <a:gd name="connsiteX7" fmla="*/ 496561 w 496561"/>
                <a:gd name="connsiteY7" fmla="*/ 163646 h 1636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96561" h="163646">
                  <a:moveTo>
                    <a:pt x="0" y="157591"/>
                  </a:moveTo>
                  <a:cubicBezTo>
                    <a:pt x="52482" y="141442"/>
                    <a:pt x="104964" y="125294"/>
                    <a:pt x="139279" y="109146"/>
                  </a:cubicBezTo>
                  <a:cubicBezTo>
                    <a:pt x="173594" y="92998"/>
                    <a:pt x="188733" y="78868"/>
                    <a:pt x="205891" y="60701"/>
                  </a:cubicBezTo>
                  <a:cubicBezTo>
                    <a:pt x="223049" y="42534"/>
                    <a:pt x="231123" y="-2884"/>
                    <a:pt x="242225" y="144"/>
                  </a:cubicBezTo>
                  <a:cubicBezTo>
                    <a:pt x="253327" y="3172"/>
                    <a:pt x="246262" y="55655"/>
                    <a:pt x="272503" y="78868"/>
                  </a:cubicBezTo>
                  <a:cubicBezTo>
                    <a:pt x="298744" y="102081"/>
                    <a:pt x="362328" y="125294"/>
                    <a:pt x="399671" y="139424"/>
                  </a:cubicBezTo>
                  <a:cubicBezTo>
                    <a:pt x="437014" y="153554"/>
                    <a:pt x="496561" y="163646"/>
                    <a:pt x="496561" y="163646"/>
                  </a:cubicBezTo>
                  <a:lnTo>
                    <a:pt x="496561" y="163646"/>
                  </a:lnTo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7" name="フリーフォーム 376">
              <a:extLst>
                <a:ext uri="{FF2B5EF4-FFF2-40B4-BE49-F238E27FC236}">
                  <a16:creationId xmlns:a16="http://schemas.microsoft.com/office/drawing/2014/main" id="{86CE9B82-74D6-EACB-44C0-344724384BC3}"/>
                </a:ext>
              </a:extLst>
            </p:cNvPr>
            <p:cNvSpPr/>
            <p:nvPr/>
          </p:nvSpPr>
          <p:spPr>
            <a:xfrm>
              <a:off x="1229293" y="1768244"/>
              <a:ext cx="62203" cy="151390"/>
            </a:xfrm>
            <a:custGeom>
              <a:avLst/>
              <a:gdLst>
                <a:gd name="connsiteX0" fmla="*/ 0 w 62203"/>
                <a:gd name="connsiteY0" fmla="*/ 0 h 151390"/>
                <a:gd name="connsiteX1" fmla="*/ 54500 w 62203"/>
                <a:gd name="connsiteY1" fmla="*/ 121112 h 151390"/>
                <a:gd name="connsiteX2" fmla="*/ 60556 w 62203"/>
                <a:gd name="connsiteY2" fmla="*/ 151390 h 1513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2203" h="151390">
                  <a:moveTo>
                    <a:pt x="0" y="0"/>
                  </a:moveTo>
                  <a:cubicBezTo>
                    <a:pt x="22203" y="47940"/>
                    <a:pt x="44407" y="95880"/>
                    <a:pt x="54500" y="121112"/>
                  </a:cubicBezTo>
                  <a:cubicBezTo>
                    <a:pt x="64593" y="146344"/>
                    <a:pt x="62574" y="148867"/>
                    <a:pt x="60556" y="151390"/>
                  </a:cubicBezTo>
                </a:path>
              </a:pathLst>
            </a:cu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8" name="フリーフォーム 377">
              <a:extLst>
                <a:ext uri="{FF2B5EF4-FFF2-40B4-BE49-F238E27FC236}">
                  <a16:creationId xmlns:a16="http://schemas.microsoft.com/office/drawing/2014/main" id="{8163C731-8B7D-ED24-327C-05A07465C845}"/>
                </a:ext>
              </a:extLst>
            </p:cNvPr>
            <p:cNvSpPr/>
            <p:nvPr/>
          </p:nvSpPr>
          <p:spPr>
            <a:xfrm>
              <a:off x="1294526" y="1789681"/>
              <a:ext cx="147977" cy="245010"/>
            </a:xfrm>
            <a:custGeom>
              <a:avLst/>
              <a:gdLst>
                <a:gd name="connsiteX0" fmla="*/ 1379 w 147977"/>
                <a:gd name="connsiteY0" fmla="*/ 245010 h 245010"/>
                <a:gd name="connsiteX1" fmla="*/ 6171 w 147977"/>
                <a:gd name="connsiteY1" fmla="*/ 136916 h 245010"/>
                <a:gd name="connsiteX2" fmla="*/ 50180 w 147977"/>
                <a:gd name="connsiteY2" fmla="*/ 88017 h 245010"/>
                <a:gd name="connsiteX3" fmla="*/ 84409 w 147977"/>
                <a:gd name="connsiteY3" fmla="*/ 58678 h 245010"/>
                <a:gd name="connsiteX4" fmla="*/ 128417 w 147977"/>
                <a:gd name="connsiteY4" fmla="*/ 9780 h 245010"/>
                <a:gd name="connsiteX5" fmla="*/ 147977 w 147977"/>
                <a:gd name="connsiteY5" fmla="*/ 0 h 2450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47977" h="245010">
                  <a:moveTo>
                    <a:pt x="1379" y="245010"/>
                  </a:moveTo>
                  <a:cubicBezTo>
                    <a:pt x="-292" y="204045"/>
                    <a:pt x="-1962" y="163081"/>
                    <a:pt x="6171" y="136916"/>
                  </a:cubicBezTo>
                  <a:cubicBezTo>
                    <a:pt x="14304" y="110751"/>
                    <a:pt x="37140" y="101057"/>
                    <a:pt x="50180" y="88017"/>
                  </a:cubicBezTo>
                  <a:cubicBezTo>
                    <a:pt x="63220" y="74977"/>
                    <a:pt x="71370" y="71717"/>
                    <a:pt x="84409" y="58678"/>
                  </a:cubicBezTo>
                  <a:cubicBezTo>
                    <a:pt x="97448" y="45639"/>
                    <a:pt x="128417" y="9780"/>
                    <a:pt x="128417" y="9780"/>
                  </a:cubicBezTo>
                  <a:cubicBezTo>
                    <a:pt x="139012" y="0"/>
                    <a:pt x="143494" y="0"/>
                    <a:pt x="147977" y="0"/>
                  </a:cubicBezTo>
                </a:path>
              </a:pathLst>
            </a:cu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9" name="円/楕円 378">
              <a:extLst>
                <a:ext uri="{FF2B5EF4-FFF2-40B4-BE49-F238E27FC236}">
                  <a16:creationId xmlns:a16="http://schemas.microsoft.com/office/drawing/2014/main" id="{7868DCF1-928C-5073-C44F-DC09C15ACB5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60661" y="1502745"/>
              <a:ext cx="200273" cy="18690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0" name="円/楕円 379">
              <a:extLst>
                <a:ext uri="{FF2B5EF4-FFF2-40B4-BE49-F238E27FC236}">
                  <a16:creationId xmlns:a16="http://schemas.microsoft.com/office/drawing/2014/main" id="{D649A2EC-5B10-68C2-7A36-96A90A0A60D1}"/>
                </a:ext>
              </a:extLst>
            </p:cNvPr>
            <p:cNvSpPr/>
            <p:nvPr/>
          </p:nvSpPr>
          <p:spPr>
            <a:xfrm rot="19705737">
              <a:off x="1190730" y="3127937"/>
              <a:ext cx="565434" cy="364714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1" name="円/楕円 380">
              <a:extLst>
                <a:ext uri="{FF2B5EF4-FFF2-40B4-BE49-F238E27FC236}">
                  <a16:creationId xmlns:a16="http://schemas.microsoft.com/office/drawing/2014/main" id="{0A0CD932-D68C-0800-B181-E41AEB2FDEC4}"/>
                </a:ext>
              </a:extLst>
            </p:cNvPr>
            <p:cNvSpPr/>
            <p:nvPr/>
          </p:nvSpPr>
          <p:spPr>
            <a:xfrm rot="19890971">
              <a:off x="1589468" y="2968150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2" name="円/楕円 381">
              <a:extLst>
                <a:ext uri="{FF2B5EF4-FFF2-40B4-BE49-F238E27FC236}">
                  <a16:creationId xmlns:a16="http://schemas.microsoft.com/office/drawing/2014/main" id="{11CDB58B-6BAA-DC2B-E5F2-4F4463FE6067}"/>
                </a:ext>
              </a:extLst>
            </p:cNvPr>
            <p:cNvSpPr/>
            <p:nvPr/>
          </p:nvSpPr>
          <p:spPr>
            <a:xfrm rot="18849464">
              <a:off x="1877979" y="3956227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3" name="円/楕円 382">
              <a:extLst>
                <a:ext uri="{FF2B5EF4-FFF2-40B4-BE49-F238E27FC236}">
                  <a16:creationId xmlns:a16="http://schemas.microsoft.com/office/drawing/2014/main" id="{444D23A0-68E8-7040-2F0B-98F341763FD1}"/>
                </a:ext>
              </a:extLst>
            </p:cNvPr>
            <p:cNvSpPr/>
            <p:nvPr/>
          </p:nvSpPr>
          <p:spPr>
            <a:xfrm rot="17969593">
              <a:off x="3366125" y="4609434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84" name="グループ化 383">
              <a:extLst>
                <a:ext uri="{FF2B5EF4-FFF2-40B4-BE49-F238E27FC236}">
                  <a16:creationId xmlns:a16="http://schemas.microsoft.com/office/drawing/2014/main" id="{60030B1E-BEB9-F92F-3443-56F29A0A1896}"/>
                </a:ext>
              </a:extLst>
            </p:cNvPr>
            <p:cNvGrpSpPr/>
            <p:nvPr/>
          </p:nvGrpSpPr>
          <p:grpSpPr>
            <a:xfrm>
              <a:off x="1382585" y="1527432"/>
              <a:ext cx="3296564" cy="3321734"/>
              <a:chOff x="1457649" y="1827683"/>
              <a:chExt cx="3296564" cy="3321734"/>
            </a:xfrm>
            <a:solidFill>
              <a:schemeClr val="bg2">
                <a:lumMod val="90000"/>
              </a:schemeClr>
            </a:solidFill>
          </p:grpSpPr>
          <p:sp>
            <p:nvSpPr>
              <p:cNvPr id="388" name="フリーフォーム 387">
                <a:extLst>
                  <a:ext uri="{FF2B5EF4-FFF2-40B4-BE49-F238E27FC236}">
                    <a16:creationId xmlns:a16="http://schemas.microsoft.com/office/drawing/2014/main" id="{369AC3A9-862D-73CE-41E1-A828719AA749}"/>
                  </a:ext>
                </a:extLst>
              </p:cNvPr>
              <p:cNvSpPr/>
              <p:nvPr/>
            </p:nvSpPr>
            <p:spPr>
              <a:xfrm>
                <a:off x="1457649" y="1827683"/>
                <a:ext cx="3296564" cy="3321734"/>
              </a:xfrm>
              <a:custGeom>
                <a:avLst/>
                <a:gdLst>
                  <a:gd name="connsiteX0" fmla="*/ 1924419 w 3296564"/>
                  <a:gd name="connsiteY0" fmla="*/ 6566 h 3321734"/>
                  <a:gd name="connsiteX1" fmla="*/ 2156431 w 3296564"/>
                  <a:gd name="connsiteY1" fmla="*/ 6566 h 3321734"/>
                  <a:gd name="connsiteX2" fmla="*/ 2395267 w 3296564"/>
                  <a:gd name="connsiteY2" fmla="*/ 74805 h 3321734"/>
                  <a:gd name="connsiteX3" fmla="*/ 2599983 w 3296564"/>
                  <a:gd name="connsiteY3" fmla="*/ 156692 h 3321734"/>
                  <a:gd name="connsiteX4" fmla="*/ 2743285 w 3296564"/>
                  <a:gd name="connsiteY4" fmla="*/ 327289 h 3321734"/>
                  <a:gd name="connsiteX5" fmla="*/ 2893410 w 3296564"/>
                  <a:gd name="connsiteY5" fmla="*/ 525181 h 3321734"/>
                  <a:gd name="connsiteX6" fmla="*/ 3016240 w 3296564"/>
                  <a:gd name="connsiteY6" fmla="*/ 777665 h 3321734"/>
                  <a:gd name="connsiteX7" fmla="*/ 3125422 w 3296564"/>
                  <a:gd name="connsiteY7" fmla="*/ 1071092 h 3321734"/>
                  <a:gd name="connsiteX8" fmla="*/ 3234604 w 3296564"/>
                  <a:gd name="connsiteY8" fmla="*/ 1453229 h 3321734"/>
                  <a:gd name="connsiteX9" fmla="*/ 3296019 w 3296564"/>
                  <a:gd name="connsiteY9" fmla="*/ 1944548 h 3321734"/>
                  <a:gd name="connsiteX10" fmla="*/ 3261900 w 3296564"/>
                  <a:gd name="connsiteY10" fmla="*/ 2319862 h 3321734"/>
                  <a:gd name="connsiteX11" fmla="*/ 3214132 w 3296564"/>
                  <a:gd name="connsiteY11" fmla="*/ 2592817 h 3321734"/>
                  <a:gd name="connsiteX12" fmla="*/ 3084479 w 3296564"/>
                  <a:gd name="connsiteY12" fmla="*/ 2906715 h 3321734"/>
                  <a:gd name="connsiteX13" fmla="*/ 2988944 w 3296564"/>
                  <a:gd name="connsiteY13" fmla="*/ 3111432 h 3321734"/>
                  <a:gd name="connsiteX14" fmla="*/ 2825171 w 3296564"/>
                  <a:gd name="connsiteY14" fmla="*/ 3282029 h 3321734"/>
                  <a:gd name="connsiteX15" fmla="*/ 2688694 w 3296564"/>
                  <a:gd name="connsiteY15" fmla="*/ 3309324 h 3321734"/>
                  <a:gd name="connsiteX16" fmla="*/ 2729637 w 3296564"/>
                  <a:gd name="connsiteY16" fmla="*/ 3118256 h 3321734"/>
                  <a:gd name="connsiteX17" fmla="*/ 2640926 w 3296564"/>
                  <a:gd name="connsiteY17" fmla="*/ 3043193 h 3321734"/>
                  <a:gd name="connsiteX18" fmla="*/ 2415738 w 3296564"/>
                  <a:gd name="connsiteY18" fmla="*/ 2995426 h 3321734"/>
                  <a:gd name="connsiteX19" fmla="*/ 2279261 w 3296564"/>
                  <a:gd name="connsiteY19" fmla="*/ 3125080 h 3321734"/>
                  <a:gd name="connsiteX20" fmla="*/ 2231494 w 3296564"/>
                  <a:gd name="connsiteY20" fmla="*/ 3213790 h 3321734"/>
                  <a:gd name="connsiteX21" fmla="*/ 2183726 w 3296564"/>
                  <a:gd name="connsiteY21" fmla="*/ 3282029 h 3321734"/>
                  <a:gd name="connsiteX22" fmla="*/ 1999482 w 3296564"/>
                  <a:gd name="connsiteY22" fmla="*/ 3302500 h 3321734"/>
                  <a:gd name="connsiteX23" fmla="*/ 1630992 w 3296564"/>
                  <a:gd name="connsiteY23" fmla="*/ 3247909 h 3321734"/>
                  <a:gd name="connsiteX24" fmla="*/ 1405804 w 3296564"/>
                  <a:gd name="connsiteY24" fmla="*/ 3166023 h 3321734"/>
                  <a:gd name="connsiteX25" fmla="*/ 1180616 w 3296564"/>
                  <a:gd name="connsiteY25" fmla="*/ 3043193 h 3321734"/>
                  <a:gd name="connsiteX26" fmla="*/ 1064610 w 3296564"/>
                  <a:gd name="connsiteY26" fmla="*/ 2749766 h 3321734"/>
                  <a:gd name="connsiteX27" fmla="*/ 996371 w 3296564"/>
                  <a:gd name="connsiteY27" fmla="*/ 2613289 h 3321734"/>
                  <a:gd name="connsiteX28" fmla="*/ 784831 w 3296564"/>
                  <a:gd name="connsiteY28" fmla="*/ 2476811 h 3321734"/>
                  <a:gd name="connsiteX29" fmla="*/ 798479 w 3296564"/>
                  <a:gd name="connsiteY29" fmla="*/ 2367629 h 3321734"/>
                  <a:gd name="connsiteX30" fmla="*/ 839422 w 3296564"/>
                  <a:gd name="connsiteY30" fmla="*/ 2183384 h 3321734"/>
                  <a:gd name="connsiteX31" fmla="*/ 853070 w 3296564"/>
                  <a:gd name="connsiteY31" fmla="*/ 1917253 h 3321734"/>
                  <a:gd name="connsiteX32" fmla="*/ 955428 w 3296564"/>
                  <a:gd name="connsiteY32" fmla="*/ 1801247 h 3321734"/>
                  <a:gd name="connsiteX33" fmla="*/ 996371 w 3296564"/>
                  <a:gd name="connsiteY33" fmla="*/ 1671593 h 3321734"/>
                  <a:gd name="connsiteX34" fmla="*/ 955428 w 3296564"/>
                  <a:gd name="connsiteY34" fmla="*/ 1596530 h 3321734"/>
                  <a:gd name="connsiteX35" fmla="*/ 880365 w 3296564"/>
                  <a:gd name="connsiteY35" fmla="*/ 1473700 h 3321734"/>
                  <a:gd name="connsiteX36" fmla="*/ 764359 w 3296564"/>
                  <a:gd name="connsiteY36" fmla="*/ 1494172 h 3321734"/>
                  <a:gd name="connsiteX37" fmla="*/ 675649 w 3296564"/>
                  <a:gd name="connsiteY37" fmla="*/ 1521468 h 3321734"/>
                  <a:gd name="connsiteX38" fmla="*/ 491404 w 3296564"/>
                  <a:gd name="connsiteY38" fmla="*/ 1541939 h 3321734"/>
                  <a:gd name="connsiteX39" fmla="*/ 375398 w 3296564"/>
                  <a:gd name="connsiteY39" fmla="*/ 1589706 h 3321734"/>
                  <a:gd name="connsiteX40" fmla="*/ 266216 w 3296564"/>
                  <a:gd name="connsiteY40" fmla="*/ 1698889 h 3321734"/>
                  <a:gd name="connsiteX41" fmla="*/ 266216 w 3296564"/>
                  <a:gd name="connsiteY41" fmla="*/ 1698889 h 3321734"/>
                  <a:gd name="connsiteX42" fmla="*/ 204801 w 3296564"/>
                  <a:gd name="connsiteY42" fmla="*/ 1678417 h 3321734"/>
                  <a:gd name="connsiteX43" fmla="*/ 109267 w 3296564"/>
                  <a:gd name="connsiteY43" fmla="*/ 1644297 h 3321734"/>
                  <a:gd name="connsiteX44" fmla="*/ 27380 w 3296564"/>
                  <a:gd name="connsiteY44" fmla="*/ 1623826 h 3321734"/>
                  <a:gd name="connsiteX45" fmla="*/ 85 w 3296564"/>
                  <a:gd name="connsiteY45" fmla="*/ 1623826 h 3321734"/>
                  <a:gd name="connsiteX46" fmla="*/ 34204 w 3296564"/>
                  <a:gd name="connsiteY46" fmla="*/ 1500996 h 3321734"/>
                  <a:gd name="connsiteX47" fmla="*/ 88795 w 3296564"/>
                  <a:gd name="connsiteY47" fmla="*/ 1357694 h 3321734"/>
                  <a:gd name="connsiteX48" fmla="*/ 136562 w 3296564"/>
                  <a:gd name="connsiteY48" fmla="*/ 1262160 h 3321734"/>
                  <a:gd name="connsiteX49" fmla="*/ 143386 w 3296564"/>
                  <a:gd name="connsiteY49" fmla="*/ 1166626 h 3321734"/>
                  <a:gd name="connsiteX50" fmla="*/ 143386 w 3296564"/>
                  <a:gd name="connsiteY50" fmla="*/ 1098387 h 3321734"/>
                  <a:gd name="connsiteX51" fmla="*/ 116091 w 3296564"/>
                  <a:gd name="connsiteY51" fmla="*/ 989205 h 33217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</a:cxnLst>
                <a:rect l="l" t="t" r="r" b="b"/>
                <a:pathLst>
                  <a:path w="3296564" h="3321734">
                    <a:moveTo>
                      <a:pt x="1924419" y="6566"/>
                    </a:moveTo>
                    <a:cubicBezTo>
                      <a:pt x="2001187" y="879"/>
                      <a:pt x="2077956" y="-4807"/>
                      <a:pt x="2156431" y="6566"/>
                    </a:cubicBezTo>
                    <a:cubicBezTo>
                      <a:pt x="2234906" y="17939"/>
                      <a:pt x="2321342" y="49784"/>
                      <a:pt x="2395267" y="74805"/>
                    </a:cubicBezTo>
                    <a:cubicBezTo>
                      <a:pt x="2469192" y="99826"/>
                      <a:pt x="2541980" y="114611"/>
                      <a:pt x="2599983" y="156692"/>
                    </a:cubicBezTo>
                    <a:cubicBezTo>
                      <a:pt x="2657986" y="198773"/>
                      <a:pt x="2694381" y="265874"/>
                      <a:pt x="2743285" y="327289"/>
                    </a:cubicBezTo>
                    <a:cubicBezTo>
                      <a:pt x="2792189" y="388704"/>
                      <a:pt x="2847918" y="450118"/>
                      <a:pt x="2893410" y="525181"/>
                    </a:cubicBezTo>
                    <a:cubicBezTo>
                      <a:pt x="2938903" y="600244"/>
                      <a:pt x="2977571" y="686680"/>
                      <a:pt x="3016240" y="777665"/>
                    </a:cubicBezTo>
                    <a:cubicBezTo>
                      <a:pt x="3054909" y="868650"/>
                      <a:pt x="3089028" y="958498"/>
                      <a:pt x="3125422" y="1071092"/>
                    </a:cubicBezTo>
                    <a:cubicBezTo>
                      <a:pt x="3161816" y="1183686"/>
                      <a:pt x="3206171" y="1307653"/>
                      <a:pt x="3234604" y="1453229"/>
                    </a:cubicBezTo>
                    <a:cubicBezTo>
                      <a:pt x="3263037" y="1598805"/>
                      <a:pt x="3291470" y="1800109"/>
                      <a:pt x="3296019" y="1944548"/>
                    </a:cubicBezTo>
                    <a:cubicBezTo>
                      <a:pt x="3300568" y="2088987"/>
                      <a:pt x="3275548" y="2211817"/>
                      <a:pt x="3261900" y="2319862"/>
                    </a:cubicBezTo>
                    <a:cubicBezTo>
                      <a:pt x="3248252" y="2427907"/>
                      <a:pt x="3243702" y="2495008"/>
                      <a:pt x="3214132" y="2592817"/>
                    </a:cubicBezTo>
                    <a:cubicBezTo>
                      <a:pt x="3184562" y="2690626"/>
                      <a:pt x="3122010" y="2820279"/>
                      <a:pt x="3084479" y="2906715"/>
                    </a:cubicBezTo>
                    <a:cubicBezTo>
                      <a:pt x="3046948" y="2993151"/>
                      <a:pt x="3032162" y="3048880"/>
                      <a:pt x="2988944" y="3111432"/>
                    </a:cubicBezTo>
                    <a:cubicBezTo>
                      <a:pt x="2945726" y="3173984"/>
                      <a:pt x="2875213" y="3249047"/>
                      <a:pt x="2825171" y="3282029"/>
                    </a:cubicBezTo>
                    <a:cubicBezTo>
                      <a:pt x="2775129" y="3315011"/>
                      <a:pt x="2704616" y="3336619"/>
                      <a:pt x="2688694" y="3309324"/>
                    </a:cubicBezTo>
                    <a:cubicBezTo>
                      <a:pt x="2672772" y="3282029"/>
                      <a:pt x="2737598" y="3162611"/>
                      <a:pt x="2729637" y="3118256"/>
                    </a:cubicBezTo>
                    <a:cubicBezTo>
                      <a:pt x="2721676" y="3073901"/>
                      <a:pt x="2693242" y="3063665"/>
                      <a:pt x="2640926" y="3043193"/>
                    </a:cubicBezTo>
                    <a:cubicBezTo>
                      <a:pt x="2588610" y="3022721"/>
                      <a:pt x="2476016" y="2981778"/>
                      <a:pt x="2415738" y="2995426"/>
                    </a:cubicBezTo>
                    <a:cubicBezTo>
                      <a:pt x="2355461" y="3009074"/>
                      <a:pt x="2309968" y="3088686"/>
                      <a:pt x="2279261" y="3125080"/>
                    </a:cubicBezTo>
                    <a:cubicBezTo>
                      <a:pt x="2248554" y="3161474"/>
                      <a:pt x="2247416" y="3187632"/>
                      <a:pt x="2231494" y="3213790"/>
                    </a:cubicBezTo>
                    <a:cubicBezTo>
                      <a:pt x="2215572" y="3239948"/>
                      <a:pt x="2222395" y="3267244"/>
                      <a:pt x="2183726" y="3282029"/>
                    </a:cubicBezTo>
                    <a:cubicBezTo>
                      <a:pt x="2145057" y="3296814"/>
                      <a:pt x="2091604" y="3308187"/>
                      <a:pt x="1999482" y="3302500"/>
                    </a:cubicBezTo>
                    <a:cubicBezTo>
                      <a:pt x="1907360" y="3296813"/>
                      <a:pt x="1729938" y="3270655"/>
                      <a:pt x="1630992" y="3247909"/>
                    </a:cubicBezTo>
                    <a:cubicBezTo>
                      <a:pt x="1532046" y="3225163"/>
                      <a:pt x="1480867" y="3200142"/>
                      <a:pt x="1405804" y="3166023"/>
                    </a:cubicBezTo>
                    <a:cubicBezTo>
                      <a:pt x="1330741" y="3131904"/>
                      <a:pt x="1237482" y="3112569"/>
                      <a:pt x="1180616" y="3043193"/>
                    </a:cubicBezTo>
                    <a:cubicBezTo>
                      <a:pt x="1123750" y="2973817"/>
                      <a:pt x="1095317" y="2821417"/>
                      <a:pt x="1064610" y="2749766"/>
                    </a:cubicBezTo>
                    <a:cubicBezTo>
                      <a:pt x="1033903" y="2678115"/>
                      <a:pt x="1043001" y="2658781"/>
                      <a:pt x="996371" y="2613289"/>
                    </a:cubicBezTo>
                    <a:cubicBezTo>
                      <a:pt x="949741" y="2567797"/>
                      <a:pt x="817813" y="2517754"/>
                      <a:pt x="784831" y="2476811"/>
                    </a:cubicBezTo>
                    <a:cubicBezTo>
                      <a:pt x="751849" y="2435868"/>
                      <a:pt x="789380" y="2416534"/>
                      <a:pt x="798479" y="2367629"/>
                    </a:cubicBezTo>
                    <a:cubicBezTo>
                      <a:pt x="807578" y="2318724"/>
                      <a:pt x="830323" y="2258447"/>
                      <a:pt x="839422" y="2183384"/>
                    </a:cubicBezTo>
                    <a:cubicBezTo>
                      <a:pt x="848520" y="2108321"/>
                      <a:pt x="833736" y="1980943"/>
                      <a:pt x="853070" y="1917253"/>
                    </a:cubicBezTo>
                    <a:cubicBezTo>
                      <a:pt x="872404" y="1853564"/>
                      <a:pt x="931544" y="1842190"/>
                      <a:pt x="955428" y="1801247"/>
                    </a:cubicBezTo>
                    <a:cubicBezTo>
                      <a:pt x="979311" y="1760304"/>
                      <a:pt x="996371" y="1705712"/>
                      <a:pt x="996371" y="1671593"/>
                    </a:cubicBezTo>
                    <a:cubicBezTo>
                      <a:pt x="996371" y="1637474"/>
                      <a:pt x="974762" y="1629512"/>
                      <a:pt x="955428" y="1596530"/>
                    </a:cubicBezTo>
                    <a:cubicBezTo>
                      <a:pt x="936094" y="1563548"/>
                      <a:pt x="912210" y="1490760"/>
                      <a:pt x="880365" y="1473700"/>
                    </a:cubicBezTo>
                    <a:cubicBezTo>
                      <a:pt x="848520" y="1456640"/>
                      <a:pt x="798478" y="1486211"/>
                      <a:pt x="764359" y="1494172"/>
                    </a:cubicBezTo>
                    <a:cubicBezTo>
                      <a:pt x="730240" y="1502133"/>
                      <a:pt x="721141" y="1513507"/>
                      <a:pt x="675649" y="1521468"/>
                    </a:cubicBezTo>
                    <a:cubicBezTo>
                      <a:pt x="630157" y="1529429"/>
                      <a:pt x="541446" y="1530566"/>
                      <a:pt x="491404" y="1541939"/>
                    </a:cubicBezTo>
                    <a:cubicBezTo>
                      <a:pt x="441362" y="1553312"/>
                      <a:pt x="412929" y="1563548"/>
                      <a:pt x="375398" y="1589706"/>
                    </a:cubicBezTo>
                    <a:cubicBezTo>
                      <a:pt x="337867" y="1615864"/>
                      <a:pt x="266216" y="1698889"/>
                      <a:pt x="266216" y="1698889"/>
                    </a:cubicBezTo>
                    <a:lnTo>
                      <a:pt x="266216" y="1698889"/>
                    </a:lnTo>
                    <a:lnTo>
                      <a:pt x="204801" y="1678417"/>
                    </a:lnTo>
                    <a:cubicBezTo>
                      <a:pt x="178643" y="1669318"/>
                      <a:pt x="138837" y="1653395"/>
                      <a:pt x="109267" y="1644297"/>
                    </a:cubicBezTo>
                    <a:cubicBezTo>
                      <a:pt x="79697" y="1635199"/>
                      <a:pt x="27380" y="1623826"/>
                      <a:pt x="27380" y="1623826"/>
                    </a:cubicBezTo>
                    <a:cubicBezTo>
                      <a:pt x="9183" y="1620414"/>
                      <a:pt x="-1052" y="1644298"/>
                      <a:pt x="85" y="1623826"/>
                    </a:cubicBezTo>
                    <a:cubicBezTo>
                      <a:pt x="1222" y="1603354"/>
                      <a:pt x="19419" y="1545351"/>
                      <a:pt x="34204" y="1500996"/>
                    </a:cubicBezTo>
                    <a:cubicBezTo>
                      <a:pt x="48989" y="1456641"/>
                      <a:pt x="71735" y="1397500"/>
                      <a:pt x="88795" y="1357694"/>
                    </a:cubicBezTo>
                    <a:cubicBezTo>
                      <a:pt x="105855" y="1317888"/>
                      <a:pt x="127463" y="1294005"/>
                      <a:pt x="136562" y="1262160"/>
                    </a:cubicBezTo>
                    <a:cubicBezTo>
                      <a:pt x="145661" y="1230315"/>
                      <a:pt x="142249" y="1193921"/>
                      <a:pt x="143386" y="1166626"/>
                    </a:cubicBezTo>
                    <a:cubicBezTo>
                      <a:pt x="144523" y="1139331"/>
                      <a:pt x="147935" y="1127957"/>
                      <a:pt x="143386" y="1098387"/>
                    </a:cubicBezTo>
                    <a:cubicBezTo>
                      <a:pt x="138837" y="1068817"/>
                      <a:pt x="127464" y="1029011"/>
                      <a:pt x="116091" y="989205"/>
                    </a:cubicBez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9" name="フリーフォーム 388">
                <a:extLst>
                  <a:ext uri="{FF2B5EF4-FFF2-40B4-BE49-F238E27FC236}">
                    <a16:creationId xmlns:a16="http://schemas.microsoft.com/office/drawing/2014/main" id="{8CDA6B56-CE4D-0AA1-FB42-5BF43FCFC3AA}"/>
                  </a:ext>
                </a:extLst>
              </p:cNvPr>
              <p:cNvSpPr/>
              <p:nvPr/>
            </p:nvSpPr>
            <p:spPr>
              <a:xfrm>
                <a:off x="1592520" y="1834317"/>
                <a:ext cx="1796817" cy="1018065"/>
              </a:xfrm>
              <a:custGeom>
                <a:avLst/>
                <a:gdLst>
                  <a:gd name="connsiteX0" fmla="*/ 0 w 1849271"/>
                  <a:gd name="connsiteY0" fmla="*/ 968991 h 968991"/>
                  <a:gd name="connsiteX1" fmla="*/ 1849271 w 1849271"/>
                  <a:gd name="connsiteY1" fmla="*/ 0 h 9689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49271" h="968991">
                    <a:moveTo>
                      <a:pt x="0" y="968991"/>
                    </a:moveTo>
                    <a:lnTo>
                      <a:pt x="1849271" y="0"/>
                    </a:lnTo>
                  </a:path>
                </a:pathLst>
              </a:cu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385" name="円/楕円 384">
              <a:extLst>
                <a:ext uri="{FF2B5EF4-FFF2-40B4-BE49-F238E27FC236}">
                  <a16:creationId xmlns:a16="http://schemas.microsoft.com/office/drawing/2014/main" id="{CEB2C058-74B3-E36F-9C2D-012DAEBC107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024350" y="1552785"/>
              <a:ext cx="38576" cy="36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6" name="円/楕円 385">
              <a:extLst>
                <a:ext uri="{FF2B5EF4-FFF2-40B4-BE49-F238E27FC236}">
                  <a16:creationId xmlns:a16="http://schemas.microsoft.com/office/drawing/2014/main" id="{9E4095FF-C1D7-5849-1A2D-B1797A57E66F}"/>
                </a:ext>
              </a:extLst>
            </p:cNvPr>
            <p:cNvSpPr>
              <a:spLocks/>
            </p:cNvSpPr>
            <p:nvPr/>
          </p:nvSpPr>
          <p:spPr>
            <a:xfrm rot="1895009">
              <a:off x="1300448" y="1347249"/>
              <a:ext cx="36000" cy="14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7" name="フリーフォーム 386">
              <a:extLst>
                <a:ext uri="{FF2B5EF4-FFF2-40B4-BE49-F238E27FC236}">
                  <a16:creationId xmlns:a16="http://schemas.microsoft.com/office/drawing/2014/main" id="{64B8E4F2-6E1B-9C0B-32C8-40DD519CF2DA}"/>
                </a:ext>
              </a:extLst>
            </p:cNvPr>
            <p:cNvSpPr/>
            <p:nvPr/>
          </p:nvSpPr>
          <p:spPr>
            <a:xfrm>
              <a:off x="1532352" y="1040366"/>
              <a:ext cx="327004" cy="139279"/>
            </a:xfrm>
            <a:custGeom>
              <a:avLst/>
              <a:gdLst>
                <a:gd name="connsiteX0" fmla="*/ 0 w 327004"/>
                <a:gd name="connsiteY0" fmla="*/ 139279 h 139279"/>
                <a:gd name="connsiteX1" fmla="*/ 145335 w 327004"/>
                <a:gd name="connsiteY1" fmla="*/ 54500 h 139279"/>
                <a:gd name="connsiteX2" fmla="*/ 254337 w 327004"/>
                <a:gd name="connsiteY2" fmla="*/ 18167 h 139279"/>
                <a:gd name="connsiteX3" fmla="*/ 327004 w 327004"/>
                <a:gd name="connsiteY3" fmla="*/ 0 h 1392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27004" h="139279">
                  <a:moveTo>
                    <a:pt x="0" y="139279"/>
                  </a:moveTo>
                  <a:cubicBezTo>
                    <a:pt x="51473" y="106982"/>
                    <a:pt x="102946" y="74685"/>
                    <a:pt x="145335" y="54500"/>
                  </a:cubicBezTo>
                  <a:cubicBezTo>
                    <a:pt x="187724" y="34315"/>
                    <a:pt x="224059" y="27250"/>
                    <a:pt x="254337" y="18167"/>
                  </a:cubicBezTo>
                  <a:cubicBezTo>
                    <a:pt x="284615" y="9084"/>
                    <a:pt x="305809" y="4542"/>
                    <a:pt x="327004" y="0"/>
                  </a:cubicBezTo>
                </a:path>
              </a:pathLst>
            </a:custGeom>
            <a:noFill/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91" name="グループ化 390">
            <a:extLst>
              <a:ext uri="{FF2B5EF4-FFF2-40B4-BE49-F238E27FC236}">
                <a16:creationId xmlns:a16="http://schemas.microsoft.com/office/drawing/2014/main" id="{962465E5-02D0-A91F-E9EA-6CF7A65CD9E8}"/>
              </a:ext>
            </a:extLst>
          </p:cNvPr>
          <p:cNvGrpSpPr>
            <a:grpSpLocks noChangeAspect="1"/>
          </p:cNvGrpSpPr>
          <p:nvPr/>
        </p:nvGrpSpPr>
        <p:grpSpPr>
          <a:xfrm>
            <a:off x="3562154" y="3260586"/>
            <a:ext cx="926142" cy="1027959"/>
            <a:chOff x="985804" y="429085"/>
            <a:chExt cx="4026800" cy="4866859"/>
          </a:xfrm>
        </p:grpSpPr>
        <p:sp>
          <p:nvSpPr>
            <p:cNvPr id="392" name="フリーフォーム 391">
              <a:extLst>
                <a:ext uri="{FF2B5EF4-FFF2-40B4-BE49-F238E27FC236}">
                  <a16:creationId xmlns:a16="http://schemas.microsoft.com/office/drawing/2014/main" id="{3A8A498D-FC53-79A2-D80F-6F4D81595694}"/>
                </a:ext>
              </a:extLst>
            </p:cNvPr>
            <p:cNvSpPr/>
            <p:nvPr/>
          </p:nvSpPr>
          <p:spPr>
            <a:xfrm>
              <a:off x="1593484" y="429085"/>
              <a:ext cx="672999" cy="728191"/>
            </a:xfrm>
            <a:custGeom>
              <a:avLst/>
              <a:gdLst>
                <a:gd name="connsiteX0" fmla="*/ 659210 w 672999"/>
                <a:gd name="connsiteY0" fmla="*/ 576149 h 728191"/>
                <a:gd name="connsiteX1" fmla="*/ 659210 w 672999"/>
                <a:gd name="connsiteY1" fmla="*/ 394481 h 728191"/>
                <a:gd name="connsiteX2" fmla="*/ 525986 w 672999"/>
                <a:gd name="connsiteY2" fmla="*/ 115922 h 728191"/>
                <a:gd name="connsiteX3" fmla="*/ 277705 w 672999"/>
                <a:gd name="connsiteY3" fmla="*/ 865 h 728191"/>
                <a:gd name="connsiteX4" fmla="*/ 168704 w 672999"/>
                <a:gd name="connsiteY4" fmla="*/ 67477 h 728191"/>
                <a:gd name="connsiteX5" fmla="*/ 114203 w 672999"/>
                <a:gd name="connsiteY5" fmla="*/ 146200 h 728191"/>
                <a:gd name="connsiteX6" fmla="*/ 102092 w 672999"/>
                <a:gd name="connsiteY6" fmla="*/ 200700 h 728191"/>
                <a:gd name="connsiteX7" fmla="*/ 132370 w 672999"/>
                <a:gd name="connsiteY7" fmla="*/ 333924 h 728191"/>
                <a:gd name="connsiteX8" fmla="*/ 138426 w 672999"/>
                <a:gd name="connsiteY8" fmla="*/ 479259 h 728191"/>
                <a:gd name="connsiteX9" fmla="*/ 96037 w 672999"/>
                <a:gd name="connsiteY9" fmla="*/ 594316 h 728191"/>
                <a:gd name="connsiteX10" fmla="*/ 29425 w 672999"/>
                <a:gd name="connsiteY10" fmla="*/ 685151 h 728191"/>
                <a:gd name="connsiteX11" fmla="*/ 5202 w 672999"/>
                <a:gd name="connsiteY11" fmla="*/ 727540 h 728191"/>
                <a:gd name="connsiteX12" fmla="*/ 126315 w 672999"/>
                <a:gd name="connsiteY12" fmla="*/ 654873 h 728191"/>
                <a:gd name="connsiteX13" fmla="*/ 307984 w 672999"/>
                <a:gd name="connsiteY13" fmla="*/ 606428 h 728191"/>
                <a:gd name="connsiteX14" fmla="*/ 489652 w 672999"/>
                <a:gd name="connsiteY14" fmla="*/ 600372 h 728191"/>
                <a:gd name="connsiteX15" fmla="*/ 574431 w 672999"/>
                <a:gd name="connsiteY15" fmla="*/ 606428 h 728191"/>
                <a:gd name="connsiteX16" fmla="*/ 659210 w 672999"/>
                <a:gd name="connsiteY16" fmla="*/ 576149 h 7281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672999" h="728191">
                  <a:moveTo>
                    <a:pt x="659210" y="576149"/>
                  </a:moveTo>
                  <a:cubicBezTo>
                    <a:pt x="673340" y="540824"/>
                    <a:pt x="681414" y="471185"/>
                    <a:pt x="659210" y="394481"/>
                  </a:cubicBezTo>
                  <a:cubicBezTo>
                    <a:pt x="637006" y="317777"/>
                    <a:pt x="589570" y="181525"/>
                    <a:pt x="525986" y="115922"/>
                  </a:cubicBezTo>
                  <a:cubicBezTo>
                    <a:pt x="462402" y="50319"/>
                    <a:pt x="337252" y="8939"/>
                    <a:pt x="277705" y="865"/>
                  </a:cubicBezTo>
                  <a:cubicBezTo>
                    <a:pt x="218158" y="-7209"/>
                    <a:pt x="195954" y="43255"/>
                    <a:pt x="168704" y="67477"/>
                  </a:cubicBezTo>
                  <a:cubicBezTo>
                    <a:pt x="141454" y="91699"/>
                    <a:pt x="125305" y="123996"/>
                    <a:pt x="114203" y="146200"/>
                  </a:cubicBezTo>
                  <a:cubicBezTo>
                    <a:pt x="103101" y="168404"/>
                    <a:pt x="99064" y="169413"/>
                    <a:pt x="102092" y="200700"/>
                  </a:cubicBezTo>
                  <a:cubicBezTo>
                    <a:pt x="105120" y="231987"/>
                    <a:pt x="126314" y="287498"/>
                    <a:pt x="132370" y="333924"/>
                  </a:cubicBezTo>
                  <a:cubicBezTo>
                    <a:pt x="138426" y="380350"/>
                    <a:pt x="144481" y="435860"/>
                    <a:pt x="138426" y="479259"/>
                  </a:cubicBezTo>
                  <a:cubicBezTo>
                    <a:pt x="132371" y="522658"/>
                    <a:pt x="114204" y="560001"/>
                    <a:pt x="96037" y="594316"/>
                  </a:cubicBezTo>
                  <a:cubicBezTo>
                    <a:pt x="77870" y="628631"/>
                    <a:pt x="44564" y="662947"/>
                    <a:pt x="29425" y="685151"/>
                  </a:cubicBezTo>
                  <a:cubicBezTo>
                    <a:pt x="14286" y="707355"/>
                    <a:pt x="-10946" y="732586"/>
                    <a:pt x="5202" y="727540"/>
                  </a:cubicBezTo>
                  <a:cubicBezTo>
                    <a:pt x="21350" y="722494"/>
                    <a:pt x="75851" y="675058"/>
                    <a:pt x="126315" y="654873"/>
                  </a:cubicBezTo>
                  <a:cubicBezTo>
                    <a:pt x="176779" y="634688"/>
                    <a:pt x="247428" y="615511"/>
                    <a:pt x="307984" y="606428"/>
                  </a:cubicBezTo>
                  <a:cubicBezTo>
                    <a:pt x="368540" y="597345"/>
                    <a:pt x="445244" y="600372"/>
                    <a:pt x="489652" y="600372"/>
                  </a:cubicBezTo>
                  <a:cubicBezTo>
                    <a:pt x="534060" y="600372"/>
                    <a:pt x="549199" y="603400"/>
                    <a:pt x="574431" y="606428"/>
                  </a:cubicBezTo>
                  <a:cubicBezTo>
                    <a:pt x="599663" y="609456"/>
                    <a:pt x="645080" y="611474"/>
                    <a:pt x="659210" y="576149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3" name="フリーフォーム 392">
              <a:extLst>
                <a:ext uri="{FF2B5EF4-FFF2-40B4-BE49-F238E27FC236}">
                  <a16:creationId xmlns:a16="http://schemas.microsoft.com/office/drawing/2014/main" id="{88BC4B86-DAF3-C3B6-B4E0-99F2B5CB5764}"/>
                </a:ext>
              </a:extLst>
            </p:cNvPr>
            <p:cNvSpPr/>
            <p:nvPr/>
          </p:nvSpPr>
          <p:spPr>
            <a:xfrm rot="21341374">
              <a:off x="4454019" y="2433209"/>
              <a:ext cx="558585" cy="1888476"/>
            </a:xfrm>
            <a:custGeom>
              <a:avLst/>
              <a:gdLst>
                <a:gd name="connsiteX0" fmla="*/ 0 w 558586"/>
                <a:gd name="connsiteY0" fmla="*/ 1328057 h 1643802"/>
                <a:gd name="connsiteX1" fmla="*/ 283028 w 558586"/>
                <a:gd name="connsiteY1" fmla="*/ 1643742 h 1643802"/>
                <a:gd name="connsiteX2" fmla="*/ 522514 w 558586"/>
                <a:gd name="connsiteY2" fmla="*/ 1306285 h 1643802"/>
                <a:gd name="connsiteX3" fmla="*/ 544286 w 558586"/>
                <a:gd name="connsiteY3" fmla="*/ 642257 h 1643802"/>
                <a:gd name="connsiteX4" fmla="*/ 391886 w 558586"/>
                <a:gd name="connsiteY4" fmla="*/ 119742 h 1643802"/>
                <a:gd name="connsiteX5" fmla="*/ 337457 w 558586"/>
                <a:gd name="connsiteY5" fmla="*/ 0 h 16438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558586" h="1643802">
                  <a:moveTo>
                    <a:pt x="0" y="1328057"/>
                  </a:moveTo>
                  <a:cubicBezTo>
                    <a:pt x="97971" y="1487714"/>
                    <a:pt x="195942" y="1647371"/>
                    <a:pt x="283028" y="1643742"/>
                  </a:cubicBezTo>
                  <a:cubicBezTo>
                    <a:pt x="370114" y="1640113"/>
                    <a:pt x="478971" y="1473199"/>
                    <a:pt x="522514" y="1306285"/>
                  </a:cubicBezTo>
                  <a:cubicBezTo>
                    <a:pt x="566057" y="1139371"/>
                    <a:pt x="566057" y="840014"/>
                    <a:pt x="544286" y="642257"/>
                  </a:cubicBezTo>
                  <a:cubicBezTo>
                    <a:pt x="522515" y="444500"/>
                    <a:pt x="426357" y="226785"/>
                    <a:pt x="391886" y="119742"/>
                  </a:cubicBezTo>
                  <a:cubicBezTo>
                    <a:pt x="357415" y="12699"/>
                    <a:pt x="347436" y="6349"/>
                    <a:pt x="337457" y="0"/>
                  </a:cubicBezTo>
                </a:path>
              </a:pathLst>
            </a:custGeom>
            <a:noFill/>
            <a:ln w="53975"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4" name="フリーフォーム 393">
              <a:extLst>
                <a:ext uri="{FF2B5EF4-FFF2-40B4-BE49-F238E27FC236}">
                  <a16:creationId xmlns:a16="http://schemas.microsoft.com/office/drawing/2014/main" id="{6BDE3D1F-5038-327C-19C5-6451831DCF67}"/>
                </a:ext>
              </a:extLst>
            </p:cNvPr>
            <p:cNvSpPr/>
            <p:nvPr/>
          </p:nvSpPr>
          <p:spPr>
            <a:xfrm>
              <a:off x="2438799" y="467412"/>
              <a:ext cx="1080194" cy="1246921"/>
            </a:xfrm>
            <a:custGeom>
              <a:avLst/>
              <a:gdLst>
                <a:gd name="connsiteX0" fmla="*/ 1620 w 1080194"/>
                <a:gd name="connsiteY0" fmla="*/ 501489 h 1246921"/>
                <a:gd name="connsiteX1" fmla="*/ 213567 w 1080194"/>
                <a:gd name="connsiteY1" fmla="*/ 216874 h 1246921"/>
                <a:gd name="connsiteX2" fmla="*/ 328624 w 1080194"/>
                <a:gd name="connsiteY2" fmla="*/ 95762 h 1246921"/>
                <a:gd name="connsiteX3" fmla="*/ 401291 w 1080194"/>
                <a:gd name="connsiteY3" fmla="*/ 47316 h 1246921"/>
                <a:gd name="connsiteX4" fmla="*/ 510292 w 1080194"/>
                <a:gd name="connsiteY4" fmla="*/ 4927 h 1246921"/>
                <a:gd name="connsiteX5" fmla="*/ 601127 w 1080194"/>
                <a:gd name="connsiteY5" fmla="*/ 4927 h 1246921"/>
                <a:gd name="connsiteX6" fmla="*/ 710128 w 1080194"/>
                <a:gd name="connsiteY6" fmla="*/ 41261 h 1246921"/>
                <a:gd name="connsiteX7" fmla="*/ 867575 w 1080194"/>
                <a:gd name="connsiteY7" fmla="*/ 132095 h 1246921"/>
                <a:gd name="connsiteX8" fmla="*/ 994743 w 1080194"/>
                <a:gd name="connsiteY8" fmla="*/ 313764 h 1246921"/>
                <a:gd name="connsiteX9" fmla="*/ 1079522 w 1080194"/>
                <a:gd name="connsiteY9" fmla="*/ 628657 h 1246921"/>
                <a:gd name="connsiteX10" fmla="*/ 1031076 w 1080194"/>
                <a:gd name="connsiteY10" fmla="*/ 876938 h 1246921"/>
                <a:gd name="connsiteX11" fmla="*/ 970520 w 1080194"/>
                <a:gd name="connsiteY11" fmla="*/ 973828 h 1246921"/>
                <a:gd name="connsiteX12" fmla="*/ 867575 w 1080194"/>
                <a:gd name="connsiteY12" fmla="*/ 1088885 h 1246921"/>
                <a:gd name="connsiteX13" fmla="*/ 595071 w 1080194"/>
                <a:gd name="connsiteY13" fmla="*/ 1246331 h 1246921"/>
                <a:gd name="connsiteX14" fmla="*/ 516348 w 1080194"/>
                <a:gd name="connsiteY14" fmla="*/ 1028328 h 1246921"/>
                <a:gd name="connsiteX15" fmla="*/ 407347 w 1080194"/>
                <a:gd name="connsiteY15" fmla="*/ 864826 h 1246921"/>
                <a:gd name="connsiteX16" fmla="*/ 249900 w 1080194"/>
                <a:gd name="connsiteY16" fmla="*/ 707380 h 1246921"/>
                <a:gd name="connsiteX17" fmla="*/ 122732 w 1080194"/>
                <a:gd name="connsiteY17" fmla="*/ 592323 h 1246921"/>
                <a:gd name="connsiteX18" fmla="*/ 1620 w 1080194"/>
                <a:gd name="connsiteY18" fmla="*/ 501489 h 12469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080194" h="1246921">
                  <a:moveTo>
                    <a:pt x="1620" y="501489"/>
                  </a:moveTo>
                  <a:cubicBezTo>
                    <a:pt x="16759" y="438914"/>
                    <a:pt x="159066" y="284495"/>
                    <a:pt x="213567" y="216874"/>
                  </a:cubicBezTo>
                  <a:cubicBezTo>
                    <a:pt x="268068" y="149253"/>
                    <a:pt x="297337" y="124022"/>
                    <a:pt x="328624" y="95762"/>
                  </a:cubicBezTo>
                  <a:cubicBezTo>
                    <a:pt x="359911" y="67502"/>
                    <a:pt x="371013" y="62455"/>
                    <a:pt x="401291" y="47316"/>
                  </a:cubicBezTo>
                  <a:cubicBezTo>
                    <a:pt x="431569" y="32177"/>
                    <a:pt x="476986" y="11992"/>
                    <a:pt x="510292" y="4927"/>
                  </a:cubicBezTo>
                  <a:cubicBezTo>
                    <a:pt x="543598" y="-2138"/>
                    <a:pt x="567821" y="-1129"/>
                    <a:pt x="601127" y="4927"/>
                  </a:cubicBezTo>
                  <a:cubicBezTo>
                    <a:pt x="634433" y="10983"/>
                    <a:pt x="665720" y="20066"/>
                    <a:pt x="710128" y="41261"/>
                  </a:cubicBezTo>
                  <a:cubicBezTo>
                    <a:pt x="754536" y="62456"/>
                    <a:pt x="820139" y="86678"/>
                    <a:pt x="867575" y="132095"/>
                  </a:cubicBezTo>
                  <a:cubicBezTo>
                    <a:pt x="915011" y="177512"/>
                    <a:pt x="959419" y="231004"/>
                    <a:pt x="994743" y="313764"/>
                  </a:cubicBezTo>
                  <a:cubicBezTo>
                    <a:pt x="1030068" y="396524"/>
                    <a:pt x="1073467" y="534795"/>
                    <a:pt x="1079522" y="628657"/>
                  </a:cubicBezTo>
                  <a:cubicBezTo>
                    <a:pt x="1085577" y="722519"/>
                    <a:pt x="1049243" y="819410"/>
                    <a:pt x="1031076" y="876938"/>
                  </a:cubicBezTo>
                  <a:cubicBezTo>
                    <a:pt x="1012909" y="934466"/>
                    <a:pt x="997770" y="938504"/>
                    <a:pt x="970520" y="973828"/>
                  </a:cubicBezTo>
                  <a:cubicBezTo>
                    <a:pt x="943270" y="1009153"/>
                    <a:pt x="930150" y="1043468"/>
                    <a:pt x="867575" y="1088885"/>
                  </a:cubicBezTo>
                  <a:cubicBezTo>
                    <a:pt x="805000" y="1134302"/>
                    <a:pt x="653609" y="1256424"/>
                    <a:pt x="595071" y="1246331"/>
                  </a:cubicBezTo>
                  <a:cubicBezTo>
                    <a:pt x="536533" y="1236238"/>
                    <a:pt x="547635" y="1091912"/>
                    <a:pt x="516348" y="1028328"/>
                  </a:cubicBezTo>
                  <a:cubicBezTo>
                    <a:pt x="485061" y="964744"/>
                    <a:pt x="451755" y="918317"/>
                    <a:pt x="407347" y="864826"/>
                  </a:cubicBezTo>
                  <a:cubicBezTo>
                    <a:pt x="362939" y="811335"/>
                    <a:pt x="297336" y="752797"/>
                    <a:pt x="249900" y="707380"/>
                  </a:cubicBezTo>
                  <a:cubicBezTo>
                    <a:pt x="202464" y="661963"/>
                    <a:pt x="164112" y="624620"/>
                    <a:pt x="122732" y="592323"/>
                  </a:cubicBezTo>
                  <a:cubicBezTo>
                    <a:pt x="81352" y="560026"/>
                    <a:pt x="-13519" y="564064"/>
                    <a:pt x="1620" y="501489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5" name="フリーフォーム 394">
              <a:extLst>
                <a:ext uri="{FF2B5EF4-FFF2-40B4-BE49-F238E27FC236}">
                  <a16:creationId xmlns:a16="http://schemas.microsoft.com/office/drawing/2014/main" id="{1262B8AC-56BE-798D-2E01-4BD23943248A}"/>
                </a:ext>
              </a:extLst>
            </p:cNvPr>
            <p:cNvSpPr/>
            <p:nvPr/>
          </p:nvSpPr>
          <p:spPr>
            <a:xfrm>
              <a:off x="985804" y="903627"/>
              <a:ext cx="2078963" cy="1730581"/>
            </a:xfrm>
            <a:custGeom>
              <a:avLst/>
              <a:gdLst>
                <a:gd name="connsiteX0" fmla="*/ 576548 w 2078962"/>
                <a:gd name="connsiteY0" fmla="*/ 252998 h 1730581"/>
                <a:gd name="connsiteX1" fmla="*/ 322212 w 2078962"/>
                <a:gd name="connsiteY1" fmla="*/ 549724 h 1730581"/>
                <a:gd name="connsiteX2" fmla="*/ 213211 w 2078962"/>
                <a:gd name="connsiteY2" fmla="*/ 725337 h 1730581"/>
                <a:gd name="connsiteX3" fmla="*/ 164766 w 2078962"/>
                <a:gd name="connsiteY3" fmla="*/ 828283 h 1730581"/>
                <a:gd name="connsiteX4" fmla="*/ 146599 w 2078962"/>
                <a:gd name="connsiteY4" fmla="*/ 858561 h 1730581"/>
                <a:gd name="connsiteX5" fmla="*/ 92098 w 2078962"/>
                <a:gd name="connsiteY5" fmla="*/ 931229 h 1730581"/>
                <a:gd name="connsiteX6" fmla="*/ 37597 w 2078962"/>
                <a:gd name="connsiteY6" fmla="*/ 1022063 h 1730581"/>
                <a:gd name="connsiteX7" fmla="*/ 1264 w 2078962"/>
                <a:gd name="connsiteY7" fmla="*/ 1131064 h 1730581"/>
                <a:gd name="connsiteX8" fmla="*/ 13375 w 2078962"/>
                <a:gd name="connsiteY8" fmla="*/ 1246121 h 1730581"/>
                <a:gd name="connsiteX9" fmla="*/ 61820 w 2078962"/>
                <a:gd name="connsiteY9" fmla="*/ 1343011 h 1730581"/>
                <a:gd name="connsiteX10" fmla="*/ 146599 w 2078962"/>
                <a:gd name="connsiteY10" fmla="*/ 1349067 h 1730581"/>
                <a:gd name="connsiteX11" fmla="*/ 176877 w 2078962"/>
                <a:gd name="connsiteY11" fmla="*/ 1403568 h 1730581"/>
                <a:gd name="connsiteX12" fmla="*/ 176877 w 2078962"/>
                <a:gd name="connsiteY12" fmla="*/ 1452013 h 1730581"/>
                <a:gd name="connsiteX13" fmla="*/ 237433 w 2078962"/>
                <a:gd name="connsiteY13" fmla="*/ 1518625 h 1730581"/>
                <a:gd name="connsiteX14" fmla="*/ 388824 w 2078962"/>
                <a:gd name="connsiteY14" fmla="*/ 1585237 h 1730581"/>
                <a:gd name="connsiteX15" fmla="*/ 552326 w 2078962"/>
                <a:gd name="connsiteY15" fmla="*/ 1609459 h 1730581"/>
                <a:gd name="connsiteX16" fmla="*/ 691605 w 2078962"/>
                <a:gd name="connsiteY16" fmla="*/ 1567070 h 1730581"/>
                <a:gd name="connsiteX17" fmla="*/ 715828 w 2078962"/>
                <a:gd name="connsiteY17" fmla="*/ 1615515 h 1730581"/>
                <a:gd name="connsiteX18" fmla="*/ 836940 w 2078962"/>
                <a:gd name="connsiteY18" fmla="*/ 1712405 h 1730581"/>
                <a:gd name="connsiteX19" fmla="*/ 964109 w 2078962"/>
                <a:gd name="connsiteY19" fmla="*/ 1730572 h 1730581"/>
                <a:gd name="connsiteX20" fmla="*/ 1188167 w 2078962"/>
                <a:gd name="connsiteY20" fmla="*/ 1712405 h 1730581"/>
                <a:gd name="connsiteX21" fmla="*/ 1351669 w 2078962"/>
                <a:gd name="connsiteY21" fmla="*/ 1639737 h 1730581"/>
                <a:gd name="connsiteX22" fmla="*/ 1587838 w 2078962"/>
                <a:gd name="connsiteY22" fmla="*/ 1482291 h 1730581"/>
                <a:gd name="connsiteX23" fmla="*/ 1799785 w 2078962"/>
                <a:gd name="connsiteY23" fmla="*/ 1300622 h 1730581"/>
                <a:gd name="connsiteX24" fmla="*/ 1975399 w 2078962"/>
                <a:gd name="connsiteY24" fmla="*/ 1100786 h 1730581"/>
                <a:gd name="connsiteX25" fmla="*/ 2078344 w 2078962"/>
                <a:gd name="connsiteY25" fmla="*/ 828283 h 1730581"/>
                <a:gd name="connsiteX26" fmla="*/ 2017788 w 2078962"/>
                <a:gd name="connsiteY26" fmla="*/ 798005 h 1730581"/>
                <a:gd name="connsiteX27" fmla="*/ 2005677 w 2078962"/>
                <a:gd name="connsiteY27" fmla="*/ 634503 h 1730581"/>
                <a:gd name="connsiteX28" fmla="*/ 1624172 w 2078962"/>
                <a:gd name="connsiteY28" fmla="*/ 174275 h 1730581"/>
                <a:gd name="connsiteX29" fmla="*/ 1442503 w 2078962"/>
                <a:gd name="connsiteY29" fmla="*/ 34996 h 1730581"/>
                <a:gd name="connsiteX30" fmla="*/ 1279001 w 2078962"/>
                <a:gd name="connsiteY30" fmla="*/ 16829 h 1730581"/>
                <a:gd name="connsiteX31" fmla="*/ 576548 w 2078962"/>
                <a:gd name="connsiteY31" fmla="*/ 252998 h 17305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</a:cxnLst>
              <a:rect l="l" t="t" r="r" b="b"/>
              <a:pathLst>
                <a:path w="2078962" h="1730581">
                  <a:moveTo>
                    <a:pt x="576548" y="252998"/>
                  </a:moveTo>
                  <a:cubicBezTo>
                    <a:pt x="417083" y="341814"/>
                    <a:pt x="382768" y="471001"/>
                    <a:pt x="322212" y="549724"/>
                  </a:cubicBezTo>
                  <a:cubicBezTo>
                    <a:pt x="261656" y="628447"/>
                    <a:pt x="239452" y="678911"/>
                    <a:pt x="213211" y="725337"/>
                  </a:cubicBezTo>
                  <a:cubicBezTo>
                    <a:pt x="186970" y="771763"/>
                    <a:pt x="175868" y="806079"/>
                    <a:pt x="164766" y="828283"/>
                  </a:cubicBezTo>
                  <a:cubicBezTo>
                    <a:pt x="153664" y="850487"/>
                    <a:pt x="158710" y="841403"/>
                    <a:pt x="146599" y="858561"/>
                  </a:cubicBezTo>
                  <a:cubicBezTo>
                    <a:pt x="134488" y="875719"/>
                    <a:pt x="110265" y="903979"/>
                    <a:pt x="92098" y="931229"/>
                  </a:cubicBezTo>
                  <a:cubicBezTo>
                    <a:pt x="73931" y="958479"/>
                    <a:pt x="52736" y="988757"/>
                    <a:pt x="37597" y="1022063"/>
                  </a:cubicBezTo>
                  <a:cubicBezTo>
                    <a:pt x="22458" y="1055369"/>
                    <a:pt x="5301" y="1093721"/>
                    <a:pt x="1264" y="1131064"/>
                  </a:cubicBezTo>
                  <a:cubicBezTo>
                    <a:pt x="-2773" y="1168407"/>
                    <a:pt x="3282" y="1210797"/>
                    <a:pt x="13375" y="1246121"/>
                  </a:cubicBezTo>
                  <a:cubicBezTo>
                    <a:pt x="23468" y="1281445"/>
                    <a:pt x="39616" y="1325853"/>
                    <a:pt x="61820" y="1343011"/>
                  </a:cubicBezTo>
                  <a:cubicBezTo>
                    <a:pt x="84024" y="1360169"/>
                    <a:pt x="127423" y="1338974"/>
                    <a:pt x="146599" y="1349067"/>
                  </a:cubicBezTo>
                  <a:cubicBezTo>
                    <a:pt x="165775" y="1359160"/>
                    <a:pt x="171831" y="1386410"/>
                    <a:pt x="176877" y="1403568"/>
                  </a:cubicBezTo>
                  <a:cubicBezTo>
                    <a:pt x="181923" y="1420726"/>
                    <a:pt x="166784" y="1432837"/>
                    <a:pt x="176877" y="1452013"/>
                  </a:cubicBezTo>
                  <a:cubicBezTo>
                    <a:pt x="186970" y="1471189"/>
                    <a:pt x="202109" y="1496421"/>
                    <a:pt x="237433" y="1518625"/>
                  </a:cubicBezTo>
                  <a:cubicBezTo>
                    <a:pt x="272757" y="1540829"/>
                    <a:pt x="336342" y="1570098"/>
                    <a:pt x="388824" y="1585237"/>
                  </a:cubicBezTo>
                  <a:cubicBezTo>
                    <a:pt x="441306" y="1600376"/>
                    <a:pt x="501863" y="1612487"/>
                    <a:pt x="552326" y="1609459"/>
                  </a:cubicBezTo>
                  <a:cubicBezTo>
                    <a:pt x="602789" y="1606431"/>
                    <a:pt x="664355" y="1566061"/>
                    <a:pt x="691605" y="1567070"/>
                  </a:cubicBezTo>
                  <a:cubicBezTo>
                    <a:pt x="718855" y="1568079"/>
                    <a:pt x="691606" y="1591293"/>
                    <a:pt x="715828" y="1615515"/>
                  </a:cubicBezTo>
                  <a:cubicBezTo>
                    <a:pt x="740050" y="1639737"/>
                    <a:pt x="795560" y="1693229"/>
                    <a:pt x="836940" y="1712405"/>
                  </a:cubicBezTo>
                  <a:cubicBezTo>
                    <a:pt x="878320" y="1731581"/>
                    <a:pt x="905571" y="1730572"/>
                    <a:pt x="964109" y="1730572"/>
                  </a:cubicBezTo>
                  <a:cubicBezTo>
                    <a:pt x="1022647" y="1730572"/>
                    <a:pt x="1123574" y="1727544"/>
                    <a:pt x="1188167" y="1712405"/>
                  </a:cubicBezTo>
                  <a:cubicBezTo>
                    <a:pt x="1252760" y="1697266"/>
                    <a:pt x="1285057" y="1678089"/>
                    <a:pt x="1351669" y="1639737"/>
                  </a:cubicBezTo>
                  <a:cubicBezTo>
                    <a:pt x="1418281" y="1601385"/>
                    <a:pt x="1513152" y="1538810"/>
                    <a:pt x="1587838" y="1482291"/>
                  </a:cubicBezTo>
                  <a:cubicBezTo>
                    <a:pt x="1662524" y="1425772"/>
                    <a:pt x="1735191" y="1364206"/>
                    <a:pt x="1799785" y="1300622"/>
                  </a:cubicBezTo>
                  <a:cubicBezTo>
                    <a:pt x="1864379" y="1237038"/>
                    <a:pt x="1928973" y="1179509"/>
                    <a:pt x="1975399" y="1100786"/>
                  </a:cubicBezTo>
                  <a:cubicBezTo>
                    <a:pt x="2021825" y="1022063"/>
                    <a:pt x="2071279" y="878746"/>
                    <a:pt x="2078344" y="828283"/>
                  </a:cubicBezTo>
                  <a:cubicBezTo>
                    <a:pt x="2085409" y="777820"/>
                    <a:pt x="2029899" y="830302"/>
                    <a:pt x="2017788" y="798005"/>
                  </a:cubicBezTo>
                  <a:cubicBezTo>
                    <a:pt x="2005677" y="765708"/>
                    <a:pt x="2071280" y="738458"/>
                    <a:pt x="2005677" y="634503"/>
                  </a:cubicBezTo>
                  <a:cubicBezTo>
                    <a:pt x="1940074" y="530548"/>
                    <a:pt x="1718034" y="274193"/>
                    <a:pt x="1624172" y="174275"/>
                  </a:cubicBezTo>
                  <a:cubicBezTo>
                    <a:pt x="1530310" y="74357"/>
                    <a:pt x="1500031" y="61237"/>
                    <a:pt x="1442503" y="34996"/>
                  </a:cubicBezTo>
                  <a:cubicBezTo>
                    <a:pt x="1384975" y="8755"/>
                    <a:pt x="1426355" y="-18496"/>
                    <a:pt x="1279001" y="16829"/>
                  </a:cubicBezTo>
                  <a:cubicBezTo>
                    <a:pt x="1131647" y="52154"/>
                    <a:pt x="736013" y="164182"/>
                    <a:pt x="576548" y="252998"/>
                  </a:cubicBezTo>
                  <a:close/>
                </a:path>
              </a:pathLst>
            </a:cu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6" name="フリーフォーム 395">
              <a:extLst>
                <a:ext uri="{FF2B5EF4-FFF2-40B4-BE49-F238E27FC236}">
                  <a16:creationId xmlns:a16="http://schemas.microsoft.com/office/drawing/2014/main" id="{63EA408F-B863-4787-71DD-06A51446E9AC}"/>
                </a:ext>
              </a:extLst>
            </p:cNvPr>
            <p:cNvSpPr/>
            <p:nvPr/>
          </p:nvSpPr>
          <p:spPr>
            <a:xfrm>
              <a:off x="2475215" y="607868"/>
              <a:ext cx="926511" cy="1041568"/>
            </a:xfrm>
            <a:custGeom>
              <a:avLst/>
              <a:gdLst>
                <a:gd name="connsiteX0" fmla="*/ 1620 w 1080194"/>
                <a:gd name="connsiteY0" fmla="*/ 501489 h 1246921"/>
                <a:gd name="connsiteX1" fmla="*/ 213567 w 1080194"/>
                <a:gd name="connsiteY1" fmla="*/ 216874 h 1246921"/>
                <a:gd name="connsiteX2" fmla="*/ 328624 w 1080194"/>
                <a:gd name="connsiteY2" fmla="*/ 95762 h 1246921"/>
                <a:gd name="connsiteX3" fmla="*/ 401291 w 1080194"/>
                <a:gd name="connsiteY3" fmla="*/ 47316 h 1246921"/>
                <a:gd name="connsiteX4" fmla="*/ 510292 w 1080194"/>
                <a:gd name="connsiteY4" fmla="*/ 4927 h 1246921"/>
                <a:gd name="connsiteX5" fmla="*/ 601127 w 1080194"/>
                <a:gd name="connsiteY5" fmla="*/ 4927 h 1246921"/>
                <a:gd name="connsiteX6" fmla="*/ 710128 w 1080194"/>
                <a:gd name="connsiteY6" fmla="*/ 41261 h 1246921"/>
                <a:gd name="connsiteX7" fmla="*/ 867575 w 1080194"/>
                <a:gd name="connsiteY7" fmla="*/ 132095 h 1246921"/>
                <a:gd name="connsiteX8" fmla="*/ 994743 w 1080194"/>
                <a:gd name="connsiteY8" fmla="*/ 313764 h 1246921"/>
                <a:gd name="connsiteX9" fmla="*/ 1079522 w 1080194"/>
                <a:gd name="connsiteY9" fmla="*/ 628657 h 1246921"/>
                <a:gd name="connsiteX10" fmla="*/ 1031076 w 1080194"/>
                <a:gd name="connsiteY10" fmla="*/ 876938 h 1246921"/>
                <a:gd name="connsiteX11" fmla="*/ 970520 w 1080194"/>
                <a:gd name="connsiteY11" fmla="*/ 973828 h 1246921"/>
                <a:gd name="connsiteX12" fmla="*/ 867575 w 1080194"/>
                <a:gd name="connsiteY12" fmla="*/ 1088885 h 1246921"/>
                <a:gd name="connsiteX13" fmla="*/ 595071 w 1080194"/>
                <a:gd name="connsiteY13" fmla="*/ 1246331 h 1246921"/>
                <a:gd name="connsiteX14" fmla="*/ 516348 w 1080194"/>
                <a:gd name="connsiteY14" fmla="*/ 1028328 h 1246921"/>
                <a:gd name="connsiteX15" fmla="*/ 407347 w 1080194"/>
                <a:gd name="connsiteY15" fmla="*/ 864826 h 1246921"/>
                <a:gd name="connsiteX16" fmla="*/ 249900 w 1080194"/>
                <a:gd name="connsiteY16" fmla="*/ 707380 h 1246921"/>
                <a:gd name="connsiteX17" fmla="*/ 122732 w 1080194"/>
                <a:gd name="connsiteY17" fmla="*/ 592323 h 1246921"/>
                <a:gd name="connsiteX18" fmla="*/ 1620 w 1080194"/>
                <a:gd name="connsiteY18" fmla="*/ 501489 h 12469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080194" h="1246921">
                  <a:moveTo>
                    <a:pt x="1620" y="501489"/>
                  </a:moveTo>
                  <a:cubicBezTo>
                    <a:pt x="16759" y="438914"/>
                    <a:pt x="159066" y="284495"/>
                    <a:pt x="213567" y="216874"/>
                  </a:cubicBezTo>
                  <a:cubicBezTo>
                    <a:pt x="268068" y="149253"/>
                    <a:pt x="297337" y="124022"/>
                    <a:pt x="328624" y="95762"/>
                  </a:cubicBezTo>
                  <a:cubicBezTo>
                    <a:pt x="359911" y="67502"/>
                    <a:pt x="371013" y="62455"/>
                    <a:pt x="401291" y="47316"/>
                  </a:cubicBezTo>
                  <a:cubicBezTo>
                    <a:pt x="431569" y="32177"/>
                    <a:pt x="476986" y="11992"/>
                    <a:pt x="510292" y="4927"/>
                  </a:cubicBezTo>
                  <a:cubicBezTo>
                    <a:pt x="543598" y="-2138"/>
                    <a:pt x="567821" y="-1129"/>
                    <a:pt x="601127" y="4927"/>
                  </a:cubicBezTo>
                  <a:cubicBezTo>
                    <a:pt x="634433" y="10983"/>
                    <a:pt x="665720" y="20066"/>
                    <a:pt x="710128" y="41261"/>
                  </a:cubicBezTo>
                  <a:cubicBezTo>
                    <a:pt x="754536" y="62456"/>
                    <a:pt x="820139" y="86678"/>
                    <a:pt x="867575" y="132095"/>
                  </a:cubicBezTo>
                  <a:cubicBezTo>
                    <a:pt x="915011" y="177512"/>
                    <a:pt x="959419" y="231004"/>
                    <a:pt x="994743" y="313764"/>
                  </a:cubicBezTo>
                  <a:cubicBezTo>
                    <a:pt x="1030068" y="396524"/>
                    <a:pt x="1073467" y="534795"/>
                    <a:pt x="1079522" y="628657"/>
                  </a:cubicBezTo>
                  <a:cubicBezTo>
                    <a:pt x="1085577" y="722519"/>
                    <a:pt x="1049243" y="819410"/>
                    <a:pt x="1031076" y="876938"/>
                  </a:cubicBezTo>
                  <a:cubicBezTo>
                    <a:pt x="1012909" y="934466"/>
                    <a:pt x="997770" y="938504"/>
                    <a:pt x="970520" y="973828"/>
                  </a:cubicBezTo>
                  <a:cubicBezTo>
                    <a:pt x="943270" y="1009153"/>
                    <a:pt x="930150" y="1043468"/>
                    <a:pt x="867575" y="1088885"/>
                  </a:cubicBezTo>
                  <a:cubicBezTo>
                    <a:pt x="805000" y="1134302"/>
                    <a:pt x="653609" y="1256424"/>
                    <a:pt x="595071" y="1246331"/>
                  </a:cubicBezTo>
                  <a:cubicBezTo>
                    <a:pt x="536533" y="1236238"/>
                    <a:pt x="547635" y="1091912"/>
                    <a:pt x="516348" y="1028328"/>
                  </a:cubicBezTo>
                  <a:cubicBezTo>
                    <a:pt x="485061" y="964744"/>
                    <a:pt x="451755" y="918317"/>
                    <a:pt x="407347" y="864826"/>
                  </a:cubicBezTo>
                  <a:cubicBezTo>
                    <a:pt x="362939" y="811335"/>
                    <a:pt x="297336" y="752797"/>
                    <a:pt x="249900" y="707380"/>
                  </a:cubicBezTo>
                  <a:cubicBezTo>
                    <a:pt x="202464" y="661963"/>
                    <a:pt x="164112" y="624620"/>
                    <a:pt x="122732" y="592323"/>
                  </a:cubicBezTo>
                  <a:cubicBezTo>
                    <a:pt x="81352" y="560026"/>
                    <a:pt x="-13519" y="564064"/>
                    <a:pt x="1620" y="501489"/>
                  </a:cubicBezTo>
                  <a:close/>
                </a:path>
              </a:pathLst>
            </a:cu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7" name="フリーフォーム 396">
              <a:extLst>
                <a:ext uri="{FF2B5EF4-FFF2-40B4-BE49-F238E27FC236}">
                  <a16:creationId xmlns:a16="http://schemas.microsoft.com/office/drawing/2014/main" id="{40EF1FD4-16CD-9A95-27EC-CAFC20CBCE57}"/>
                </a:ext>
              </a:extLst>
            </p:cNvPr>
            <p:cNvSpPr/>
            <p:nvPr/>
          </p:nvSpPr>
          <p:spPr>
            <a:xfrm>
              <a:off x="1156625" y="2027846"/>
              <a:ext cx="690342" cy="255236"/>
            </a:xfrm>
            <a:custGeom>
              <a:avLst/>
              <a:gdLst>
                <a:gd name="connsiteX0" fmla="*/ 0 w 690342"/>
                <a:gd name="connsiteY0" fmla="*/ 236959 h 255236"/>
                <a:gd name="connsiteX1" fmla="*/ 102946 w 690342"/>
                <a:gd name="connsiteY1" fmla="*/ 127958 h 255236"/>
                <a:gd name="connsiteX2" fmla="*/ 127168 w 690342"/>
                <a:gd name="connsiteY2" fmla="*/ 91624 h 255236"/>
                <a:gd name="connsiteX3" fmla="*/ 145335 w 690342"/>
                <a:gd name="connsiteY3" fmla="*/ 31068 h 255236"/>
                <a:gd name="connsiteX4" fmla="*/ 145335 w 690342"/>
                <a:gd name="connsiteY4" fmla="*/ 790 h 255236"/>
                <a:gd name="connsiteX5" fmla="*/ 181669 w 690342"/>
                <a:gd name="connsiteY5" fmla="*/ 61346 h 255236"/>
                <a:gd name="connsiteX6" fmla="*/ 218003 w 690342"/>
                <a:gd name="connsiteY6" fmla="*/ 127958 h 255236"/>
                <a:gd name="connsiteX7" fmla="*/ 327004 w 690342"/>
                <a:gd name="connsiteY7" fmla="*/ 212737 h 255236"/>
                <a:gd name="connsiteX8" fmla="*/ 423894 w 690342"/>
                <a:gd name="connsiteY8" fmla="*/ 243015 h 255236"/>
                <a:gd name="connsiteX9" fmla="*/ 502617 w 690342"/>
                <a:gd name="connsiteY9" fmla="*/ 255126 h 255236"/>
                <a:gd name="connsiteX10" fmla="*/ 611619 w 690342"/>
                <a:gd name="connsiteY10" fmla="*/ 236959 h 255236"/>
                <a:gd name="connsiteX11" fmla="*/ 690342 w 690342"/>
                <a:gd name="connsiteY11" fmla="*/ 206681 h 255236"/>
                <a:gd name="connsiteX12" fmla="*/ 690342 w 690342"/>
                <a:gd name="connsiteY12" fmla="*/ 206681 h 2552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690342" h="255236">
                  <a:moveTo>
                    <a:pt x="0" y="236959"/>
                  </a:moveTo>
                  <a:cubicBezTo>
                    <a:pt x="40875" y="194569"/>
                    <a:pt x="81751" y="152180"/>
                    <a:pt x="102946" y="127958"/>
                  </a:cubicBezTo>
                  <a:cubicBezTo>
                    <a:pt x="124141" y="103735"/>
                    <a:pt x="120103" y="107772"/>
                    <a:pt x="127168" y="91624"/>
                  </a:cubicBezTo>
                  <a:cubicBezTo>
                    <a:pt x="134233" y="75476"/>
                    <a:pt x="142307" y="46207"/>
                    <a:pt x="145335" y="31068"/>
                  </a:cubicBezTo>
                  <a:cubicBezTo>
                    <a:pt x="148363" y="15929"/>
                    <a:pt x="139279" y="-4256"/>
                    <a:pt x="145335" y="790"/>
                  </a:cubicBezTo>
                  <a:cubicBezTo>
                    <a:pt x="151391" y="5836"/>
                    <a:pt x="169558" y="40151"/>
                    <a:pt x="181669" y="61346"/>
                  </a:cubicBezTo>
                  <a:cubicBezTo>
                    <a:pt x="193780" y="82541"/>
                    <a:pt x="193781" y="102726"/>
                    <a:pt x="218003" y="127958"/>
                  </a:cubicBezTo>
                  <a:cubicBezTo>
                    <a:pt x="242225" y="153190"/>
                    <a:pt x="292689" y="193561"/>
                    <a:pt x="327004" y="212737"/>
                  </a:cubicBezTo>
                  <a:cubicBezTo>
                    <a:pt x="361319" y="231913"/>
                    <a:pt x="394625" y="235950"/>
                    <a:pt x="423894" y="243015"/>
                  </a:cubicBezTo>
                  <a:cubicBezTo>
                    <a:pt x="453163" y="250080"/>
                    <a:pt x="471330" y="256135"/>
                    <a:pt x="502617" y="255126"/>
                  </a:cubicBezTo>
                  <a:cubicBezTo>
                    <a:pt x="533904" y="254117"/>
                    <a:pt x="580332" y="245033"/>
                    <a:pt x="611619" y="236959"/>
                  </a:cubicBezTo>
                  <a:cubicBezTo>
                    <a:pt x="642906" y="228885"/>
                    <a:pt x="690342" y="206681"/>
                    <a:pt x="690342" y="206681"/>
                  </a:cubicBezTo>
                  <a:lnTo>
                    <a:pt x="690342" y="206681"/>
                  </a:lnTo>
                </a:path>
              </a:pathLst>
            </a:custGeom>
            <a:noFill/>
            <a:ln w="1270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8" name="フリーフォーム 397">
              <a:extLst>
                <a:ext uri="{FF2B5EF4-FFF2-40B4-BE49-F238E27FC236}">
                  <a16:creationId xmlns:a16="http://schemas.microsoft.com/office/drawing/2014/main" id="{CE2D8B0B-C560-F45D-DBD5-C0553433478B}"/>
                </a:ext>
              </a:extLst>
            </p:cNvPr>
            <p:cNvSpPr/>
            <p:nvPr/>
          </p:nvSpPr>
          <p:spPr>
            <a:xfrm>
              <a:off x="1671354" y="2313106"/>
              <a:ext cx="496561" cy="163646"/>
            </a:xfrm>
            <a:custGeom>
              <a:avLst/>
              <a:gdLst>
                <a:gd name="connsiteX0" fmla="*/ 0 w 496561"/>
                <a:gd name="connsiteY0" fmla="*/ 157591 h 163646"/>
                <a:gd name="connsiteX1" fmla="*/ 139279 w 496561"/>
                <a:gd name="connsiteY1" fmla="*/ 109146 h 163646"/>
                <a:gd name="connsiteX2" fmla="*/ 205891 w 496561"/>
                <a:gd name="connsiteY2" fmla="*/ 60701 h 163646"/>
                <a:gd name="connsiteX3" fmla="*/ 242225 w 496561"/>
                <a:gd name="connsiteY3" fmla="*/ 144 h 163646"/>
                <a:gd name="connsiteX4" fmla="*/ 272503 w 496561"/>
                <a:gd name="connsiteY4" fmla="*/ 78868 h 163646"/>
                <a:gd name="connsiteX5" fmla="*/ 399671 w 496561"/>
                <a:gd name="connsiteY5" fmla="*/ 139424 h 163646"/>
                <a:gd name="connsiteX6" fmla="*/ 496561 w 496561"/>
                <a:gd name="connsiteY6" fmla="*/ 163646 h 163646"/>
                <a:gd name="connsiteX7" fmla="*/ 496561 w 496561"/>
                <a:gd name="connsiteY7" fmla="*/ 163646 h 1636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496561" h="163646">
                  <a:moveTo>
                    <a:pt x="0" y="157591"/>
                  </a:moveTo>
                  <a:cubicBezTo>
                    <a:pt x="52482" y="141442"/>
                    <a:pt x="104964" y="125294"/>
                    <a:pt x="139279" y="109146"/>
                  </a:cubicBezTo>
                  <a:cubicBezTo>
                    <a:pt x="173594" y="92998"/>
                    <a:pt x="188733" y="78868"/>
                    <a:pt x="205891" y="60701"/>
                  </a:cubicBezTo>
                  <a:cubicBezTo>
                    <a:pt x="223049" y="42534"/>
                    <a:pt x="231123" y="-2884"/>
                    <a:pt x="242225" y="144"/>
                  </a:cubicBezTo>
                  <a:cubicBezTo>
                    <a:pt x="253327" y="3172"/>
                    <a:pt x="246262" y="55655"/>
                    <a:pt x="272503" y="78868"/>
                  </a:cubicBezTo>
                  <a:cubicBezTo>
                    <a:pt x="298744" y="102081"/>
                    <a:pt x="362328" y="125294"/>
                    <a:pt x="399671" y="139424"/>
                  </a:cubicBezTo>
                  <a:cubicBezTo>
                    <a:pt x="437014" y="153554"/>
                    <a:pt x="496561" y="163646"/>
                    <a:pt x="496561" y="163646"/>
                  </a:cubicBezTo>
                  <a:lnTo>
                    <a:pt x="496561" y="163646"/>
                  </a:lnTo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9" name="フリーフォーム 398">
              <a:extLst>
                <a:ext uri="{FF2B5EF4-FFF2-40B4-BE49-F238E27FC236}">
                  <a16:creationId xmlns:a16="http://schemas.microsoft.com/office/drawing/2014/main" id="{39A0D7CE-5BE0-045C-B401-D3D6C04492AA}"/>
                </a:ext>
              </a:extLst>
            </p:cNvPr>
            <p:cNvSpPr/>
            <p:nvPr/>
          </p:nvSpPr>
          <p:spPr>
            <a:xfrm>
              <a:off x="1229293" y="1768244"/>
              <a:ext cx="62203" cy="151390"/>
            </a:xfrm>
            <a:custGeom>
              <a:avLst/>
              <a:gdLst>
                <a:gd name="connsiteX0" fmla="*/ 0 w 62203"/>
                <a:gd name="connsiteY0" fmla="*/ 0 h 151390"/>
                <a:gd name="connsiteX1" fmla="*/ 54500 w 62203"/>
                <a:gd name="connsiteY1" fmla="*/ 121112 h 151390"/>
                <a:gd name="connsiteX2" fmla="*/ 60556 w 62203"/>
                <a:gd name="connsiteY2" fmla="*/ 151390 h 1513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62203" h="151390">
                  <a:moveTo>
                    <a:pt x="0" y="0"/>
                  </a:moveTo>
                  <a:cubicBezTo>
                    <a:pt x="22203" y="47940"/>
                    <a:pt x="44407" y="95880"/>
                    <a:pt x="54500" y="121112"/>
                  </a:cubicBezTo>
                  <a:cubicBezTo>
                    <a:pt x="64593" y="146344"/>
                    <a:pt x="62574" y="148867"/>
                    <a:pt x="60556" y="151390"/>
                  </a:cubicBezTo>
                </a:path>
              </a:pathLst>
            </a:cu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0" name="フリーフォーム 399">
              <a:extLst>
                <a:ext uri="{FF2B5EF4-FFF2-40B4-BE49-F238E27FC236}">
                  <a16:creationId xmlns:a16="http://schemas.microsoft.com/office/drawing/2014/main" id="{A0D561C0-28EA-3542-F3A7-D7627C533C08}"/>
                </a:ext>
              </a:extLst>
            </p:cNvPr>
            <p:cNvSpPr/>
            <p:nvPr/>
          </p:nvSpPr>
          <p:spPr>
            <a:xfrm>
              <a:off x="1294526" y="1789681"/>
              <a:ext cx="147977" cy="245010"/>
            </a:xfrm>
            <a:custGeom>
              <a:avLst/>
              <a:gdLst>
                <a:gd name="connsiteX0" fmla="*/ 1379 w 147977"/>
                <a:gd name="connsiteY0" fmla="*/ 245010 h 245010"/>
                <a:gd name="connsiteX1" fmla="*/ 6171 w 147977"/>
                <a:gd name="connsiteY1" fmla="*/ 136916 h 245010"/>
                <a:gd name="connsiteX2" fmla="*/ 50180 w 147977"/>
                <a:gd name="connsiteY2" fmla="*/ 88017 h 245010"/>
                <a:gd name="connsiteX3" fmla="*/ 84409 w 147977"/>
                <a:gd name="connsiteY3" fmla="*/ 58678 h 245010"/>
                <a:gd name="connsiteX4" fmla="*/ 128417 w 147977"/>
                <a:gd name="connsiteY4" fmla="*/ 9780 h 245010"/>
                <a:gd name="connsiteX5" fmla="*/ 147977 w 147977"/>
                <a:gd name="connsiteY5" fmla="*/ 0 h 2450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47977" h="245010">
                  <a:moveTo>
                    <a:pt x="1379" y="245010"/>
                  </a:moveTo>
                  <a:cubicBezTo>
                    <a:pt x="-292" y="204045"/>
                    <a:pt x="-1962" y="163081"/>
                    <a:pt x="6171" y="136916"/>
                  </a:cubicBezTo>
                  <a:cubicBezTo>
                    <a:pt x="14304" y="110751"/>
                    <a:pt x="37140" y="101057"/>
                    <a:pt x="50180" y="88017"/>
                  </a:cubicBezTo>
                  <a:cubicBezTo>
                    <a:pt x="63220" y="74977"/>
                    <a:pt x="71370" y="71717"/>
                    <a:pt x="84409" y="58678"/>
                  </a:cubicBezTo>
                  <a:cubicBezTo>
                    <a:pt x="97448" y="45639"/>
                    <a:pt x="128417" y="9780"/>
                    <a:pt x="128417" y="9780"/>
                  </a:cubicBezTo>
                  <a:cubicBezTo>
                    <a:pt x="139012" y="0"/>
                    <a:pt x="143494" y="0"/>
                    <a:pt x="147977" y="0"/>
                  </a:cubicBezTo>
                </a:path>
              </a:pathLst>
            </a:cu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1" name="円/楕円 400">
              <a:extLst>
                <a:ext uri="{FF2B5EF4-FFF2-40B4-BE49-F238E27FC236}">
                  <a16:creationId xmlns:a16="http://schemas.microsoft.com/office/drawing/2014/main" id="{265F2C0C-A181-63A4-2CB8-DD1300D6C8A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60661" y="1502745"/>
              <a:ext cx="200273" cy="186901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2" name="円/楕円 401">
              <a:extLst>
                <a:ext uri="{FF2B5EF4-FFF2-40B4-BE49-F238E27FC236}">
                  <a16:creationId xmlns:a16="http://schemas.microsoft.com/office/drawing/2014/main" id="{B76F1171-C2FD-1239-DD41-3E5990467153}"/>
                </a:ext>
              </a:extLst>
            </p:cNvPr>
            <p:cNvSpPr/>
            <p:nvPr/>
          </p:nvSpPr>
          <p:spPr>
            <a:xfrm rot="19705737">
              <a:off x="1190730" y="3127937"/>
              <a:ext cx="565434" cy="364714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3" name="円/楕円 402">
              <a:extLst>
                <a:ext uri="{FF2B5EF4-FFF2-40B4-BE49-F238E27FC236}">
                  <a16:creationId xmlns:a16="http://schemas.microsoft.com/office/drawing/2014/main" id="{0CEF8DBB-2CDC-5D7B-DD12-B1D20CF3C34B}"/>
                </a:ext>
              </a:extLst>
            </p:cNvPr>
            <p:cNvSpPr/>
            <p:nvPr/>
          </p:nvSpPr>
          <p:spPr>
            <a:xfrm rot="19890971">
              <a:off x="1589468" y="2968150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4" name="円/楕円 403">
              <a:extLst>
                <a:ext uri="{FF2B5EF4-FFF2-40B4-BE49-F238E27FC236}">
                  <a16:creationId xmlns:a16="http://schemas.microsoft.com/office/drawing/2014/main" id="{19A66BBF-7ACA-63DF-F9E0-B98A69553C77}"/>
                </a:ext>
              </a:extLst>
            </p:cNvPr>
            <p:cNvSpPr/>
            <p:nvPr/>
          </p:nvSpPr>
          <p:spPr>
            <a:xfrm rot="18849464">
              <a:off x="1877979" y="3956227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5" name="円/楕円 404">
              <a:extLst>
                <a:ext uri="{FF2B5EF4-FFF2-40B4-BE49-F238E27FC236}">
                  <a16:creationId xmlns:a16="http://schemas.microsoft.com/office/drawing/2014/main" id="{F2546FCB-0D5E-722D-1FA8-B93A560407C5}"/>
                </a:ext>
              </a:extLst>
            </p:cNvPr>
            <p:cNvSpPr/>
            <p:nvPr/>
          </p:nvSpPr>
          <p:spPr>
            <a:xfrm rot="17969593">
              <a:off x="3366125" y="4609434"/>
              <a:ext cx="914400" cy="458620"/>
            </a:xfrm>
            <a:prstGeom prst="ellipse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06" name="グループ化 405">
              <a:extLst>
                <a:ext uri="{FF2B5EF4-FFF2-40B4-BE49-F238E27FC236}">
                  <a16:creationId xmlns:a16="http://schemas.microsoft.com/office/drawing/2014/main" id="{3025E415-98A9-F315-FE54-DEF12F442401}"/>
                </a:ext>
              </a:extLst>
            </p:cNvPr>
            <p:cNvGrpSpPr/>
            <p:nvPr/>
          </p:nvGrpSpPr>
          <p:grpSpPr>
            <a:xfrm>
              <a:off x="1382585" y="1527432"/>
              <a:ext cx="3296564" cy="3321734"/>
              <a:chOff x="1457649" y="1827683"/>
              <a:chExt cx="3296564" cy="3321734"/>
            </a:xfrm>
            <a:solidFill>
              <a:schemeClr val="bg2">
                <a:lumMod val="90000"/>
              </a:schemeClr>
            </a:solidFill>
          </p:grpSpPr>
          <p:sp>
            <p:nvSpPr>
              <p:cNvPr id="410" name="フリーフォーム 409">
                <a:extLst>
                  <a:ext uri="{FF2B5EF4-FFF2-40B4-BE49-F238E27FC236}">
                    <a16:creationId xmlns:a16="http://schemas.microsoft.com/office/drawing/2014/main" id="{1BBE01F1-E35E-4E49-DA01-7E1E67387FA8}"/>
                  </a:ext>
                </a:extLst>
              </p:cNvPr>
              <p:cNvSpPr/>
              <p:nvPr/>
            </p:nvSpPr>
            <p:spPr>
              <a:xfrm>
                <a:off x="1457649" y="1827683"/>
                <a:ext cx="3296564" cy="3321734"/>
              </a:xfrm>
              <a:custGeom>
                <a:avLst/>
                <a:gdLst>
                  <a:gd name="connsiteX0" fmla="*/ 1924419 w 3296564"/>
                  <a:gd name="connsiteY0" fmla="*/ 6566 h 3321734"/>
                  <a:gd name="connsiteX1" fmla="*/ 2156431 w 3296564"/>
                  <a:gd name="connsiteY1" fmla="*/ 6566 h 3321734"/>
                  <a:gd name="connsiteX2" fmla="*/ 2395267 w 3296564"/>
                  <a:gd name="connsiteY2" fmla="*/ 74805 h 3321734"/>
                  <a:gd name="connsiteX3" fmla="*/ 2599983 w 3296564"/>
                  <a:gd name="connsiteY3" fmla="*/ 156692 h 3321734"/>
                  <a:gd name="connsiteX4" fmla="*/ 2743285 w 3296564"/>
                  <a:gd name="connsiteY4" fmla="*/ 327289 h 3321734"/>
                  <a:gd name="connsiteX5" fmla="*/ 2893410 w 3296564"/>
                  <a:gd name="connsiteY5" fmla="*/ 525181 h 3321734"/>
                  <a:gd name="connsiteX6" fmla="*/ 3016240 w 3296564"/>
                  <a:gd name="connsiteY6" fmla="*/ 777665 h 3321734"/>
                  <a:gd name="connsiteX7" fmla="*/ 3125422 w 3296564"/>
                  <a:gd name="connsiteY7" fmla="*/ 1071092 h 3321734"/>
                  <a:gd name="connsiteX8" fmla="*/ 3234604 w 3296564"/>
                  <a:gd name="connsiteY8" fmla="*/ 1453229 h 3321734"/>
                  <a:gd name="connsiteX9" fmla="*/ 3296019 w 3296564"/>
                  <a:gd name="connsiteY9" fmla="*/ 1944548 h 3321734"/>
                  <a:gd name="connsiteX10" fmla="*/ 3261900 w 3296564"/>
                  <a:gd name="connsiteY10" fmla="*/ 2319862 h 3321734"/>
                  <a:gd name="connsiteX11" fmla="*/ 3214132 w 3296564"/>
                  <a:gd name="connsiteY11" fmla="*/ 2592817 h 3321734"/>
                  <a:gd name="connsiteX12" fmla="*/ 3084479 w 3296564"/>
                  <a:gd name="connsiteY12" fmla="*/ 2906715 h 3321734"/>
                  <a:gd name="connsiteX13" fmla="*/ 2988944 w 3296564"/>
                  <a:gd name="connsiteY13" fmla="*/ 3111432 h 3321734"/>
                  <a:gd name="connsiteX14" fmla="*/ 2825171 w 3296564"/>
                  <a:gd name="connsiteY14" fmla="*/ 3282029 h 3321734"/>
                  <a:gd name="connsiteX15" fmla="*/ 2688694 w 3296564"/>
                  <a:gd name="connsiteY15" fmla="*/ 3309324 h 3321734"/>
                  <a:gd name="connsiteX16" fmla="*/ 2729637 w 3296564"/>
                  <a:gd name="connsiteY16" fmla="*/ 3118256 h 3321734"/>
                  <a:gd name="connsiteX17" fmla="*/ 2640926 w 3296564"/>
                  <a:gd name="connsiteY17" fmla="*/ 3043193 h 3321734"/>
                  <a:gd name="connsiteX18" fmla="*/ 2415738 w 3296564"/>
                  <a:gd name="connsiteY18" fmla="*/ 2995426 h 3321734"/>
                  <a:gd name="connsiteX19" fmla="*/ 2279261 w 3296564"/>
                  <a:gd name="connsiteY19" fmla="*/ 3125080 h 3321734"/>
                  <a:gd name="connsiteX20" fmla="*/ 2231494 w 3296564"/>
                  <a:gd name="connsiteY20" fmla="*/ 3213790 h 3321734"/>
                  <a:gd name="connsiteX21" fmla="*/ 2183726 w 3296564"/>
                  <a:gd name="connsiteY21" fmla="*/ 3282029 h 3321734"/>
                  <a:gd name="connsiteX22" fmla="*/ 1999482 w 3296564"/>
                  <a:gd name="connsiteY22" fmla="*/ 3302500 h 3321734"/>
                  <a:gd name="connsiteX23" fmla="*/ 1630992 w 3296564"/>
                  <a:gd name="connsiteY23" fmla="*/ 3247909 h 3321734"/>
                  <a:gd name="connsiteX24" fmla="*/ 1405804 w 3296564"/>
                  <a:gd name="connsiteY24" fmla="*/ 3166023 h 3321734"/>
                  <a:gd name="connsiteX25" fmla="*/ 1180616 w 3296564"/>
                  <a:gd name="connsiteY25" fmla="*/ 3043193 h 3321734"/>
                  <a:gd name="connsiteX26" fmla="*/ 1064610 w 3296564"/>
                  <a:gd name="connsiteY26" fmla="*/ 2749766 h 3321734"/>
                  <a:gd name="connsiteX27" fmla="*/ 996371 w 3296564"/>
                  <a:gd name="connsiteY27" fmla="*/ 2613289 h 3321734"/>
                  <a:gd name="connsiteX28" fmla="*/ 784831 w 3296564"/>
                  <a:gd name="connsiteY28" fmla="*/ 2476811 h 3321734"/>
                  <a:gd name="connsiteX29" fmla="*/ 798479 w 3296564"/>
                  <a:gd name="connsiteY29" fmla="*/ 2367629 h 3321734"/>
                  <a:gd name="connsiteX30" fmla="*/ 839422 w 3296564"/>
                  <a:gd name="connsiteY30" fmla="*/ 2183384 h 3321734"/>
                  <a:gd name="connsiteX31" fmla="*/ 853070 w 3296564"/>
                  <a:gd name="connsiteY31" fmla="*/ 1917253 h 3321734"/>
                  <a:gd name="connsiteX32" fmla="*/ 955428 w 3296564"/>
                  <a:gd name="connsiteY32" fmla="*/ 1801247 h 3321734"/>
                  <a:gd name="connsiteX33" fmla="*/ 996371 w 3296564"/>
                  <a:gd name="connsiteY33" fmla="*/ 1671593 h 3321734"/>
                  <a:gd name="connsiteX34" fmla="*/ 955428 w 3296564"/>
                  <a:gd name="connsiteY34" fmla="*/ 1596530 h 3321734"/>
                  <a:gd name="connsiteX35" fmla="*/ 880365 w 3296564"/>
                  <a:gd name="connsiteY35" fmla="*/ 1473700 h 3321734"/>
                  <a:gd name="connsiteX36" fmla="*/ 764359 w 3296564"/>
                  <a:gd name="connsiteY36" fmla="*/ 1494172 h 3321734"/>
                  <a:gd name="connsiteX37" fmla="*/ 675649 w 3296564"/>
                  <a:gd name="connsiteY37" fmla="*/ 1521468 h 3321734"/>
                  <a:gd name="connsiteX38" fmla="*/ 491404 w 3296564"/>
                  <a:gd name="connsiteY38" fmla="*/ 1541939 h 3321734"/>
                  <a:gd name="connsiteX39" fmla="*/ 375398 w 3296564"/>
                  <a:gd name="connsiteY39" fmla="*/ 1589706 h 3321734"/>
                  <a:gd name="connsiteX40" fmla="*/ 266216 w 3296564"/>
                  <a:gd name="connsiteY40" fmla="*/ 1698889 h 3321734"/>
                  <a:gd name="connsiteX41" fmla="*/ 266216 w 3296564"/>
                  <a:gd name="connsiteY41" fmla="*/ 1698889 h 3321734"/>
                  <a:gd name="connsiteX42" fmla="*/ 204801 w 3296564"/>
                  <a:gd name="connsiteY42" fmla="*/ 1678417 h 3321734"/>
                  <a:gd name="connsiteX43" fmla="*/ 109267 w 3296564"/>
                  <a:gd name="connsiteY43" fmla="*/ 1644297 h 3321734"/>
                  <a:gd name="connsiteX44" fmla="*/ 27380 w 3296564"/>
                  <a:gd name="connsiteY44" fmla="*/ 1623826 h 3321734"/>
                  <a:gd name="connsiteX45" fmla="*/ 85 w 3296564"/>
                  <a:gd name="connsiteY45" fmla="*/ 1623826 h 3321734"/>
                  <a:gd name="connsiteX46" fmla="*/ 34204 w 3296564"/>
                  <a:gd name="connsiteY46" fmla="*/ 1500996 h 3321734"/>
                  <a:gd name="connsiteX47" fmla="*/ 88795 w 3296564"/>
                  <a:gd name="connsiteY47" fmla="*/ 1357694 h 3321734"/>
                  <a:gd name="connsiteX48" fmla="*/ 136562 w 3296564"/>
                  <a:gd name="connsiteY48" fmla="*/ 1262160 h 3321734"/>
                  <a:gd name="connsiteX49" fmla="*/ 143386 w 3296564"/>
                  <a:gd name="connsiteY49" fmla="*/ 1166626 h 3321734"/>
                  <a:gd name="connsiteX50" fmla="*/ 143386 w 3296564"/>
                  <a:gd name="connsiteY50" fmla="*/ 1098387 h 3321734"/>
                  <a:gd name="connsiteX51" fmla="*/ 116091 w 3296564"/>
                  <a:gd name="connsiteY51" fmla="*/ 989205 h 332173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</a:cxnLst>
                <a:rect l="l" t="t" r="r" b="b"/>
                <a:pathLst>
                  <a:path w="3296564" h="3321734">
                    <a:moveTo>
                      <a:pt x="1924419" y="6566"/>
                    </a:moveTo>
                    <a:cubicBezTo>
                      <a:pt x="2001187" y="879"/>
                      <a:pt x="2077956" y="-4807"/>
                      <a:pt x="2156431" y="6566"/>
                    </a:cubicBezTo>
                    <a:cubicBezTo>
                      <a:pt x="2234906" y="17939"/>
                      <a:pt x="2321342" y="49784"/>
                      <a:pt x="2395267" y="74805"/>
                    </a:cubicBezTo>
                    <a:cubicBezTo>
                      <a:pt x="2469192" y="99826"/>
                      <a:pt x="2541980" y="114611"/>
                      <a:pt x="2599983" y="156692"/>
                    </a:cubicBezTo>
                    <a:cubicBezTo>
                      <a:pt x="2657986" y="198773"/>
                      <a:pt x="2694381" y="265874"/>
                      <a:pt x="2743285" y="327289"/>
                    </a:cubicBezTo>
                    <a:cubicBezTo>
                      <a:pt x="2792189" y="388704"/>
                      <a:pt x="2847918" y="450118"/>
                      <a:pt x="2893410" y="525181"/>
                    </a:cubicBezTo>
                    <a:cubicBezTo>
                      <a:pt x="2938903" y="600244"/>
                      <a:pt x="2977571" y="686680"/>
                      <a:pt x="3016240" y="777665"/>
                    </a:cubicBezTo>
                    <a:cubicBezTo>
                      <a:pt x="3054909" y="868650"/>
                      <a:pt x="3089028" y="958498"/>
                      <a:pt x="3125422" y="1071092"/>
                    </a:cubicBezTo>
                    <a:cubicBezTo>
                      <a:pt x="3161816" y="1183686"/>
                      <a:pt x="3206171" y="1307653"/>
                      <a:pt x="3234604" y="1453229"/>
                    </a:cubicBezTo>
                    <a:cubicBezTo>
                      <a:pt x="3263037" y="1598805"/>
                      <a:pt x="3291470" y="1800109"/>
                      <a:pt x="3296019" y="1944548"/>
                    </a:cubicBezTo>
                    <a:cubicBezTo>
                      <a:pt x="3300568" y="2088987"/>
                      <a:pt x="3275548" y="2211817"/>
                      <a:pt x="3261900" y="2319862"/>
                    </a:cubicBezTo>
                    <a:cubicBezTo>
                      <a:pt x="3248252" y="2427907"/>
                      <a:pt x="3243702" y="2495008"/>
                      <a:pt x="3214132" y="2592817"/>
                    </a:cubicBezTo>
                    <a:cubicBezTo>
                      <a:pt x="3184562" y="2690626"/>
                      <a:pt x="3122010" y="2820279"/>
                      <a:pt x="3084479" y="2906715"/>
                    </a:cubicBezTo>
                    <a:cubicBezTo>
                      <a:pt x="3046948" y="2993151"/>
                      <a:pt x="3032162" y="3048880"/>
                      <a:pt x="2988944" y="3111432"/>
                    </a:cubicBezTo>
                    <a:cubicBezTo>
                      <a:pt x="2945726" y="3173984"/>
                      <a:pt x="2875213" y="3249047"/>
                      <a:pt x="2825171" y="3282029"/>
                    </a:cubicBezTo>
                    <a:cubicBezTo>
                      <a:pt x="2775129" y="3315011"/>
                      <a:pt x="2704616" y="3336619"/>
                      <a:pt x="2688694" y="3309324"/>
                    </a:cubicBezTo>
                    <a:cubicBezTo>
                      <a:pt x="2672772" y="3282029"/>
                      <a:pt x="2737598" y="3162611"/>
                      <a:pt x="2729637" y="3118256"/>
                    </a:cubicBezTo>
                    <a:cubicBezTo>
                      <a:pt x="2721676" y="3073901"/>
                      <a:pt x="2693242" y="3063665"/>
                      <a:pt x="2640926" y="3043193"/>
                    </a:cubicBezTo>
                    <a:cubicBezTo>
                      <a:pt x="2588610" y="3022721"/>
                      <a:pt x="2476016" y="2981778"/>
                      <a:pt x="2415738" y="2995426"/>
                    </a:cubicBezTo>
                    <a:cubicBezTo>
                      <a:pt x="2355461" y="3009074"/>
                      <a:pt x="2309968" y="3088686"/>
                      <a:pt x="2279261" y="3125080"/>
                    </a:cubicBezTo>
                    <a:cubicBezTo>
                      <a:pt x="2248554" y="3161474"/>
                      <a:pt x="2247416" y="3187632"/>
                      <a:pt x="2231494" y="3213790"/>
                    </a:cubicBezTo>
                    <a:cubicBezTo>
                      <a:pt x="2215572" y="3239948"/>
                      <a:pt x="2222395" y="3267244"/>
                      <a:pt x="2183726" y="3282029"/>
                    </a:cubicBezTo>
                    <a:cubicBezTo>
                      <a:pt x="2145057" y="3296814"/>
                      <a:pt x="2091604" y="3308187"/>
                      <a:pt x="1999482" y="3302500"/>
                    </a:cubicBezTo>
                    <a:cubicBezTo>
                      <a:pt x="1907360" y="3296813"/>
                      <a:pt x="1729938" y="3270655"/>
                      <a:pt x="1630992" y="3247909"/>
                    </a:cubicBezTo>
                    <a:cubicBezTo>
                      <a:pt x="1532046" y="3225163"/>
                      <a:pt x="1480867" y="3200142"/>
                      <a:pt x="1405804" y="3166023"/>
                    </a:cubicBezTo>
                    <a:cubicBezTo>
                      <a:pt x="1330741" y="3131904"/>
                      <a:pt x="1237482" y="3112569"/>
                      <a:pt x="1180616" y="3043193"/>
                    </a:cubicBezTo>
                    <a:cubicBezTo>
                      <a:pt x="1123750" y="2973817"/>
                      <a:pt x="1095317" y="2821417"/>
                      <a:pt x="1064610" y="2749766"/>
                    </a:cubicBezTo>
                    <a:cubicBezTo>
                      <a:pt x="1033903" y="2678115"/>
                      <a:pt x="1043001" y="2658781"/>
                      <a:pt x="996371" y="2613289"/>
                    </a:cubicBezTo>
                    <a:cubicBezTo>
                      <a:pt x="949741" y="2567797"/>
                      <a:pt x="817813" y="2517754"/>
                      <a:pt x="784831" y="2476811"/>
                    </a:cubicBezTo>
                    <a:cubicBezTo>
                      <a:pt x="751849" y="2435868"/>
                      <a:pt x="789380" y="2416534"/>
                      <a:pt x="798479" y="2367629"/>
                    </a:cubicBezTo>
                    <a:cubicBezTo>
                      <a:pt x="807578" y="2318724"/>
                      <a:pt x="830323" y="2258447"/>
                      <a:pt x="839422" y="2183384"/>
                    </a:cubicBezTo>
                    <a:cubicBezTo>
                      <a:pt x="848520" y="2108321"/>
                      <a:pt x="833736" y="1980943"/>
                      <a:pt x="853070" y="1917253"/>
                    </a:cubicBezTo>
                    <a:cubicBezTo>
                      <a:pt x="872404" y="1853564"/>
                      <a:pt x="931544" y="1842190"/>
                      <a:pt x="955428" y="1801247"/>
                    </a:cubicBezTo>
                    <a:cubicBezTo>
                      <a:pt x="979311" y="1760304"/>
                      <a:pt x="996371" y="1705712"/>
                      <a:pt x="996371" y="1671593"/>
                    </a:cubicBezTo>
                    <a:cubicBezTo>
                      <a:pt x="996371" y="1637474"/>
                      <a:pt x="974762" y="1629512"/>
                      <a:pt x="955428" y="1596530"/>
                    </a:cubicBezTo>
                    <a:cubicBezTo>
                      <a:pt x="936094" y="1563548"/>
                      <a:pt x="912210" y="1490760"/>
                      <a:pt x="880365" y="1473700"/>
                    </a:cubicBezTo>
                    <a:cubicBezTo>
                      <a:pt x="848520" y="1456640"/>
                      <a:pt x="798478" y="1486211"/>
                      <a:pt x="764359" y="1494172"/>
                    </a:cubicBezTo>
                    <a:cubicBezTo>
                      <a:pt x="730240" y="1502133"/>
                      <a:pt x="721141" y="1513507"/>
                      <a:pt x="675649" y="1521468"/>
                    </a:cubicBezTo>
                    <a:cubicBezTo>
                      <a:pt x="630157" y="1529429"/>
                      <a:pt x="541446" y="1530566"/>
                      <a:pt x="491404" y="1541939"/>
                    </a:cubicBezTo>
                    <a:cubicBezTo>
                      <a:pt x="441362" y="1553312"/>
                      <a:pt x="412929" y="1563548"/>
                      <a:pt x="375398" y="1589706"/>
                    </a:cubicBezTo>
                    <a:cubicBezTo>
                      <a:pt x="337867" y="1615864"/>
                      <a:pt x="266216" y="1698889"/>
                      <a:pt x="266216" y="1698889"/>
                    </a:cubicBezTo>
                    <a:lnTo>
                      <a:pt x="266216" y="1698889"/>
                    </a:lnTo>
                    <a:lnTo>
                      <a:pt x="204801" y="1678417"/>
                    </a:lnTo>
                    <a:cubicBezTo>
                      <a:pt x="178643" y="1669318"/>
                      <a:pt x="138837" y="1653395"/>
                      <a:pt x="109267" y="1644297"/>
                    </a:cubicBezTo>
                    <a:cubicBezTo>
                      <a:pt x="79697" y="1635199"/>
                      <a:pt x="27380" y="1623826"/>
                      <a:pt x="27380" y="1623826"/>
                    </a:cubicBezTo>
                    <a:cubicBezTo>
                      <a:pt x="9183" y="1620414"/>
                      <a:pt x="-1052" y="1644298"/>
                      <a:pt x="85" y="1623826"/>
                    </a:cubicBezTo>
                    <a:cubicBezTo>
                      <a:pt x="1222" y="1603354"/>
                      <a:pt x="19419" y="1545351"/>
                      <a:pt x="34204" y="1500996"/>
                    </a:cubicBezTo>
                    <a:cubicBezTo>
                      <a:pt x="48989" y="1456641"/>
                      <a:pt x="71735" y="1397500"/>
                      <a:pt x="88795" y="1357694"/>
                    </a:cubicBezTo>
                    <a:cubicBezTo>
                      <a:pt x="105855" y="1317888"/>
                      <a:pt x="127463" y="1294005"/>
                      <a:pt x="136562" y="1262160"/>
                    </a:cubicBezTo>
                    <a:cubicBezTo>
                      <a:pt x="145661" y="1230315"/>
                      <a:pt x="142249" y="1193921"/>
                      <a:pt x="143386" y="1166626"/>
                    </a:cubicBezTo>
                    <a:cubicBezTo>
                      <a:pt x="144523" y="1139331"/>
                      <a:pt x="147935" y="1127957"/>
                      <a:pt x="143386" y="1098387"/>
                    </a:cubicBezTo>
                    <a:cubicBezTo>
                      <a:pt x="138837" y="1068817"/>
                      <a:pt x="127464" y="1029011"/>
                      <a:pt x="116091" y="989205"/>
                    </a:cubicBezTo>
                  </a:path>
                </a:pathLst>
              </a:custGeom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1" name="フリーフォーム 410">
                <a:extLst>
                  <a:ext uri="{FF2B5EF4-FFF2-40B4-BE49-F238E27FC236}">
                    <a16:creationId xmlns:a16="http://schemas.microsoft.com/office/drawing/2014/main" id="{6DEB64AA-D1F6-A7BA-58F4-BBC0BC7AF938}"/>
                  </a:ext>
                </a:extLst>
              </p:cNvPr>
              <p:cNvSpPr/>
              <p:nvPr/>
            </p:nvSpPr>
            <p:spPr>
              <a:xfrm>
                <a:off x="1592520" y="1834317"/>
                <a:ext cx="1796817" cy="1018065"/>
              </a:xfrm>
              <a:custGeom>
                <a:avLst/>
                <a:gdLst>
                  <a:gd name="connsiteX0" fmla="*/ 0 w 1849271"/>
                  <a:gd name="connsiteY0" fmla="*/ 968991 h 968991"/>
                  <a:gd name="connsiteX1" fmla="*/ 1849271 w 1849271"/>
                  <a:gd name="connsiteY1" fmla="*/ 0 h 9689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1849271" h="968991">
                    <a:moveTo>
                      <a:pt x="0" y="968991"/>
                    </a:moveTo>
                    <a:lnTo>
                      <a:pt x="1849271" y="0"/>
                    </a:lnTo>
                  </a:path>
                </a:pathLst>
              </a:cu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407" name="円/楕円 406">
              <a:extLst>
                <a:ext uri="{FF2B5EF4-FFF2-40B4-BE49-F238E27FC236}">
                  <a16:creationId xmlns:a16="http://schemas.microsoft.com/office/drawing/2014/main" id="{1978B3DB-DFCD-9F4E-53A7-8597F850359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024350" y="1552785"/>
              <a:ext cx="38576" cy="36000"/>
            </a:xfrm>
            <a:prstGeom prst="ellipse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8" name="円/楕円 407">
              <a:extLst>
                <a:ext uri="{FF2B5EF4-FFF2-40B4-BE49-F238E27FC236}">
                  <a16:creationId xmlns:a16="http://schemas.microsoft.com/office/drawing/2014/main" id="{2F9D99E9-1A20-3EFE-F888-2C70CAD31636}"/>
                </a:ext>
              </a:extLst>
            </p:cNvPr>
            <p:cNvSpPr>
              <a:spLocks/>
            </p:cNvSpPr>
            <p:nvPr/>
          </p:nvSpPr>
          <p:spPr>
            <a:xfrm rot="1895009">
              <a:off x="1300448" y="1347249"/>
              <a:ext cx="36000" cy="14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9" name="フリーフォーム 408">
              <a:extLst>
                <a:ext uri="{FF2B5EF4-FFF2-40B4-BE49-F238E27FC236}">
                  <a16:creationId xmlns:a16="http://schemas.microsoft.com/office/drawing/2014/main" id="{DC05397A-4109-4615-5250-B9E7BE8ADE85}"/>
                </a:ext>
              </a:extLst>
            </p:cNvPr>
            <p:cNvSpPr/>
            <p:nvPr/>
          </p:nvSpPr>
          <p:spPr>
            <a:xfrm>
              <a:off x="1532352" y="1040366"/>
              <a:ext cx="327004" cy="139279"/>
            </a:xfrm>
            <a:custGeom>
              <a:avLst/>
              <a:gdLst>
                <a:gd name="connsiteX0" fmla="*/ 0 w 327004"/>
                <a:gd name="connsiteY0" fmla="*/ 139279 h 139279"/>
                <a:gd name="connsiteX1" fmla="*/ 145335 w 327004"/>
                <a:gd name="connsiteY1" fmla="*/ 54500 h 139279"/>
                <a:gd name="connsiteX2" fmla="*/ 254337 w 327004"/>
                <a:gd name="connsiteY2" fmla="*/ 18167 h 139279"/>
                <a:gd name="connsiteX3" fmla="*/ 327004 w 327004"/>
                <a:gd name="connsiteY3" fmla="*/ 0 h 1392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27004" h="139279">
                  <a:moveTo>
                    <a:pt x="0" y="139279"/>
                  </a:moveTo>
                  <a:cubicBezTo>
                    <a:pt x="51473" y="106982"/>
                    <a:pt x="102946" y="74685"/>
                    <a:pt x="145335" y="54500"/>
                  </a:cubicBezTo>
                  <a:cubicBezTo>
                    <a:pt x="187724" y="34315"/>
                    <a:pt x="224059" y="27250"/>
                    <a:pt x="254337" y="18167"/>
                  </a:cubicBezTo>
                  <a:cubicBezTo>
                    <a:pt x="284615" y="9084"/>
                    <a:pt x="305809" y="4542"/>
                    <a:pt x="327004" y="0"/>
                  </a:cubicBezTo>
                </a:path>
              </a:pathLst>
            </a:custGeom>
            <a:noFill/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79" name="図形グループ 2">
            <a:extLst>
              <a:ext uri="{FF2B5EF4-FFF2-40B4-BE49-F238E27FC236}">
                <a16:creationId xmlns:a16="http://schemas.microsoft.com/office/drawing/2014/main" id="{E8FE0C1F-A34F-38B8-6D11-0BCEC5382959}"/>
              </a:ext>
            </a:extLst>
          </p:cNvPr>
          <p:cNvGrpSpPr/>
          <p:nvPr/>
        </p:nvGrpSpPr>
        <p:grpSpPr>
          <a:xfrm flipV="1">
            <a:off x="4172405" y="3929101"/>
            <a:ext cx="686800" cy="320186"/>
            <a:chOff x="2335213" y="1373188"/>
            <a:chExt cx="1597025" cy="744537"/>
          </a:xfrm>
        </p:grpSpPr>
        <p:sp>
          <p:nvSpPr>
            <p:cNvPr id="80" name="Line 13">
              <a:extLst>
                <a:ext uri="{FF2B5EF4-FFF2-40B4-BE49-F238E27FC236}">
                  <a16:creationId xmlns:a16="http://schemas.microsoft.com/office/drawing/2014/main" id="{3D2BC33E-40FA-88A1-05D5-978B7096E5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35213" y="1870075"/>
              <a:ext cx="655637" cy="24765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81" name="Freeform 14">
              <a:extLst>
                <a:ext uri="{FF2B5EF4-FFF2-40B4-BE49-F238E27FC236}">
                  <a16:creationId xmlns:a16="http://schemas.microsoft.com/office/drawing/2014/main" id="{2C10156E-1B4E-923B-40A6-F7FEAD9727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8263" y="1573213"/>
              <a:ext cx="920750" cy="514350"/>
            </a:xfrm>
            <a:custGeom>
              <a:avLst/>
              <a:gdLst>
                <a:gd name="T0" fmla="*/ 2147483647 w 736"/>
                <a:gd name="T1" fmla="*/ 0 h 392"/>
                <a:gd name="T2" fmla="*/ 2147483647 w 736"/>
                <a:gd name="T3" fmla="*/ 2147483647 h 392"/>
                <a:gd name="T4" fmla="*/ 2147483647 w 736"/>
                <a:gd name="T5" fmla="*/ 2147483647 h 392"/>
                <a:gd name="T6" fmla="*/ 0 w 736"/>
                <a:gd name="T7" fmla="*/ 2147483647 h 392"/>
                <a:gd name="T8" fmla="*/ 2147483647 w 736"/>
                <a:gd name="T9" fmla="*/ 0 h 39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36" h="392">
                  <a:moveTo>
                    <a:pt x="680" y="0"/>
                  </a:moveTo>
                  <a:lnTo>
                    <a:pt x="736" y="144"/>
                  </a:lnTo>
                  <a:lnTo>
                    <a:pt x="56" y="392"/>
                  </a:lnTo>
                  <a:lnTo>
                    <a:pt x="0" y="248"/>
                  </a:lnTo>
                  <a:lnTo>
                    <a:pt x="680" y="0"/>
                  </a:lnTo>
                  <a:close/>
                </a:path>
              </a:pathLst>
            </a:custGeom>
            <a:blipFill dpi="0" rotWithShape="0"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tile tx="0" ty="0" sx="100000" sy="100000" flip="none" algn="tl"/>
            </a:blip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82" name="Freeform 14">
              <a:extLst>
                <a:ext uri="{FF2B5EF4-FFF2-40B4-BE49-F238E27FC236}">
                  <a16:creationId xmlns:a16="http://schemas.microsoft.com/office/drawing/2014/main" id="{91C3B0A5-889D-94EE-1E71-2DB4C37D53B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73388" y="1433513"/>
              <a:ext cx="922337" cy="514350"/>
            </a:xfrm>
            <a:custGeom>
              <a:avLst/>
              <a:gdLst>
                <a:gd name="T0" fmla="*/ 2147483647 w 736"/>
                <a:gd name="T1" fmla="*/ 0 h 392"/>
                <a:gd name="T2" fmla="*/ 2147483647 w 736"/>
                <a:gd name="T3" fmla="*/ 2147483647 h 392"/>
                <a:gd name="T4" fmla="*/ 2147483647 w 736"/>
                <a:gd name="T5" fmla="*/ 2147483647 h 392"/>
                <a:gd name="T6" fmla="*/ 0 w 736"/>
                <a:gd name="T7" fmla="*/ 2147483647 h 392"/>
                <a:gd name="T8" fmla="*/ 2147483647 w 736"/>
                <a:gd name="T9" fmla="*/ 0 h 39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736" h="392">
                  <a:moveTo>
                    <a:pt x="680" y="0"/>
                  </a:moveTo>
                  <a:lnTo>
                    <a:pt x="736" y="144"/>
                  </a:lnTo>
                  <a:lnTo>
                    <a:pt x="56" y="392"/>
                  </a:lnTo>
                  <a:lnTo>
                    <a:pt x="0" y="248"/>
                  </a:lnTo>
                  <a:lnTo>
                    <a:pt x="680" y="0"/>
                  </a:lnTo>
                  <a:close/>
                </a:path>
              </a:pathLst>
            </a:custGeom>
            <a:solidFill>
              <a:schemeClr val="bg1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83" name="Freeform 16">
              <a:extLst>
                <a:ext uri="{FF2B5EF4-FFF2-40B4-BE49-F238E27FC236}">
                  <a16:creationId xmlns:a16="http://schemas.microsoft.com/office/drawing/2014/main" id="{A4C7EF31-F095-4F55-FB76-14811D4AB6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405188" y="1412875"/>
              <a:ext cx="201612" cy="465138"/>
            </a:xfrm>
            <a:custGeom>
              <a:avLst/>
              <a:gdLst>
                <a:gd name="T0" fmla="*/ 2147483647 w 128"/>
                <a:gd name="T1" fmla="*/ 0 h 304"/>
                <a:gd name="T2" fmla="*/ 2147483647 w 128"/>
                <a:gd name="T3" fmla="*/ 2147483647 h 304"/>
                <a:gd name="T4" fmla="*/ 2147483647 w 128"/>
                <a:gd name="T5" fmla="*/ 2147483647 h 304"/>
                <a:gd name="T6" fmla="*/ 0 w 128"/>
                <a:gd name="T7" fmla="*/ 2147483647 h 304"/>
                <a:gd name="T8" fmla="*/ 2147483647 w 128"/>
                <a:gd name="T9" fmla="*/ 0 h 30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8" h="304">
                  <a:moveTo>
                    <a:pt x="24" y="0"/>
                  </a:moveTo>
                  <a:lnTo>
                    <a:pt x="128" y="296"/>
                  </a:lnTo>
                  <a:lnTo>
                    <a:pt x="104" y="304"/>
                  </a:lnTo>
                  <a:lnTo>
                    <a:pt x="0" y="16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  <p:sp>
          <p:nvSpPr>
            <p:cNvPr id="84" name="Freeform 17">
              <a:extLst>
                <a:ext uri="{FF2B5EF4-FFF2-40B4-BE49-F238E27FC236}">
                  <a16:creationId xmlns:a16="http://schemas.microsoft.com/office/drawing/2014/main" id="{0A293136-ADEC-AA2A-BAFF-95F8A09000B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7775" y="1373188"/>
              <a:ext cx="144463" cy="323850"/>
            </a:xfrm>
            <a:custGeom>
              <a:avLst/>
              <a:gdLst>
                <a:gd name="T0" fmla="*/ 2147483647 w 120"/>
                <a:gd name="T1" fmla="*/ 0 h 272"/>
                <a:gd name="T2" fmla="*/ 2147483647 w 120"/>
                <a:gd name="T3" fmla="*/ 2147483647 h 272"/>
                <a:gd name="T4" fmla="*/ 2147483647 w 120"/>
                <a:gd name="T5" fmla="*/ 2147483647 h 272"/>
                <a:gd name="T6" fmla="*/ 0 w 120"/>
                <a:gd name="T7" fmla="*/ 2147483647 h 272"/>
                <a:gd name="T8" fmla="*/ 2147483647 w 120"/>
                <a:gd name="T9" fmla="*/ 0 h 27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120" h="272">
                  <a:moveTo>
                    <a:pt x="24" y="0"/>
                  </a:moveTo>
                  <a:lnTo>
                    <a:pt x="120" y="264"/>
                  </a:lnTo>
                  <a:lnTo>
                    <a:pt x="96" y="272"/>
                  </a:lnTo>
                  <a:lnTo>
                    <a:pt x="0" y="8"/>
                  </a:lnTo>
                  <a:lnTo>
                    <a:pt x="24" y="0"/>
                  </a:lnTo>
                  <a:close/>
                </a:path>
              </a:pathLst>
            </a:custGeom>
            <a:solidFill>
              <a:srgbClr val="FFFFFF"/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>
              <a:prstTxWarp prst="textNoShape">
                <a:avLst/>
              </a:prstTxWarp>
            </a:bodyPr>
            <a:lstStyle/>
            <a:p>
              <a:endParaRPr lang="ja-JP" altLang="en-US" sz="1350"/>
            </a:p>
          </p:txBody>
        </p:sp>
      </p:grpSp>
      <p:grpSp>
        <p:nvGrpSpPr>
          <p:cNvPr id="415" name="グループ化 414">
            <a:extLst>
              <a:ext uri="{FF2B5EF4-FFF2-40B4-BE49-F238E27FC236}">
                <a16:creationId xmlns:a16="http://schemas.microsoft.com/office/drawing/2014/main" id="{4E2544B6-AFB9-6B40-A5CF-2B63A9E64EF0}"/>
              </a:ext>
            </a:extLst>
          </p:cNvPr>
          <p:cNvGrpSpPr>
            <a:grpSpLocks noChangeAspect="1"/>
          </p:cNvGrpSpPr>
          <p:nvPr/>
        </p:nvGrpSpPr>
        <p:grpSpPr>
          <a:xfrm>
            <a:off x="1592669" y="7115570"/>
            <a:ext cx="4941443" cy="2441402"/>
            <a:chOff x="1752509" y="7362223"/>
            <a:chExt cx="4371882" cy="2160000"/>
          </a:xfrm>
        </p:grpSpPr>
        <p:pic>
          <p:nvPicPr>
            <p:cNvPr id="180" name="図 179">
              <a:extLst>
                <a:ext uri="{FF2B5EF4-FFF2-40B4-BE49-F238E27FC236}">
                  <a16:creationId xmlns:a16="http://schemas.microsoft.com/office/drawing/2014/main" id="{1DE5125E-A4ED-9D65-9E0B-69A6F25DED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7567" t="13086"/>
            <a:stretch/>
          </p:blipFill>
          <p:spPr>
            <a:xfrm>
              <a:off x="3236666" y="7369612"/>
              <a:ext cx="323248" cy="2145221"/>
            </a:xfrm>
            <a:prstGeom prst="rect">
              <a:avLst/>
            </a:prstGeom>
          </p:spPr>
        </p:pic>
        <p:pic>
          <p:nvPicPr>
            <p:cNvPr id="184" name="図 183">
              <a:extLst>
                <a:ext uri="{FF2B5EF4-FFF2-40B4-BE49-F238E27FC236}">
                  <a16:creationId xmlns:a16="http://schemas.microsoft.com/office/drawing/2014/main" id="{3F5CAF1E-6EA7-8EC5-1E1B-978D369EBC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8163" t="12947" b="-1"/>
            <a:stretch/>
          </p:blipFill>
          <p:spPr>
            <a:xfrm>
              <a:off x="5819846" y="7369612"/>
              <a:ext cx="304545" cy="214522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12" name="図 411">
              <a:extLst>
                <a:ext uri="{FF2B5EF4-FFF2-40B4-BE49-F238E27FC236}">
                  <a16:creationId xmlns:a16="http://schemas.microsoft.com/office/drawing/2014/main" id="{599E4EF2-A9E1-0152-E020-326DBCC59C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3956" t="14847" r="29278" b="12740"/>
            <a:stretch/>
          </p:blipFill>
          <p:spPr>
            <a:xfrm>
              <a:off x="1752509" y="7366516"/>
              <a:ext cx="1463584" cy="2151413"/>
            </a:xfrm>
            <a:prstGeom prst="rect">
              <a:avLst/>
            </a:prstGeom>
          </p:spPr>
        </p:pic>
        <p:pic>
          <p:nvPicPr>
            <p:cNvPr id="413" name="図 412">
              <a:extLst>
                <a:ext uri="{FF2B5EF4-FFF2-40B4-BE49-F238E27FC236}">
                  <a16:creationId xmlns:a16="http://schemas.microsoft.com/office/drawing/2014/main" id="{89EFF597-DEC7-1C1F-79AC-13BA7F4B8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9434" t="42253" r="32023" b="6266"/>
            <a:stretch/>
          </p:blipFill>
          <p:spPr>
            <a:xfrm>
              <a:off x="3672700" y="7362223"/>
              <a:ext cx="2126572" cy="2160000"/>
            </a:xfrm>
            <a:prstGeom prst="rect">
              <a:avLst/>
            </a:prstGeom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351982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2</TotalTime>
  <Words>49</Words>
  <Application>Microsoft Macintosh PowerPoint</Application>
  <PresentationFormat>Custom</PresentationFormat>
  <Paragraphs>3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Hiromi TANAKA</dc:creator>
  <cp:keywords/>
  <dc:description/>
  <cp:lastModifiedBy>Gurumurthy, Channabasavaiah</cp:lastModifiedBy>
  <cp:revision>206</cp:revision>
  <cp:lastPrinted>2022-07-27T07:31:48Z</cp:lastPrinted>
  <dcterms:created xsi:type="dcterms:W3CDTF">2022-07-20T13:48:43Z</dcterms:created>
  <dcterms:modified xsi:type="dcterms:W3CDTF">2022-09-07T18:00:45Z</dcterms:modified>
  <cp:category/>
</cp:coreProperties>
</file>